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67" r:id="rId2"/>
    <p:sldId id="273" r:id="rId3"/>
    <p:sldId id="258" r:id="rId4"/>
    <p:sldId id="256" r:id="rId5"/>
    <p:sldId id="271" r:id="rId6"/>
    <p:sldId id="272" r:id="rId7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3" d="100"/>
          <a:sy n="73" d="100"/>
        </p:scale>
        <p:origin x="317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erei Wu" userId="935b1b74ff2f2987" providerId="LiveId" clId="{864E8B50-34A4-4017-B7AE-C64FD42D83DD}"/>
    <pc:docChg chg="undo redo custSel modSld">
      <pc:chgData name="Derei Wu" userId="935b1b74ff2f2987" providerId="LiveId" clId="{864E8B50-34A4-4017-B7AE-C64FD42D83DD}" dt="2021-02-28T07:48:03.161" v="657" actId="1036"/>
      <pc:docMkLst>
        <pc:docMk/>
      </pc:docMkLst>
      <pc:sldChg chg="addSp delSp modSp mod">
        <pc:chgData name="Derei Wu" userId="935b1b74ff2f2987" providerId="LiveId" clId="{864E8B50-34A4-4017-B7AE-C64FD42D83DD}" dt="2021-02-28T07:48:03.161" v="657" actId="1036"/>
        <pc:sldMkLst>
          <pc:docMk/>
          <pc:sldMk cId="3197682673" sldId="263"/>
        </pc:sldMkLst>
        <pc:spChg chg="mod">
          <ac:chgData name="Derei Wu" userId="935b1b74ff2f2987" providerId="LiveId" clId="{864E8B50-34A4-4017-B7AE-C64FD42D83DD}" dt="2021-02-28T07:31:17.139" v="77" actId="2711"/>
          <ac:spMkLst>
            <pc:docMk/>
            <pc:sldMk cId="3197682673" sldId="263"/>
            <ac:spMk id="5" creationId="{00000000-0000-0000-0000-000000000000}"/>
          </ac:spMkLst>
        </pc:spChg>
        <pc:spChg chg="mod">
          <ac:chgData name="Derei Wu" userId="935b1b74ff2f2987" providerId="LiveId" clId="{864E8B50-34A4-4017-B7AE-C64FD42D83DD}" dt="2021-02-28T07:31:17.139" v="77" actId="2711"/>
          <ac:spMkLst>
            <pc:docMk/>
            <pc:sldMk cId="3197682673" sldId="263"/>
            <ac:spMk id="7" creationId="{00000000-0000-0000-0000-000000000000}"/>
          </ac:spMkLst>
        </pc:spChg>
        <pc:spChg chg="mod">
          <ac:chgData name="Derei Wu" userId="935b1b74ff2f2987" providerId="LiveId" clId="{864E8B50-34A4-4017-B7AE-C64FD42D83DD}" dt="2021-02-28T07:31:17.139" v="77" actId="2711"/>
          <ac:spMkLst>
            <pc:docMk/>
            <pc:sldMk cId="3197682673" sldId="263"/>
            <ac:spMk id="11" creationId="{00000000-0000-0000-0000-000000000000}"/>
          </ac:spMkLst>
        </pc:spChg>
        <pc:spChg chg="mod">
          <ac:chgData name="Derei Wu" userId="935b1b74ff2f2987" providerId="LiveId" clId="{864E8B50-34A4-4017-B7AE-C64FD42D83DD}" dt="2021-02-28T07:31:17.139" v="77" actId="2711"/>
          <ac:spMkLst>
            <pc:docMk/>
            <pc:sldMk cId="3197682673" sldId="263"/>
            <ac:spMk id="13" creationId="{00000000-0000-0000-0000-000000000000}"/>
          </ac:spMkLst>
        </pc:spChg>
        <pc:spChg chg="mod">
          <ac:chgData name="Derei Wu" userId="935b1b74ff2f2987" providerId="LiveId" clId="{864E8B50-34A4-4017-B7AE-C64FD42D83DD}" dt="2021-02-28T07:31:17.139" v="77" actId="2711"/>
          <ac:spMkLst>
            <pc:docMk/>
            <pc:sldMk cId="3197682673" sldId="263"/>
            <ac:spMk id="23" creationId="{B972F12F-7C09-4441-A7D2-E4FE1C57A646}"/>
          </ac:spMkLst>
        </pc:spChg>
        <pc:spChg chg="mod">
          <ac:chgData name="Derei Wu" userId="935b1b74ff2f2987" providerId="LiveId" clId="{864E8B50-34A4-4017-B7AE-C64FD42D83DD}" dt="2021-02-28T07:31:17.139" v="77" actId="2711"/>
          <ac:spMkLst>
            <pc:docMk/>
            <pc:sldMk cId="3197682673" sldId="263"/>
            <ac:spMk id="24" creationId="{72CF4B65-A875-4C4F-91C9-8E7E0A1169B7}"/>
          </ac:spMkLst>
        </pc:spChg>
        <pc:spChg chg="mod">
          <ac:chgData name="Derei Wu" userId="935b1b74ff2f2987" providerId="LiveId" clId="{864E8B50-34A4-4017-B7AE-C64FD42D83DD}" dt="2021-02-28T07:31:17.139" v="77" actId="2711"/>
          <ac:spMkLst>
            <pc:docMk/>
            <pc:sldMk cId="3197682673" sldId="263"/>
            <ac:spMk id="25" creationId="{C6EBDF33-EF98-4001-8355-76AC1ED6D625}"/>
          </ac:spMkLst>
        </pc:spChg>
        <pc:spChg chg="mod">
          <ac:chgData name="Derei Wu" userId="935b1b74ff2f2987" providerId="LiveId" clId="{864E8B50-34A4-4017-B7AE-C64FD42D83DD}" dt="2021-02-28T07:31:17.139" v="77" actId="2711"/>
          <ac:spMkLst>
            <pc:docMk/>
            <pc:sldMk cId="3197682673" sldId="263"/>
            <ac:spMk id="27" creationId="{E70C5FC1-38A8-4232-B8FA-EADD12826D7B}"/>
          </ac:spMkLst>
        </pc:spChg>
        <pc:spChg chg="mod">
          <ac:chgData name="Derei Wu" userId="935b1b74ff2f2987" providerId="LiveId" clId="{864E8B50-34A4-4017-B7AE-C64FD42D83DD}" dt="2021-02-28T07:31:17.139" v="77" actId="2711"/>
          <ac:spMkLst>
            <pc:docMk/>
            <pc:sldMk cId="3197682673" sldId="263"/>
            <ac:spMk id="30" creationId="{6F49041D-57C0-467A-89F2-626FE88CF622}"/>
          </ac:spMkLst>
        </pc:spChg>
        <pc:spChg chg="add del mod">
          <ac:chgData name="Derei Wu" userId="935b1b74ff2f2987" providerId="LiveId" clId="{864E8B50-34A4-4017-B7AE-C64FD42D83DD}" dt="2021-02-28T07:47:51.543" v="639" actId="21"/>
          <ac:spMkLst>
            <pc:docMk/>
            <pc:sldMk cId="3197682673" sldId="263"/>
            <ac:spMk id="31" creationId="{768FF7FF-1356-4433-9534-58C9CDB0B13F}"/>
          </ac:spMkLst>
        </pc:spChg>
        <pc:spChg chg="add del mod">
          <ac:chgData name="Derei Wu" userId="935b1b74ff2f2987" providerId="LiveId" clId="{864E8B50-34A4-4017-B7AE-C64FD42D83DD}" dt="2021-02-28T07:47:32.641" v="623" actId="21"/>
          <ac:spMkLst>
            <pc:docMk/>
            <pc:sldMk cId="3197682673" sldId="263"/>
            <ac:spMk id="32" creationId="{64D4BCB1-DF89-4FB5-B362-7188F29A247B}"/>
          </ac:spMkLst>
        </pc:spChg>
        <pc:spChg chg="add mod">
          <ac:chgData name="Derei Wu" userId="935b1b74ff2f2987" providerId="LiveId" clId="{864E8B50-34A4-4017-B7AE-C64FD42D83DD}" dt="2021-02-28T07:43:05.892" v="403" actId="164"/>
          <ac:spMkLst>
            <pc:docMk/>
            <pc:sldMk cId="3197682673" sldId="263"/>
            <ac:spMk id="33" creationId="{EC3CFCE3-BA3E-43CF-8C65-806D3EA9977E}"/>
          </ac:spMkLst>
        </pc:spChg>
        <pc:spChg chg="add mod">
          <ac:chgData name="Derei Wu" userId="935b1b74ff2f2987" providerId="LiveId" clId="{864E8B50-34A4-4017-B7AE-C64FD42D83DD}" dt="2021-02-28T07:43:05.892" v="403" actId="164"/>
          <ac:spMkLst>
            <pc:docMk/>
            <pc:sldMk cId="3197682673" sldId="263"/>
            <ac:spMk id="34" creationId="{838F3C34-12E1-4529-8978-58480E859EE4}"/>
          </ac:spMkLst>
        </pc:spChg>
        <pc:spChg chg="add mod">
          <ac:chgData name="Derei Wu" userId="935b1b74ff2f2987" providerId="LiveId" clId="{864E8B50-34A4-4017-B7AE-C64FD42D83DD}" dt="2021-02-28T07:43:05.892" v="403" actId="164"/>
          <ac:spMkLst>
            <pc:docMk/>
            <pc:sldMk cId="3197682673" sldId="263"/>
            <ac:spMk id="36" creationId="{728749F8-E417-4461-B062-3043397509A8}"/>
          </ac:spMkLst>
        </pc:spChg>
        <pc:spChg chg="add mod">
          <ac:chgData name="Derei Wu" userId="935b1b74ff2f2987" providerId="LiveId" clId="{864E8B50-34A4-4017-B7AE-C64FD42D83DD}" dt="2021-02-28T07:44:09.002" v="424" actId="164"/>
          <ac:spMkLst>
            <pc:docMk/>
            <pc:sldMk cId="3197682673" sldId="263"/>
            <ac:spMk id="38" creationId="{467BD55C-54F1-43A5-BE1E-C8F1C002CAA8}"/>
          </ac:spMkLst>
        </pc:spChg>
        <pc:spChg chg="add mod">
          <ac:chgData name="Derei Wu" userId="935b1b74ff2f2987" providerId="LiveId" clId="{864E8B50-34A4-4017-B7AE-C64FD42D83DD}" dt="2021-02-28T07:43:02.205" v="402" actId="164"/>
          <ac:spMkLst>
            <pc:docMk/>
            <pc:sldMk cId="3197682673" sldId="263"/>
            <ac:spMk id="39" creationId="{591DE331-B0F5-4E11-AB1F-946E721FA05B}"/>
          </ac:spMkLst>
        </pc:spChg>
        <pc:spChg chg="add mod">
          <ac:chgData name="Derei Wu" userId="935b1b74ff2f2987" providerId="LiveId" clId="{864E8B50-34A4-4017-B7AE-C64FD42D83DD}" dt="2021-02-28T07:44:47.399" v="469" actId="1035"/>
          <ac:spMkLst>
            <pc:docMk/>
            <pc:sldMk cId="3197682673" sldId="263"/>
            <ac:spMk id="40" creationId="{8B4CA1FD-0860-4696-8129-7C4EB67175F5}"/>
          </ac:spMkLst>
        </pc:spChg>
        <pc:spChg chg="add del mod">
          <ac:chgData name="Derei Wu" userId="935b1b74ff2f2987" providerId="LiveId" clId="{864E8B50-34A4-4017-B7AE-C64FD42D83DD}" dt="2021-02-28T07:39:58.639" v="296" actId="478"/>
          <ac:spMkLst>
            <pc:docMk/>
            <pc:sldMk cId="3197682673" sldId="263"/>
            <ac:spMk id="41" creationId="{B5BF3B8E-1C2B-413D-BA97-FFD23CEB36A2}"/>
          </ac:spMkLst>
        </pc:spChg>
        <pc:spChg chg="add mod">
          <ac:chgData name="Derei Wu" userId="935b1b74ff2f2987" providerId="LiveId" clId="{864E8B50-34A4-4017-B7AE-C64FD42D83DD}" dt="2021-02-28T07:44:50.070" v="473" actId="1035"/>
          <ac:spMkLst>
            <pc:docMk/>
            <pc:sldMk cId="3197682673" sldId="263"/>
            <ac:spMk id="43" creationId="{2F74C3D2-BA18-4F99-9BE4-F620DAE13FE8}"/>
          </ac:spMkLst>
        </pc:spChg>
        <pc:spChg chg="add mod">
          <ac:chgData name="Derei Wu" userId="935b1b74ff2f2987" providerId="LiveId" clId="{864E8B50-34A4-4017-B7AE-C64FD42D83DD}" dt="2021-02-28T07:42:53.832" v="400" actId="164"/>
          <ac:spMkLst>
            <pc:docMk/>
            <pc:sldMk cId="3197682673" sldId="263"/>
            <ac:spMk id="46" creationId="{00FDA05B-66C5-4E88-A0CA-E3435BD27193}"/>
          </ac:spMkLst>
        </pc:spChg>
        <pc:spChg chg="add mod">
          <ac:chgData name="Derei Wu" userId="935b1b74ff2f2987" providerId="LiveId" clId="{864E8B50-34A4-4017-B7AE-C64FD42D83DD}" dt="2021-02-28T07:42:53.832" v="400" actId="164"/>
          <ac:spMkLst>
            <pc:docMk/>
            <pc:sldMk cId="3197682673" sldId="263"/>
            <ac:spMk id="47" creationId="{03A2B24E-B46E-4880-BA91-FBE9EA581FDD}"/>
          </ac:spMkLst>
        </pc:spChg>
        <pc:spChg chg="add mod">
          <ac:chgData name="Derei Wu" userId="935b1b74ff2f2987" providerId="LiveId" clId="{864E8B50-34A4-4017-B7AE-C64FD42D83DD}" dt="2021-02-28T07:42:53.832" v="400" actId="164"/>
          <ac:spMkLst>
            <pc:docMk/>
            <pc:sldMk cId="3197682673" sldId="263"/>
            <ac:spMk id="48" creationId="{930F4DBB-5234-427C-A119-5CADF05EAD86}"/>
          </ac:spMkLst>
        </pc:spChg>
        <pc:spChg chg="add mod">
          <ac:chgData name="Derei Wu" userId="935b1b74ff2f2987" providerId="LiveId" clId="{864E8B50-34A4-4017-B7AE-C64FD42D83DD}" dt="2021-02-28T07:44:54.538" v="477" actId="1035"/>
          <ac:spMkLst>
            <pc:docMk/>
            <pc:sldMk cId="3197682673" sldId="263"/>
            <ac:spMk id="49" creationId="{80F3958C-F3CC-4AC2-BB15-17CB2A81CB90}"/>
          </ac:spMkLst>
        </pc:spChg>
        <pc:spChg chg="add mod">
          <ac:chgData name="Derei Wu" userId="935b1b74ff2f2987" providerId="LiveId" clId="{864E8B50-34A4-4017-B7AE-C64FD42D83DD}" dt="2021-02-28T07:44:57.381" v="480" actId="1035"/>
          <ac:spMkLst>
            <pc:docMk/>
            <pc:sldMk cId="3197682673" sldId="263"/>
            <ac:spMk id="52" creationId="{C4111967-AACD-434A-A86A-D1CFA16D6B73}"/>
          </ac:spMkLst>
        </pc:spChg>
        <pc:spChg chg="mod">
          <ac:chgData name="Derei Wu" userId="935b1b74ff2f2987" providerId="LiveId" clId="{864E8B50-34A4-4017-B7AE-C64FD42D83DD}" dt="2021-02-28T07:31:17.139" v="77" actId="2711"/>
          <ac:spMkLst>
            <pc:docMk/>
            <pc:sldMk cId="3197682673" sldId="263"/>
            <ac:spMk id="53" creationId="{B6F7DECF-FC0D-4EFA-9BF3-A02418924C19}"/>
          </ac:spMkLst>
        </pc:spChg>
        <pc:spChg chg="mod">
          <ac:chgData name="Derei Wu" userId="935b1b74ff2f2987" providerId="LiveId" clId="{864E8B50-34A4-4017-B7AE-C64FD42D83DD}" dt="2021-02-28T07:31:17.139" v="77" actId="2711"/>
          <ac:spMkLst>
            <pc:docMk/>
            <pc:sldMk cId="3197682673" sldId="263"/>
            <ac:spMk id="54" creationId="{98B446BC-7949-41A0-B527-DEDEF877C2EA}"/>
          </ac:spMkLst>
        </pc:spChg>
        <pc:spChg chg="mod">
          <ac:chgData name="Derei Wu" userId="935b1b74ff2f2987" providerId="LiveId" clId="{864E8B50-34A4-4017-B7AE-C64FD42D83DD}" dt="2021-02-28T07:31:17.139" v="77" actId="2711"/>
          <ac:spMkLst>
            <pc:docMk/>
            <pc:sldMk cId="3197682673" sldId="263"/>
            <ac:spMk id="55" creationId="{3CB7DED0-CB1C-46FC-90A0-BF2BF0F0A0BC}"/>
          </ac:spMkLst>
        </pc:spChg>
        <pc:spChg chg="mod">
          <ac:chgData name="Derei Wu" userId="935b1b74ff2f2987" providerId="LiveId" clId="{864E8B50-34A4-4017-B7AE-C64FD42D83DD}" dt="2021-02-28T07:31:17.139" v="77" actId="2711"/>
          <ac:spMkLst>
            <pc:docMk/>
            <pc:sldMk cId="3197682673" sldId="263"/>
            <ac:spMk id="56" creationId="{324C7C38-CD83-4FC8-9EE7-8E54FC35ED44}"/>
          </ac:spMkLst>
        </pc:spChg>
        <pc:spChg chg="mod">
          <ac:chgData name="Derei Wu" userId="935b1b74ff2f2987" providerId="LiveId" clId="{864E8B50-34A4-4017-B7AE-C64FD42D83DD}" dt="2021-02-28T07:31:17.139" v="77" actId="2711"/>
          <ac:spMkLst>
            <pc:docMk/>
            <pc:sldMk cId="3197682673" sldId="263"/>
            <ac:spMk id="57" creationId="{0B67AD68-99D3-4DAF-80A1-23FF0A8CD698}"/>
          </ac:spMkLst>
        </pc:spChg>
        <pc:spChg chg="mod">
          <ac:chgData name="Derei Wu" userId="935b1b74ff2f2987" providerId="LiveId" clId="{864E8B50-34A4-4017-B7AE-C64FD42D83DD}" dt="2021-02-28T07:31:17.139" v="77" actId="2711"/>
          <ac:spMkLst>
            <pc:docMk/>
            <pc:sldMk cId="3197682673" sldId="263"/>
            <ac:spMk id="58" creationId="{FDE4BD53-43C9-4B56-874D-20F2A3442E56}"/>
          </ac:spMkLst>
        </pc:spChg>
        <pc:spChg chg="add mod">
          <ac:chgData name="Derei Wu" userId="935b1b74ff2f2987" providerId="LiveId" clId="{864E8B50-34A4-4017-B7AE-C64FD42D83DD}" dt="2021-02-28T07:43:48.522" v="419" actId="164"/>
          <ac:spMkLst>
            <pc:docMk/>
            <pc:sldMk cId="3197682673" sldId="263"/>
            <ac:spMk id="59" creationId="{AA420B6A-382C-45F3-99E0-DD2C82223B75}"/>
          </ac:spMkLst>
        </pc:spChg>
        <pc:spChg chg="add mod">
          <ac:chgData name="Derei Wu" userId="935b1b74ff2f2987" providerId="LiveId" clId="{864E8B50-34A4-4017-B7AE-C64FD42D83DD}" dt="2021-02-28T07:43:48.522" v="419" actId="164"/>
          <ac:spMkLst>
            <pc:docMk/>
            <pc:sldMk cId="3197682673" sldId="263"/>
            <ac:spMk id="60" creationId="{3A111494-0E41-449A-A360-8A69EC0A3B29}"/>
          </ac:spMkLst>
        </pc:spChg>
        <pc:spChg chg="add mod">
          <ac:chgData name="Derei Wu" userId="935b1b74ff2f2987" providerId="LiveId" clId="{864E8B50-34A4-4017-B7AE-C64FD42D83DD}" dt="2021-02-28T07:45:01.333" v="489" actId="1035"/>
          <ac:spMkLst>
            <pc:docMk/>
            <pc:sldMk cId="3197682673" sldId="263"/>
            <ac:spMk id="62" creationId="{BF4A8194-8DCF-46AE-9486-40193676A29A}"/>
          </ac:spMkLst>
        </pc:spChg>
        <pc:spChg chg="mod">
          <ac:chgData name="Derei Wu" userId="935b1b74ff2f2987" providerId="LiveId" clId="{864E8B50-34A4-4017-B7AE-C64FD42D83DD}" dt="2021-02-28T07:45:18.782" v="490" actId="1076"/>
          <ac:spMkLst>
            <pc:docMk/>
            <pc:sldMk cId="3197682673" sldId="263"/>
            <ac:spMk id="63" creationId="{7119CFD8-3C7E-443C-AFC5-E49DE9A90252}"/>
          </ac:spMkLst>
        </pc:spChg>
        <pc:spChg chg="add mod">
          <ac:chgData name="Derei Wu" userId="935b1b74ff2f2987" providerId="LiveId" clId="{864E8B50-34A4-4017-B7AE-C64FD42D83DD}" dt="2021-02-28T07:45:21.407" v="491" actId="1076"/>
          <ac:spMkLst>
            <pc:docMk/>
            <pc:sldMk cId="3197682673" sldId="263"/>
            <ac:spMk id="64" creationId="{CEA186A0-4BDA-43F8-B1F9-6E8B31B2B30F}"/>
          </ac:spMkLst>
        </pc:spChg>
        <pc:spChg chg="add del mod">
          <ac:chgData name="Derei Wu" userId="935b1b74ff2f2987" providerId="LiveId" clId="{864E8B50-34A4-4017-B7AE-C64FD42D83DD}" dt="2021-02-28T07:46:38.123" v="535" actId="21"/>
          <ac:spMkLst>
            <pc:docMk/>
            <pc:sldMk cId="3197682673" sldId="263"/>
            <ac:spMk id="65" creationId="{F6CD5744-03E1-44AB-810D-6AB26B315CC9}"/>
          </ac:spMkLst>
        </pc:spChg>
        <pc:spChg chg="add mod">
          <ac:chgData name="Derei Wu" userId="935b1b74ff2f2987" providerId="LiveId" clId="{864E8B50-34A4-4017-B7AE-C64FD42D83DD}" dt="2021-02-28T07:38:26.520" v="235" actId="164"/>
          <ac:spMkLst>
            <pc:docMk/>
            <pc:sldMk cId="3197682673" sldId="263"/>
            <ac:spMk id="67" creationId="{46949494-8F83-4E28-9915-85AB57C3354A}"/>
          </ac:spMkLst>
        </pc:spChg>
        <pc:spChg chg="add mod">
          <ac:chgData name="Derei Wu" userId="935b1b74ff2f2987" providerId="LiveId" clId="{864E8B50-34A4-4017-B7AE-C64FD42D83DD}" dt="2021-02-28T07:38:26.520" v="235" actId="164"/>
          <ac:spMkLst>
            <pc:docMk/>
            <pc:sldMk cId="3197682673" sldId="263"/>
            <ac:spMk id="68" creationId="{D7896D62-8761-4D39-A03A-BD43F431FC30}"/>
          </ac:spMkLst>
        </pc:spChg>
        <pc:spChg chg="add mod">
          <ac:chgData name="Derei Wu" userId="935b1b74ff2f2987" providerId="LiveId" clId="{864E8B50-34A4-4017-B7AE-C64FD42D83DD}" dt="2021-02-28T07:38:26.520" v="235" actId="164"/>
          <ac:spMkLst>
            <pc:docMk/>
            <pc:sldMk cId="3197682673" sldId="263"/>
            <ac:spMk id="69" creationId="{37E1EE17-2887-4B51-9225-34E5045FE90D}"/>
          </ac:spMkLst>
        </pc:spChg>
        <pc:spChg chg="add mod">
          <ac:chgData name="Derei Wu" userId="935b1b74ff2f2987" providerId="LiveId" clId="{864E8B50-34A4-4017-B7AE-C64FD42D83DD}" dt="2021-02-28T07:38:26.520" v="235" actId="164"/>
          <ac:spMkLst>
            <pc:docMk/>
            <pc:sldMk cId="3197682673" sldId="263"/>
            <ac:spMk id="70" creationId="{CEC11FC5-A449-4B5D-8EC1-247445DDEE6E}"/>
          </ac:spMkLst>
        </pc:spChg>
        <pc:spChg chg="add mod">
          <ac:chgData name="Derei Wu" userId="935b1b74ff2f2987" providerId="LiveId" clId="{864E8B50-34A4-4017-B7AE-C64FD42D83DD}" dt="2021-02-28T07:38:42.110" v="236" actId="164"/>
          <ac:spMkLst>
            <pc:docMk/>
            <pc:sldMk cId="3197682673" sldId="263"/>
            <ac:spMk id="71" creationId="{0A645078-E3A0-42B0-A27E-F328C5B81035}"/>
          </ac:spMkLst>
        </pc:spChg>
        <pc:spChg chg="add mod">
          <ac:chgData name="Derei Wu" userId="935b1b74ff2f2987" providerId="LiveId" clId="{864E8B50-34A4-4017-B7AE-C64FD42D83DD}" dt="2021-02-28T07:38:42.110" v="236" actId="164"/>
          <ac:spMkLst>
            <pc:docMk/>
            <pc:sldMk cId="3197682673" sldId="263"/>
            <ac:spMk id="72" creationId="{0C27DA99-ADA1-4C53-8A84-892DADFF0511}"/>
          </ac:spMkLst>
        </pc:spChg>
        <pc:spChg chg="add del mod">
          <ac:chgData name="Derei Wu" userId="935b1b74ff2f2987" providerId="LiveId" clId="{864E8B50-34A4-4017-B7AE-C64FD42D83DD}" dt="2021-02-28T07:39:18.852" v="247" actId="478"/>
          <ac:spMkLst>
            <pc:docMk/>
            <pc:sldMk cId="3197682673" sldId="263"/>
            <ac:spMk id="73" creationId="{DF8F7347-4FF1-40B0-85B1-3BCCF9A9E819}"/>
          </ac:spMkLst>
        </pc:spChg>
        <pc:spChg chg="add mod">
          <ac:chgData name="Derei Wu" userId="935b1b74ff2f2987" providerId="LiveId" clId="{864E8B50-34A4-4017-B7AE-C64FD42D83DD}" dt="2021-02-28T07:38:42.110" v="236" actId="164"/>
          <ac:spMkLst>
            <pc:docMk/>
            <pc:sldMk cId="3197682673" sldId="263"/>
            <ac:spMk id="74" creationId="{AEE55BE8-E80C-4351-B7C2-A2ABDA66145C}"/>
          </ac:spMkLst>
        </pc:spChg>
        <pc:spChg chg="add mod">
          <ac:chgData name="Derei Wu" userId="935b1b74ff2f2987" providerId="LiveId" clId="{864E8B50-34A4-4017-B7AE-C64FD42D83DD}" dt="2021-02-28T07:44:31.044" v="443" actId="1035"/>
          <ac:spMkLst>
            <pc:docMk/>
            <pc:sldMk cId="3197682673" sldId="263"/>
            <ac:spMk id="75" creationId="{C12AA530-3461-4428-A7DC-4D72E600BE9A}"/>
          </ac:spMkLst>
        </pc:spChg>
        <pc:spChg chg="add mod">
          <ac:chgData name="Derei Wu" userId="935b1b74ff2f2987" providerId="LiveId" clId="{864E8B50-34A4-4017-B7AE-C64FD42D83DD}" dt="2021-02-28T07:38:49.890" v="237" actId="164"/>
          <ac:spMkLst>
            <pc:docMk/>
            <pc:sldMk cId="3197682673" sldId="263"/>
            <ac:spMk id="76" creationId="{3ED1AB4E-6246-48AE-A7CC-9F42B12D51FE}"/>
          </ac:spMkLst>
        </pc:spChg>
        <pc:spChg chg="add mod">
          <ac:chgData name="Derei Wu" userId="935b1b74ff2f2987" providerId="LiveId" clId="{864E8B50-34A4-4017-B7AE-C64FD42D83DD}" dt="2021-02-28T07:39:34.489" v="267" actId="1038"/>
          <ac:spMkLst>
            <pc:docMk/>
            <pc:sldMk cId="3197682673" sldId="263"/>
            <ac:spMk id="77" creationId="{CACA174F-7753-418B-94E5-09E3FFF94DDD}"/>
          </ac:spMkLst>
        </pc:spChg>
        <pc:spChg chg="add mod">
          <ac:chgData name="Derei Wu" userId="935b1b74ff2f2987" providerId="LiveId" clId="{864E8B50-34A4-4017-B7AE-C64FD42D83DD}" dt="2021-02-28T07:44:34.355" v="449" actId="1035"/>
          <ac:spMkLst>
            <pc:docMk/>
            <pc:sldMk cId="3197682673" sldId="263"/>
            <ac:spMk id="78" creationId="{BFB45277-E91E-481C-8EFF-F23C3F93BEAB}"/>
          </ac:spMkLst>
        </pc:spChg>
        <pc:spChg chg="add mod">
          <ac:chgData name="Derei Wu" userId="935b1b74ff2f2987" providerId="LiveId" clId="{864E8B50-34A4-4017-B7AE-C64FD42D83DD}" dt="2021-02-28T07:44:37.948" v="455" actId="1035"/>
          <ac:spMkLst>
            <pc:docMk/>
            <pc:sldMk cId="3197682673" sldId="263"/>
            <ac:spMk id="79" creationId="{CE61A2F0-5E83-403E-8928-F372144D685A}"/>
          </ac:spMkLst>
        </pc:spChg>
        <pc:spChg chg="add mod">
          <ac:chgData name="Derei Wu" userId="935b1b74ff2f2987" providerId="LiveId" clId="{864E8B50-34A4-4017-B7AE-C64FD42D83DD}" dt="2021-02-28T07:38:54.248" v="238" actId="164"/>
          <ac:spMkLst>
            <pc:docMk/>
            <pc:sldMk cId="3197682673" sldId="263"/>
            <ac:spMk id="80" creationId="{19A2CE6B-FDD7-447B-9419-93704FC72518}"/>
          </ac:spMkLst>
        </pc:spChg>
        <pc:spChg chg="add mod">
          <ac:chgData name="Derei Wu" userId="935b1b74ff2f2987" providerId="LiveId" clId="{864E8B50-34A4-4017-B7AE-C64FD42D83DD}" dt="2021-02-28T07:39:37.285" v="270" actId="1038"/>
          <ac:spMkLst>
            <pc:docMk/>
            <pc:sldMk cId="3197682673" sldId="263"/>
            <ac:spMk id="81" creationId="{6197B30B-3164-4B54-80AD-406889D45EB7}"/>
          </ac:spMkLst>
        </pc:spChg>
        <pc:spChg chg="add mod">
          <ac:chgData name="Derei Wu" userId="935b1b74ff2f2987" providerId="LiveId" clId="{864E8B50-34A4-4017-B7AE-C64FD42D83DD}" dt="2021-02-28T07:44:41.947" v="466" actId="1035"/>
          <ac:spMkLst>
            <pc:docMk/>
            <pc:sldMk cId="3197682673" sldId="263"/>
            <ac:spMk id="82" creationId="{87C17FB8-0612-450A-9775-AE88EEAD58C3}"/>
          </ac:spMkLst>
        </pc:spChg>
        <pc:spChg chg="add mod">
          <ac:chgData name="Derei Wu" userId="935b1b74ff2f2987" providerId="LiveId" clId="{864E8B50-34A4-4017-B7AE-C64FD42D83DD}" dt="2021-02-28T07:46:41.341" v="541" actId="1038"/>
          <ac:spMkLst>
            <pc:docMk/>
            <pc:sldMk cId="3197682673" sldId="263"/>
            <ac:spMk id="87" creationId="{0DEE7DF7-3DA6-4F3C-ADF6-77EAA0B2B782}"/>
          </ac:spMkLst>
        </pc:spChg>
        <pc:spChg chg="add mod">
          <ac:chgData name="Derei Wu" userId="935b1b74ff2f2987" providerId="LiveId" clId="{864E8B50-34A4-4017-B7AE-C64FD42D83DD}" dt="2021-02-28T07:47:58.912" v="650" actId="1036"/>
          <ac:spMkLst>
            <pc:docMk/>
            <pc:sldMk cId="3197682673" sldId="263"/>
            <ac:spMk id="89" creationId="{4978A823-B75A-4A8C-9A39-57BB610C3BE9}"/>
          </ac:spMkLst>
        </pc:spChg>
        <pc:spChg chg="add mod">
          <ac:chgData name="Derei Wu" userId="935b1b74ff2f2987" providerId="LiveId" clId="{864E8B50-34A4-4017-B7AE-C64FD42D83DD}" dt="2021-02-28T07:48:03.161" v="657" actId="1036"/>
          <ac:spMkLst>
            <pc:docMk/>
            <pc:sldMk cId="3197682673" sldId="263"/>
            <ac:spMk id="90" creationId="{ACD7B811-2FE8-441F-B03D-059A3CA779D5}"/>
          </ac:spMkLst>
        </pc:spChg>
        <pc:grpChg chg="add mod">
          <ac:chgData name="Derei Wu" userId="935b1b74ff2f2987" providerId="LiveId" clId="{864E8B50-34A4-4017-B7AE-C64FD42D83DD}" dt="2021-02-28T07:39:50.329" v="295" actId="1037"/>
          <ac:grpSpMkLst>
            <pc:docMk/>
            <pc:sldMk cId="3197682673" sldId="263"/>
            <ac:grpSpMk id="3" creationId="{B52E78D2-3B4E-46BB-B8D8-0575F9C12831}"/>
          </ac:grpSpMkLst>
        </pc:grpChg>
        <pc:grpChg chg="add mod">
          <ac:chgData name="Derei Wu" userId="935b1b74ff2f2987" providerId="LiveId" clId="{864E8B50-34A4-4017-B7AE-C64FD42D83DD}" dt="2021-02-28T07:39:50.329" v="295" actId="1037"/>
          <ac:grpSpMkLst>
            <pc:docMk/>
            <pc:sldMk cId="3197682673" sldId="263"/>
            <ac:grpSpMk id="4" creationId="{52368C4A-60B1-41A5-B785-4BD97D4140FF}"/>
          </ac:grpSpMkLst>
        </pc:grpChg>
        <pc:grpChg chg="add mod">
          <ac:chgData name="Derei Wu" userId="935b1b74ff2f2987" providerId="LiveId" clId="{864E8B50-34A4-4017-B7AE-C64FD42D83DD}" dt="2021-02-28T07:39:50.329" v="295" actId="1037"/>
          <ac:grpSpMkLst>
            <pc:docMk/>
            <pc:sldMk cId="3197682673" sldId="263"/>
            <ac:grpSpMk id="6" creationId="{B5D2B2DB-FE40-4E91-BC9F-D3703BB7EBB9}"/>
          </ac:grpSpMkLst>
        </pc:grpChg>
        <pc:grpChg chg="add mod">
          <ac:chgData name="Derei Wu" userId="935b1b74ff2f2987" providerId="LiveId" clId="{864E8B50-34A4-4017-B7AE-C64FD42D83DD}" dt="2021-02-28T07:39:50.329" v="295" actId="1037"/>
          <ac:grpSpMkLst>
            <pc:docMk/>
            <pc:sldMk cId="3197682673" sldId="263"/>
            <ac:grpSpMk id="10" creationId="{A63D4279-3D87-42A7-85D0-8F4B934FA11B}"/>
          </ac:grpSpMkLst>
        </pc:grpChg>
        <pc:grpChg chg="add mod">
          <ac:chgData name="Derei Wu" userId="935b1b74ff2f2987" providerId="LiveId" clId="{864E8B50-34A4-4017-B7AE-C64FD42D83DD}" dt="2021-02-28T07:47:58.912" v="650" actId="1036"/>
          <ac:grpSpMkLst>
            <pc:docMk/>
            <pc:sldMk cId="3197682673" sldId="263"/>
            <ac:grpSpMk id="12" creationId="{5312B9A1-8746-4B8D-8D14-E3C6FA6CB0D7}"/>
          </ac:grpSpMkLst>
        </pc:grpChg>
        <pc:grpChg chg="add mod">
          <ac:chgData name="Derei Wu" userId="935b1b74ff2f2987" providerId="LiveId" clId="{864E8B50-34A4-4017-B7AE-C64FD42D83DD}" dt="2021-02-28T07:47:58.912" v="650" actId="1036"/>
          <ac:grpSpMkLst>
            <pc:docMk/>
            <pc:sldMk cId="3197682673" sldId="263"/>
            <ac:grpSpMk id="14" creationId="{E857C1DA-F1FC-4F80-AE47-68687E79638C}"/>
          </ac:grpSpMkLst>
        </pc:grpChg>
        <pc:grpChg chg="add mod">
          <ac:chgData name="Derei Wu" userId="935b1b74ff2f2987" providerId="LiveId" clId="{864E8B50-34A4-4017-B7AE-C64FD42D83DD}" dt="2021-02-28T07:44:09.002" v="424" actId="164"/>
          <ac:grpSpMkLst>
            <pc:docMk/>
            <pc:sldMk cId="3197682673" sldId="263"/>
            <ac:grpSpMk id="15" creationId="{87812103-020B-4870-863E-6303092E581D}"/>
          </ac:grpSpMkLst>
        </pc:grpChg>
        <pc:grpChg chg="add mod">
          <ac:chgData name="Derei Wu" userId="935b1b74ff2f2987" providerId="LiveId" clId="{864E8B50-34A4-4017-B7AE-C64FD42D83DD}" dt="2021-02-28T07:47:58.912" v="650" actId="1036"/>
          <ac:grpSpMkLst>
            <pc:docMk/>
            <pc:sldMk cId="3197682673" sldId="263"/>
            <ac:grpSpMk id="16" creationId="{CB63731C-6C57-49C5-A3EC-3ABC1A06CCAB}"/>
          </ac:grpSpMkLst>
        </pc:grpChg>
        <pc:grpChg chg="add mod">
          <ac:chgData name="Derei Wu" userId="935b1b74ff2f2987" providerId="LiveId" clId="{864E8B50-34A4-4017-B7AE-C64FD42D83DD}" dt="2021-02-28T07:47:58.912" v="650" actId="1036"/>
          <ac:grpSpMkLst>
            <pc:docMk/>
            <pc:sldMk cId="3197682673" sldId="263"/>
            <ac:grpSpMk id="17" creationId="{3D733743-FB92-4D3E-94DB-AAFB983183FE}"/>
          </ac:grpSpMkLst>
        </pc:grpChg>
        <pc:grpChg chg="mod">
          <ac:chgData name="Derei Wu" userId="935b1b74ff2f2987" providerId="LiveId" clId="{864E8B50-34A4-4017-B7AE-C64FD42D83DD}" dt="2021-02-27T14:58:03.702" v="48" actId="1076"/>
          <ac:grpSpMkLst>
            <pc:docMk/>
            <pc:sldMk cId="3197682673" sldId="263"/>
            <ac:grpSpMk id="42" creationId="{157057FD-F97E-4166-9F04-4DE9BFF214EC}"/>
          </ac:grpSpMkLst>
        </pc:grpChg>
        <pc:grpChg chg="mod">
          <ac:chgData name="Derei Wu" userId="935b1b74ff2f2987" providerId="LiveId" clId="{864E8B50-34A4-4017-B7AE-C64FD42D83DD}" dt="2021-02-27T14:58:03.702" v="48" actId="1076"/>
          <ac:grpSpMkLst>
            <pc:docMk/>
            <pc:sldMk cId="3197682673" sldId="263"/>
            <ac:grpSpMk id="44" creationId="{8A4DFB1A-17B1-4AA7-A32B-FED4EDB07451}"/>
          </ac:grpSpMkLst>
        </pc:grpChg>
        <pc:graphicFrameChg chg="mod">
          <ac:chgData name="Derei Wu" userId="935b1b74ff2f2987" providerId="LiveId" clId="{864E8B50-34A4-4017-B7AE-C64FD42D83DD}" dt="2021-02-27T14:58:03.702" v="48" actId="1076"/>
          <ac:graphicFrameMkLst>
            <pc:docMk/>
            <pc:sldMk cId="3197682673" sldId="263"/>
            <ac:graphicFrameMk id="2" creationId="{8405D2E2-0F6F-472E-A653-BEFB08500646}"/>
          </ac:graphicFrameMkLst>
        </pc:graphicFrameChg>
        <pc:graphicFrameChg chg="add del mod">
          <ac:chgData name="Derei Wu" userId="935b1b74ff2f2987" providerId="LiveId" clId="{864E8B50-34A4-4017-B7AE-C64FD42D83DD}" dt="2021-02-27T14:49:32.823" v="8" actId="478"/>
          <ac:graphicFrameMkLst>
            <pc:docMk/>
            <pc:sldMk cId="3197682673" sldId="263"/>
            <ac:graphicFrameMk id="3" creationId="{5D98ADA7-2C8B-4D77-B07E-9D571C4EDEE6}"/>
          </ac:graphicFrameMkLst>
        </pc:graphicFrameChg>
        <pc:graphicFrameChg chg="add del mod">
          <ac:chgData name="Derei Wu" userId="935b1b74ff2f2987" providerId="LiveId" clId="{864E8B50-34A4-4017-B7AE-C64FD42D83DD}" dt="2021-02-27T14:51:15.164" v="12" actId="478"/>
          <ac:graphicFrameMkLst>
            <pc:docMk/>
            <pc:sldMk cId="3197682673" sldId="263"/>
            <ac:graphicFrameMk id="4" creationId="{BB2834D2-A876-4D9E-8792-000C8A4CFA16}"/>
          </ac:graphicFrameMkLst>
        </pc:graphicFrameChg>
        <pc:graphicFrameChg chg="add del mod">
          <ac:chgData name="Derei Wu" userId="935b1b74ff2f2987" providerId="LiveId" clId="{864E8B50-34A4-4017-B7AE-C64FD42D83DD}" dt="2021-02-27T14:53:06.401" v="17" actId="478"/>
          <ac:graphicFrameMkLst>
            <pc:docMk/>
            <pc:sldMk cId="3197682673" sldId="263"/>
            <ac:graphicFrameMk id="6" creationId="{9971443A-FD0E-4BE7-8E37-3E81576E5274}"/>
          </ac:graphicFrameMkLst>
        </pc:graphicFrameChg>
        <pc:graphicFrameChg chg="add mod">
          <ac:chgData name="Derei Wu" userId="935b1b74ff2f2987" providerId="LiveId" clId="{864E8B50-34A4-4017-B7AE-C64FD42D83DD}" dt="2021-02-27T14:58:03.702" v="48" actId="1076"/>
          <ac:graphicFrameMkLst>
            <pc:docMk/>
            <pc:sldMk cId="3197682673" sldId="263"/>
            <ac:graphicFrameMk id="8" creationId="{6F8D418C-CC74-400F-BB00-26765C6FE6DB}"/>
          </ac:graphicFrameMkLst>
        </pc:graphicFrameChg>
        <pc:graphicFrameChg chg="add mod">
          <ac:chgData name="Derei Wu" userId="935b1b74ff2f2987" providerId="LiveId" clId="{864E8B50-34A4-4017-B7AE-C64FD42D83DD}" dt="2021-02-27T14:58:03.702" v="48" actId="1076"/>
          <ac:graphicFrameMkLst>
            <pc:docMk/>
            <pc:sldMk cId="3197682673" sldId="263"/>
            <ac:graphicFrameMk id="9" creationId="{BD7B4165-BEB7-40A3-9C20-3618B5232259}"/>
          </ac:graphicFrameMkLst>
        </pc:graphicFrameChg>
        <pc:graphicFrameChg chg="mod">
          <ac:chgData name="Derei Wu" userId="935b1b74ff2f2987" providerId="LiveId" clId="{864E8B50-34A4-4017-B7AE-C64FD42D83DD}" dt="2021-02-27T14:58:03.702" v="48" actId="1076"/>
          <ac:graphicFrameMkLst>
            <pc:docMk/>
            <pc:sldMk cId="3197682673" sldId="263"/>
            <ac:graphicFrameMk id="61" creationId="{AB543B76-7168-40E3-B8CB-EA19CF8ADC80}"/>
          </ac:graphicFrameMkLst>
        </pc:graphicFrameChg>
        <pc:picChg chg="add del">
          <ac:chgData name="Derei Wu" userId="935b1b74ff2f2987" providerId="LiveId" clId="{864E8B50-34A4-4017-B7AE-C64FD42D83DD}" dt="2021-02-27T14:57:52.606" v="47" actId="478"/>
          <ac:picMkLst>
            <pc:docMk/>
            <pc:sldMk cId="3197682673" sldId="263"/>
            <ac:picMk id="20" creationId="{EAD5CA52-F093-4F8A-827C-BDAD99CC8EE0}"/>
          </ac:picMkLst>
        </pc:picChg>
        <pc:picChg chg="add mod">
          <ac:chgData name="Derei Wu" userId="935b1b74ff2f2987" providerId="LiveId" clId="{864E8B50-34A4-4017-B7AE-C64FD42D83DD}" dt="2021-02-28T07:43:05.892" v="403" actId="164"/>
          <ac:picMkLst>
            <pc:docMk/>
            <pc:sldMk cId="3197682673" sldId="263"/>
            <ac:picMk id="35" creationId="{99750001-3F13-49D8-996D-4CBF49C7ADF8}"/>
          </ac:picMkLst>
        </pc:picChg>
        <pc:picChg chg="add mod">
          <ac:chgData name="Derei Wu" userId="935b1b74ff2f2987" providerId="LiveId" clId="{864E8B50-34A4-4017-B7AE-C64FD42D83DD}" dt="2021-02-28T07:42:53.832" v="400" actId="164"/>
          <ac:picMkLst>
            <pc:docMk/>
            <pc:sldMk cId="3197682673" sldId="263"/>
            <ac:picMk id="45" creationId="{B0FD4C33-D009-4733-9E88-2F1A1CD4FA18}"/>
          </ac:picMkLst>
        </pc:picChg>
        <pc:picChg chg="add mod">
          <ac:chgData name="Derei Wu" userId="935b1b74ff2f2987" providerId="LiveId" clId="{864E8B50-34A4-4017-B7AE-C64FD42D83DD}" dt="2021-02-28T07:43:48.522" v="419" actId="164"/>
          <ac:picMkLst>
            <pc:docMk/>
            <pc:sldMk cId="3197682673" sldId="263"/>
            <ac:picMk id="50" creationId="{51079B62-A670-463F-90FB-1FE03B8877D3}"/>
          </ac:picMkLst>
        </pc:picChg>
        <pc:picChg chg="add mod">
          <ac:chgData name="Derei Wu" userId="935b1b74ff2f2987" providerId="LiveId" clId="{864E8B50-34A4-4017-B7AE-C64FD42D83DD}" dt="2021-02-28T07:43:02.205" v="402" actId="164"/>
          <ac:picMkLst>
            <pc:docMk/>
            <pc:sldMk cId="3197682673" sldId="263"/>
            <ac:picMk id="66" creationId="{EBF289D3-F34C-4456-9017-45CDF8B9363E}"/>
          </ac:picMkLst>
        </pc:picChg>
        <pc:picChg chg="add mod">
          <ac:chgData name="Derei Wu" userId="935b1b74ff2f2987" providerId="LiveId" clId="{864E8B50-34A4-4017-B7AE-C64FD42D83DD}" dt="2021-02-28T07:38:26.520" v="235" actId="164"/>
          <ac:picMkLst>
            <pc:docMk/>
            <pc:sldMk cId="3197682673" sldId="263"/>
            <ac:picMk id="83" creationId="{97B7FE83-93D9-42B3-BE75-D5FD501FA24D}"/>
          </ac:picMkLst>
        </pc:picChg>
        <pc:picChg chg="add mod">
          <ac:chgData name="Derei Wu" userId="935b1b74ff2f2987" providerId="LiveId" clId="{864E8B50-34A4-4017-B7AE-C64FD42D83DD}" dt="2021-02-28T07:38:42.110" v="236" actId="164"/>
          <ac:picMkLst>
            <pc:docMk/>
            <pc:sldMk cId="3197682673" sldId="263"/>
            <ac:picMk id="84" creationId="{2BFBF3C3-AFCD-40C2-B75D-B608401541E0}"/>
          </ac:picMkLst>
        </pc:picChg>
        <pc:picChg chg="add mod">
          <ac:chgData name="Derei Wu" userId="935b1b74ff2f2987" providerId="LiveId" clId="{864E8B50-34A4-4017-B7AE-C64FD42D83DD}" dt="2021-02-28T07:38:49.890" v="237" actId="164"/>
          <ac:picMkLst>
            <pc:docMk/>
            <pc:sldMk cId="3197682673" sldId="263"/>
            <ac:picMk id="85" creationId="{9E5008A5-0B31-4AB4-A696-452263F2182B}"/>
          </ac:picMkLst>
        </pc:picChg>
        <pc:picChg chg="add mod">
          <ac:chgData name="Derei Wu" userId="935b1b74ff2f2987" providerId="LiveId" clId="{864E8B50-34A4-4017-B7AE-C64FD42D83DD}" dt="2021-02-28T07:38:54.248" v="238" actId="164"/>
          <ac:picMkLst>
            <pc:docMk/>
            <pc:sldMk cId="3197682673" sldId="263"/>
            <ac:picMk id="86" creationId="{D7439D44-059D-4D5A-BBAC-1F555EA40238}"/>
          </ac:picMkLst>
        </pc:picChg>
        <pc:cxnChg chg="add mod">
          <ac:chgData name="Derei Wu" userId="935b1b74ff2f2987" providerId="LiveId" clId="{864E8B50-34A4-4017-B7AE-C64FD42D83DD}" dt="2021-02-28T07:46:00.663" v="520" actId="1036"/>
          <ac:cxnSpMkLst>
            <pc:docMk/>
            <pc:sldMk cId="3197682673" sldId="263"/>
            <ac:cxnSpMk id="19" creationId="{5142E83F-082B-4D3E-A8FD-2B46624DB53A}"/>
          </ac:cxnSpMkLst>
        </pc:cxnChg>
        <pc:cxnChg chg="add mod">
          <ac:chgData name="Derei Wu" userId="935b1b74ff2f2987" providerId="LiveId" clId="{864E8B50-34A4-4017-B7AE-C64FD42D83DD}" dt="2021-02-28T07:47:58.912" v="650" actId="1036"/>
          <ac:cxnSpMkLst>
            <pc:docMk/>
            <pc:sldMk cId="3197682673" sldId="263"/>
            <ac:cxnSpMk id="88" creationId="{1C8A78A0-32E2-48BB-9D8A-5711F38E14D4}"/>
          </ac:cxnSpMkLst>
        </pc:cxnChg>
      </pc:sldChg>
    </pc:docChg>
  </pc:docChgLst>
  <pc:docChgLst>
    <pc:chgData name="Derei Wu" userId="935b1b74ff2f2987" providerId="LiveId" clId="{4D918F31-26C5-4DD5-8396-F60E9215E8F7}"/>
    <pc:docChg chg="delSld">
      <pc:chgData name="Derei Wu" userId="935b1b74ff2f2987" providerId="LiveId" clId="{4D918F31-26C5-4DD5-8396-F60E9215E8F7}" dt="2021-02-28T10:36:14.908" v="0" actId="47"/>
      <pc:docMkLst>
        <pc:docMk/>
      </pc:docMkLst>
      <pc:sldChg chg="del">
        <pc:chgData name="Derei Wu" userId="935b1b74ff2f2987" providerId="LiveId" clId="{4D918F31-26C5-4DD5-8396-F60E9215E8F7}" dt="2021-02-28T10:36:14.908" v="0" actId="47"/>
        <pc:sldMkLst>
          <pc:docMk/>
          <pc:sldMk cId="1266171639" sldId="257"/>
        </pc:sldMkLst>
      </pc:sldChg>
      <pc:sldChg chg="del">
        <pc:chgData name="Derei Wu" userId="935b1b74ff2f2987" providerId="LiveId" clId="{4D918F31-26C5-4DD5-8396-F60E9215E8F7}" dt="2021-02-28T10:36:14.908" v="0" actId="47"/>
        <pc:sldMkLst>
          <pc:docMk/>
          <pc:sldMk cId="3107955919" sldId="260"/>
        </pc:sldMkLst>
      </pc:sldChg>
      <pc:sldChg chg="del">
        <pc:chgData name="Derei Wu" userId="935b1b74ff2f2987" providerId="LiveId" clId="{4D918F31-26C5-4DD5-8396-F60E9215E8F7}" dt="2021-02-28T10:36:14.908" v="0" actId="47"/>
        <pc:sldMkLst>
          <pc:docMk/>
          <pc:sldMk cId="3197682673" sldId="263"/>
        </pc:sldMkLst>
      </pc:sldChg>
      <pc:sldChg chg="del">
        <pc:chgData name="Derei Wu" userId="935b1b74ff2f2987" providerId="LiveId" clId="{4D918F31-26C5-4DD5-8396-F60E9215E8F7}" dt="2021-02-28T10:36:14.908" v="0" actId="47"/>
        <pc:sldMkLst>
          <pc:docMk/>
          <pc:sldMk cId="2985042206" sldId="264"/>
        </pc:sldMkLst>
      </pc:sldChg>
    </pc:docChg>
  </pc:docChgLst>
  <pc:docChgLst>
    <pc:chgData name="Derei Wu" userId="935b1b74ff2f2987" providerId="LiveId" clId="{2FF1EA3B-BB44-453C-9823-562CC6FBA2BF}"/>
    <pc:docChg chg="undo custSel addSld modSld sldOrd">
      <pc:chgData name="Derei Wu" userId="935b1b74ff2f2987" providerId="LiveId" clId="{2FF1EA3B-BB44-453C-9823-562CC6FBA2BF}" dt="2021-04-07T02:02:03.730" v="432" actId="1076"/>
      <pc:docMkLst>
        <pc:docMk/>
      </pc:docMkLst>
      <pc:sldChg chg="modSp mod">
        <pc:chgData name="Derei Wu" userId="935b1b74ff2f2987" providerId="LiveId" clId="{2FF1EA3B-BB44-453C-9823-562CC6FBA2BF}" dt="2021-04-07T01:29:08.721" v="14" actId="20577"/>
        <pc:sldMkLst>
          <pc:docMk/>
          <pc:sldMk cId="598588755" sldId="256"/>
        </pc:sldMkLst>
        <pc:spChg chg="mod">
          <ac:chgData name="Derei Wu" userId="935b1b74ff2f2987" providerId="LiveId" clId="{2FF1EA3B-BB44-453C-9823-562CC6FBA2BF}" dt="2021-04-07T01:29:08.721" v="14" actId="20577"/>
          <ac:spMkLst>
            <pc:docMk/>
            <pc:sldMk cId="598588755" sldId="256"/>
            <ac:spMk id="2" creationId="{6DA89DD4-2B01-4ACB-9D80-C5BB10CEBDF0}"/>
          </ac:spMkLst>
        </pc:spChg>
      </pc:sldChg>
      <pc:sldChg chg="modSp mod">
        <pc:chgData name="Derei Wu" userId="935b1b74ff2f2987" providerId="LiveId" clId="{2FF1EA3B-BB44-453C-9823-562CC6FBA2BF}" dt="2021-04-07T01:29:06.920" v="13" actId="20577"/>
        <pc:sldMkLst>
          <pc:docMk/>
          <pc:sldMk cId="3513237702" sldId="258"/>
        </pc:sldMkLst>
        <pc:spChg chg="mod">
          <ac:chgData name="Derei Wu" userId="935b1b74ff2f2987" providerId="LiveId" clId="{2FF1EA3B-BB44-453C-9823-562CC6FBA2BF}" dt="2021-04-07T01:29:06.920" v="13" actId="20577"/>
          <ac:spMkLst>
            <pc:docMk/>
            <pc:sldMk cId="3513237702" sldId="258"/>
            <ac:spMk id="14" creationId="{94B70CBB-129F-4D14-AF36-1FE7864E4F78}"/>
          </ac:spMkLst>
        </pc:spChg>
      </pc:sldChg>
      <pc:sldChg chg="modSp mod">
        <pc:chgData name="Derei Wu" userId="935b1b74ff2f2987" providerId="LiveId" clId="{2FF1EA3B-BB44-453C-9823-562CC6FBA2BF}" dt="2021-04-07T01:29:10.960" v="15" actId="20577"/>
        <pc:sldMkLst>
          <pc:docMk/>
          <pc:sldMk cId="4009664465" sldId="271"/>
        </pc:sldMkLst>
        <pc:spChg chg="mod">
          <ac:chgData name="Derei Wu" userId="935b1b74ff2f2987" providerId="LiveId" clId="{2FF1EA3B-BB44-453C-9823-562CC6FBA2BF}" dt="2021-04-07T01:29:10.960" v="15" actId="20577"/>
          <ac:spMkLst>
            <pc:docMk/>
            <pc:sldMk cId="4009664465" sldId="271"/>
            <ac:spMk id="29" creationId="{39904E7C-D7DB-42E0-A888-4A9EE6962FAA}"/>
          </ac:spMkLst>
        </pc:spChg>
      </pc:sldChg>
      <pc:sldChg chg="addSp delSp modSp add mod ord">
        <pc:chgData name="Derei Wu" userId="935b1b74ff2f2987" providerId="LiveId" clId="{2FF1EA3B-BB44-453C-9823-562CC6FBA2BF}" dt="2021-04-07T02:02:03.730" v="432" actId="1076"/>
        <pc:sldMkLst>
          <pc:docMk/>
          <pc:sldMk cId="542880972" sldId="273"/>
        </pc:sldMkLst>
        <pc:spChg chg="mod">
          <ac:chgData name="Derei Wu" userId="935b1b74ff2f2987" providerId="LiveId" clId="{2FF1EA3B-BB44-453C-9823-562CC6FBA2BF}" dt="2021-04-07T01:52:54.635" v="370" actId="1076"/>
          <ac:spMkLst>
            <pc:docMk/>
            <pc:sldMk cId="542880972" sldId="273"/>
            <ac:spMk id="2" creationId="{6DA89DD4-2B01-4ACB-9D80-C5BB10CEBDF0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7" creationId="{045BE53F-C4BE-4378-9F4B-67019B966F27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8" creationId="{B311CAA3-4ACC-4568-BF6B-8E4413B250E0}"/>
          </ac:spMkLst>
        </pc:spChg>
        <pc:spChg chg="add del mod">
          <ac:chgData name="Derei Wu" userId="935b1b74ff2f2987" providerId="LiveId" clId="{2FF1EA3B-BB44-453C-9823-562CC6FBA2BF}" dt="2021-04-07T01:38:23.134" v="25" actId="478"/>
          <ac:spMkLst>
            <pc:docMk/>
            <pc:sldMk cId="542880972" sldId="273"/>
            <ac:spMk id="9" creationId="{9A76A3EC-02A5-410B-A379-9CA5604C84B4}"/>
          </ac:spMkLst>
        </pc:spChg>
        <pc:spChg chg="del">
          <ac:chgData name="Derei Wu" userId="935b1b74ff2f2987" providerId="LiveId" clId="{2FF1EA3B-BB44-453C-9823-562CC6FBA2BF}" dt="2021-04-07T01:27:27.251" v="1" actId="478"/>
          <ac:spMkLst>
            <pc:docMk/>
            <pc:sldMk cId="542880972" sldId="273"/>
            <ac:spMk id="10" creationId="{00000000-0000-0000-0000-000000000000}"/>
          </ac:spMkLst>
        </pc:spChg>
        <pc:spChg chg="add del mod">
          <ac:chgData name="Derei Wu" userId="935b1b74ff2f2987" providerId="LiveId" clId="{2FF1EA3B-BB44-453C-9823-562CC6FBA2BF}" dt="2021-04-07T01:38:21.774" v="24" actId="478"/>
          <ac:spMkLst>
            <pc:docMk/>
            <pc:sldMk cId="542880972" sldId="273"/>
            <ac:spMk id="11" creationId="{1E07EAB4-A465-4885-B049-596DBB55B45A}"/>
          </ac:spMkLst>
        </pc:spChg>
        <pc:spChg chg="add del mod">
          <ac:chgData name="Derei Wu" userId="935b1b74ff2f2987" providerId="LiveId" clId="{2FF1EA3B-BB44-453C-9823-562CC6FBA2BF}" dt="2021-04-07T01:38:26.752" v="28" actId="478"/>
          <ac:spMkLst>
            <pc:docMk/>
            <pc:sldMk cId="542880972" sldId="273"/>
            <ac:spMk id="12" creationId="{0D7CAF69-B825-4DC6-A7CB-8DC11B9E2D9D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13" creationId="{161D8A25-02D0-4EB3-A45D-F609720FDDCE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14" creationId="{FD4E9D47-5423-471D-BFE6-D266D029E6F0}"/>
          </ac:spMkLst>
        </pc:spChg>
        <pc:spChg chg="del">
          <ac:chgData name="Derei Wu" userId="935b1b74ff2f2987" providerId="LiveId" clId="{2FF1EA3B-BB44-453C-9823-562CC6FBA2BF}" dt="2021-04-07T01:27:27.251" v="1" actId="478"/>
          <ac:spMkLst>
            <pc:docMk/>
            <pc:sldMk cId="542880972" sldId="273"/>
            <ac:spMk id="15" creationId="{92A75ACC-2317-4DAE-B8A1-9E6B794353BB}"/>
          </ac:spMkLst>
        </pc:spChg>
        <pc:spChg chg="add del mod">
          <ac:chgData name="Derei Wu" userId="935b1b74ff2f2987" providerId="LiveId" clId="{2FF1EA3B-BB44-453C-9823-562CC6FBA2BF}" dt="2021-04-07T01:38:28.732" v="30" actId="478"/>
          <ac:spMkLst>
            <pc:docMk/>
            <pc:sldMk cId="542880972" sldId="273"/>
            <ac:spMk id="16" creationId="{8C5F1D01-F2D9-4AD7-9429-263E3450AD59}"/>
          </ac:spMkLst>
        </pc:spChg>
        <pc:spChg chg="add del mod">
          <ac:chgData name="Derei Wu" userId="935b1b74ff2f2987" providerId="LiveId" clId="{2FF1EA3B-BB44-453C-9823-562CC6FBA2BF}" dt="2021-04-07T01:38:27.982" v="29" actId="478"/>
          <ac:spMkLst>
            <pc:docMk/>
            <pc:sldMk cId="542880972" sldId="273"/>
            <ac:spMk id="17" creationId="{7981E757-83EA-4685-88AE-8F199378FAE2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20" creationId="{9D9560D8-0598-4B47-A577-78A947CCF5BA}"/>
          </ac:spMkLst>
        </pc:spChg>
        <pc:spChg chg="add del mod">
          <ac:chgData name="Derei Wu" userId="935b1b74ff2f2987" providerId="LiveId" clId="{2FF1EA3B-BB44-453C-9823-562CC6FBA2BF}" dt="2021-04-07T01:38:31.558" v="33" actId="478"/>
          <ac:spMkLst>
            <pc:docMk/>
            <pc:sldMk cId="542880972" sldId="273"/>
            <ac:spMk id="21" creationId="{0B42F54F-889F-4DB7-9328-B03099BCDF4E}"/>
          </ac:spMkLst>
        </pc:spChg>
        <pc:spChg chg="add del mod">
          <ac:chgData name="Derei Wu" userId="935b1b74ff2f2987" providerId="LiveId" clId="{2FF1EA3B-BB44-453C-9823-562CC6FBA2BF}" dt="2021-04-07T01:38:30.730" v="32" actId="478"/>
          <ac:spMkLst>
            <pc:docMk/>
            <pc:sldMk cId="542880972" sldId="273"/>
            <ac:spMk id="22" creationId="{F03732B5-DD9D-40A4-A1FD-58FEF176251C}"/>
          </ac:spMkLst>
        </pc:spChg>
        <pc:spChg chg="add del mod">
          <ac:chgData name="Derei Wu" userId="935b1b74ff2f2987" providerId="LiveId" clId="{2FF1EA3B-BB44-453C-9823-562CC6FBA2BF}" dt="2021-04-07T01:44:59.058" v="189" actId="21"/>
          <ac:spMkLst>
            <pc:docMk/>
            <pc:sldMk cId="542880972" sldId="273"/>
            <ac:spMk id="23" creationId="{66594AE9-B203-4D5D-B26A-65CDE2774D21}"/>
          </ac:spMkLst>
        </pc:spChg>
        <pc:spChg chg="add del mod">
          <ac:chgData name="Derei Wu" userId="935b1b74ff2f2987" providerId="LiveId" clId="{2FF1EA3B-BB44-453C-9823-562CC6FBA2BF}" dt="2021-04-07T01:44:59.058" v="189" actId="21"/>
          <ac:spMkLst>
            <pc:docMk/>
            <pc:sldMk cId="542880972" sldId="273"/>
            <ac:spMk id="24" creationId="{3A346B02-5EDD-453A-BEE7-48B5689933C0}"/>
          </ac:spMkLst>
        </pc:spChg>
        <pc:spChg chg="add del mod">
          <ac:chgData name="Derei Wu" userId="935b1b74ff2f2987" providerId="LiveId" clId="{2FF1EA3B-BB44-453C-9823-562CC6FBA2BF}" dt="2021-04-07T01:38:25.397" v="27" actId="478"/>
          <ac:spMkLst>
            <pc:docMk/>
            <pc:sldMk cId="542880972" sldId="273"/>
            <ac:spMk id="25" creationId="{5C49FB63-8908-42C0-9C72-E27BFFFB1355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26" creationId="{B3DBD64B-292B-4749-A763-21A93A23DCF6}"/>
          </ac:spMkLst>
        </pc:spChg>
        <pc:spChg chg="add mod">
          <ac:chgData name="Derei Wu" userId="935b1b74ff2f2987" providerId="LiveId" clId="{2FF1EA3B-BB44-453C-9823-562CC6FBA2BF}" dt="2021-04-07T02:02:01.089" v="431" actId="1076"/>
          <ac:spMkLst>
            <pc:docMk/>
            <pc:sldMk cId="542880972" sldId="273"/>
            <ac:spMk id="27" creationId="{3E99C5AF-791D-40B2-8368-70025E106B08}"/>
          </ac:spMkLst>
        </pc:spChg>
        <pc:spChg chg="add del mod">
          <ac:chgData name="Derei Wu" userId="935b1b74ff2f2987" providerId="LiveId" clId="{2FF1EA3B-BB44-453C-9823-562CC6FBA2BF}" dt="2021-04-07T01:38:39.329" v="39" actId="478"/>
          <ac:spMkLst>
            <pc:docMk/>
            <pc:sldMk cId="542880972" sldId="273"/>
            <ac:spMk id="32" creationId="{C8FEDD46-4EBA-478C-A1AB-E4DA0B5F2AE3}"/>
          </ac:spMkLst>
        </pc:spChg>
        <pc:spChg chg="add del mod">
          <ac:chgData name="Derei Wu" userId="935b1b74ff2f2987" providerId="LiveId" clId="{2FF1EA3B-BB44-453C-9823-562CC6FBA2BF}" dt="2021-04-07T01:38:42.080" v="41" actId="478"/>
          <ac:spMkLst>
            <pc:docMk/>
            <pc:sldMk cId="542880972" sldId="273"/>
            <ac:spMk id="33" creationId="{C31F2926-CCC4-4477-AB7E-D12D99BF93B9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34" creationId="{780DCABB-01AB-4A45-BE5E-ED7F20EEA10A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35" creationId="{750F5316-BF07-4EDF-8DC7-8BA711EE9B9D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36" creationId="{913B9385-F1A2-4878-A228-A7BEF0E21917}"/>
          </ac:spMkLst>
        </pc:spChg>
        <pc:spChg chg="add del mod">
          <ac:chgData name="Derei Wu" userId="935b1b74ff2f2987" providerId="LiveId" clId="{2FF1EA3B-BB44-453C-9823-562CC6FBA2BF}" dt="2021-04-07T01:38:38.413" v="38" actId="478"/>
          <ac:spMkLst>
            <pc:docMk/>
            <pc:sldMk cId="542880972" sldId="273"/>
            <ac:spMk id="37" creationId="{FF107DE4-C81E-4970-B556-D617866FF2EB}"/>
          </ac:spMkLst>
        </pc:spChg>
        <pc:spChg chg="add del mod">
          <ac:chgData name="Derei Wu" userId="935b1b74ff2f2987" providerId="LiveId" clId="{2FF1EA3B-BB44-453C-9823-562CC6FBA2BF}" dt="2021-04-07T01:38:24.567" v="26" actId="478"/>
          <ac:spMkLst>
            <pc:docMk/>
            <pc:sldMk cId="542880972" sldId="273"/>
            <ac:spMk id="38" creationId="{FB9290AA-813D-41BE-A4AD-281D3989B2A4}"/>
          </ac:spMkLst>
        </pc:spChg>
        <pc:spChg chg="add del mod">
          <ac:chgData name="Derei Wu" userId="935b1b74ff2f2987" providerId="LiveId" clId="{2FF1EA3B-BB44-453C-9823-562CC6FBA2BF}" dt="2021-04-07T01:39:22.101" v="48" actId="478"/>
          <ac:spMkLst>
            <pc:docMk/>
            <pc:sldMk cId="542880972" sldId="273"/>
            <ac:spMk id="39" creationId="{620C9678-673B-47CB-AC38-E57470E4DD10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40" creationId="{D1ED2D15-9BF1-40BC-9677-2F583C4343F5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41" creationId="{5C0DF90A-5951-4D61-8143-9C14293DDFDD}"/>
          </ac:spMkLst>
        </pc:spChg>
        <pc:spChg chg="add del mod">
          <ac:chgData name="Derei Wu" userId="935b1b74ff2f2987" providerId="LiveId" clId="{2FF1EA3B-BB44-453C-9823-562CC6FBA2BF}" dt="2021-04-07T01:38:33.452" v="34" actId="478"/>
          <ac:spMkLst>
            <pc:docMk/>
            <pc:sldMk cId="542880972" sldId="273"/>
            <ac:spMk id="42" creationId="{D722FEC2-832A-49E9-807F-7081505DAED3}"/>
          </ac:spMkLst>
        </pc:spChg>
        <pc:spChg chg="add del mod">
          <ac:chgData name="Derei Wu" userId="935b1b74ff2f2987" providerId="LiveId" clId="{2FF1EA3B-BB44-453C-9823-562CC6FBA2BF}" dt="2021-04-07T01:38:35.337" v="36" actId="478"/>
          <ac:spMkLst>
            <pc:docMk/>
            <pc:sldMk cId="542880972" sldId="273"/>
            <ac:spMk id="43" creationId="{A1EF996B-91CE-4FA8-A6C7-D01F702C2694}"/>
          </ac:spMkLst>
        </pc:spChg>
        <pc:spChg chg="add del mod">
          <ac:chgData name="Derei Wu" userId="935b1b74ff2f2987" providerId="LiveId" clId="{2FF1EA3B-BB44-453C-9823-562CC6FBA2BF}" dt="2021-04-07T01:39:23.142" v="49" actId="478"/>
          <ac:spMkLst>
            <pc:docMk/>
            <pc:sldMk cId="542880972" sldId="273"/>
            <ac:spMk id="44" creationId="{FB4B679A-0B6F-4179-B7DF-EE153D725AED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45" creationId="{DD6EF3B3-1924-44D5-9DAF-0C46C39EFFFD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46" creationId="{03E91209-2E0B-486A-ACA3-DAB705949869}"/>
          </ac:spMkLst>
        </pc:spChg>
        <pc:spChg chg="add del mod">
          <ac:chgData name="Derei Wu" userId="935b1b74ff2f2987" providerId="LiveId" clId="{2FF1EA3B-BB44-453C-9823-562CC6FBA2BF}" dt="2021-04-07T01:38:34.233" v="35" actId="478"/>
          <ac:spMkLst>
            <pc:docMk/>
            <pc:sldMk cId="542880972" sldId="273"/>
            <ac:spMk id="47" creationId="{0D949C17-AF5E-40D5-AF0C-FBE7AFF4A109}"/>
          </ac:spMkLst>
        </pc:spChg>
        <pc:spChg chg="add del mod">
          <ac:chgData name="Derei Wu" userId="935b1b74ff2f2987" providerId="LiveId" clId="{2FF1EA3B-BB44-453C-9823-562CC6FBA2BF}" dt="2021-04-07T01:38:29.859" v="31" actId="478"/>
          <ac:spMkLst>
            <pc:docMk/>
            <pc:sldMk cId="542880972" sldId="273"/>
            <ac:spMk id="48" creationId="{A043D921-B650-4C2C-A235-B0CE5F0F0D74}"/>
          </ac:spMkLst>
        </pc:spChg>
        <pc:spChg chg="add del mod">
          <ac:chgData name="Derei Wu" userId="935b1b74ff2f2987" providerId="LiveId" clId="{2FF1EA3B-BB44-453C-9823-562CC6FBA2BF}" dt="2021-04-07T01:39:24.354" v="50" actId="478"/>
          <ac:spMkLst>
            <pc:docMk/>
            <pc:sldMk cId="542880972" sldId="273"/>
            <ac:spMk id="49" creationId="{92291080-520E-4960-9EDA-68A059ED6ABE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50" creationId="{9DBDE58D-1329-4EBF-8C40-94010EBF2CBC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51" creationId="{A9209B37-01E4-4112-B919-60787C1C693D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52" creationId="{403219E2-7FC8-40CE-A636-E00D7FF5BF06}"/>
          </ac:spMkLst>
        </pc:spChg>
        <pc:spChg chg="add del mod">
          <ac:chgData name="Derei Wu" userId="935b1b74ff2f2987" providerId="LiveId" clId="{2FF1EA3B-BB44-453C-9823-562CC6FBA2BF}" dt="2021-04-07T01:38:44.810" v="42" actId="478"/>
          <ac:spMkLst>
            <pc:docMk/>
            <pc:sldMk cId="542880972" sldId="273"/>
            <ac:spMk id="57" creationId="{00B41E6B-3189-40AD-A4D1-F2AE09C12C94}"/>
          </ac:spMkLst>
        </pc:spChg>
        <pc:spChg chg="add del mod">
          <ac:chgData name="Derei Wu" userId="935b1b74ff2f2987" providerId="LiveId" clId="{2FF1EA3B-BB44-453C-9823-562CC6FBA2BF}" dt="2021-04-07T01:38:40.461" v="40" actId="478"/>
          <ac:spMkLst>
            <pc:docMk/>
            <pc:sldMk cId="542880972" sldId="273"/>
            <ac:spMk id="58" creationId="{9E8B2575-F7C2-44DA-B376-60EA3BE304FB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59" creationId="{B2B4B575-173C-4C1A-A07E-60DFDB14BF6C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60" creationId="{9F7E56F7-C59C-484E-A3FD-7005E50E1A84}"/>
          </ac:spMkLst>
        </pc:spChg>
        <pc:spChg chg="add del mod">
          <ac:chgData name="Derei Wu" userId="935b1b74ff2f2987" providerId="LiveId" clId="{2FF1EA3B-BB44-453C-9823-562CC6FBA2BF}" dt="2021-04-07T01:38:45.655" v="43" actId="478"/>
          <ac:spMkLst>
            <pc:docMk/>
            <pc:sldMk cId="542880972" sldId="273"/>
            <ac:spMk id="61" creationId="{A4DEB2D7-D47A-4907-A5BF-FBF99D5F45B2}"/>
          </ac:spMkLst>
        </pc:spChg>
        <pc:spChg chg="add del mod">
          <ac:chgData name="Derei Wu" userId="935b1b74ff2f2987" providerId="LiveId" clId="{2FF1EA3B-BB44-453C-9823-562CC6FBA2BF}" dt="2021-04-07T01:38:37.287" v="37" actId="478"/>
          <ac:spMkLst>
            <pc:docMk/>
            <pc:sldMk cId="542880972" sldId="273"/>
            <ac:spMk id="62" creationId="{C014B008-A231-435B-9ADD-90F8292863D5}"/>
          </ac:spMkLst>
        </pc:spChg>
        <pc:spChg chg="add del mod">
          <ac:chgData name="Derei Wu" userId="935b1b74ff2f2987" providerId="LiveId" clId="{2FF1EA3B-BB44-453C-9823-562CC6FBA2BF}" dt="2021-04-07T01:39:25.388" v="51" actId="478"/>
          <ac:spMkLst>
            <pc:docMk/>
            <pc:sldMk cId="542880972" sldId="273"/>
            <ac:spMk id="63" creationId="{441C04F2-2A1E-4852-BEA3-11F0DABCD20F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64" creationId="{03FF4DCC-A647-446C-87CC-4CFF9F0E746F}"/>
          </ac:spMkLst>
        </pc:spChg>
        <pc:spChg chg="add del mod">
          <ac:chgData name="Derei Wu" userId="935b1b74ff2f2987" providerId="LiveId" clId="{2FF1EA3B-BB44-453C-9823-562CC6FBA2BF}" dt="2021-04-07T01:38:47.780" v="45" actId="478"/>
          <ac:spMkLst>
            <pc:docMk/>
            <pc:sldMk cId="542880972" sldId="273"/>
            <ac:spMk id="65" creationId="{EC5EE34E-9E6F-46EF-A006-4687A4BE2530}"/>
          </ac:spMkLst>
        </pc:spChg>
        <pc:spChg chg="add del mod">
          <ac:chgData name="Derei Wu" userId="935b1b74ff2f2987" providerId="LiveId" clId="{2FF1EA3B-BB44-453C-9823-562CC6FBA2BF}" dt="2021-04-07T01:38:46.733" v="44" actId="478"/>
          <ac:spMkLst>
            <pc:docMk/>
            <pc:sldMk cId="542880972" sldId="273"/>
            <ac:spMk id="66" creationId="{0F4AD180-9467-4974-B678-166460CA470B}"/>
          </ac:spMkLst>
        </pc:spChg>
        <pc:spChg chg="add del mod">
          <ac:chgData name="Derei Wu" userId="935b1b74ff2f2987" providerId="LiveId" clId="{2FF1EA3B-BB44-453C-9823-562CC6FBA2BF}" dt="2021-04-07T01:39:26.204" v="52" actId="478"/>
          <ac:spMkLst>
            <pc:docMk/>
            <pc:sldMk cId="542880972" sldId="273"/>
            <ac:spMk id="67" creationId="{B384A8EA-4C81-4B18-9E2B-AA4E9525919D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68" creationId="{FD435261-161A-4450-8393-EC6D8EADD594}"/>
          </ac:spMkLst>
        </pc:spChg>
        <pc:spChg chg="add del mod">
          <ac:chgData name="Derei Wu" userId="935b1b74ff2f2987" providerId="LiveId" clId="{2FF1EA3B-BB44-453C-9823-562CC6FBA2BF}" dt="2021-04-07T01:38:50.634" v="47" actId="478"/>
          <ac:spMkLst>
            <pc:docMk/>
            <pc:sldMk cId="542880972" sldId="273"/>
            <ac:spMk id="69" creationId="{D320BF73-6B2C-4027-83D7-60FEF0AB4804}"/>
          </ac:spMkLst>
        </pc:spChg>
        <pc:spChg chg="add del mod">
          <ac:chgData name="Derei Wu" userId="935b1b74ff2f2987" providerId="LiveId" clId="{2FF1EA3B-BB44-453C-9823-562CC6FBA2BF}" dt="2021-04-07T01:38:49.467" v="46" actId="478"/>
          <ac:spMkLst>
            <pc:docMk/>
            <pc:sldMk cId="542880972" sldId="273"/>
            <ac:spMk id="70" creationId="{2B50EA98-9CFD-438B-9568-C418A8DCE589}"/>
          </ac:spMkLst>
        </pc:spChg>
        <pc:spChg chg="add del mod">
          <ac:chgData name="Derei Wu" userId="935b1b74ff2f2987" providerId="LiveId" clId="{2FF1EA3B-BB44-453C-9823-562CC6FBA2BF}" dt="2021-04-07T01:39:27.261" v="53" actId="478"/>
          <ac:spMkLst>
            <pc:docMk/>
            <pc:sldMk cId="542880972" sldId="273"/>
            <ac:spMk id="71" creationId="{375AE9E1-30F8-4391-A47C-727426B9D2BF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72" creationId="{1FF8C43C-8D6A-425E-85E7-36FBE130B1B5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73" creationId="{51045177-6F58-4014-917A-19313D0B3090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74" creationId="{AECBD202-55CB-478C-BDE2-9F3B8F650E86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75" creationId="{B759B65C-CB31-4ADC-A7CF-A2106E29023B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76" creationId="{10E4BFBD-5400-4886-871D-2ED7126E7155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77" creationId="{9A401BE7-9F3B-4E69-A376-F039290EF909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79" creationId="{323E7C38-888F-4F1C-B7BB-F6094EDCA8DE}"/>
          </ac:spMkLst>
        </pc:spChg>
        <pc:spChg chg="add del mod">
          <ac:chgData name="Derei Wu" userId="935b1b74ff2f2987" providerId="LiveId" clId="{2FF1EA3B-BB44-453C-9823-562CC6FBA2BF}" dt="2021-04-07T01:44:59.058" v="189" actId="21"/>
          <ac:spMkLst>
            <pc:docMk/>
            <pc:sldMk cId="542880972" sldId="273"/>
            <ac:spMk id="82" creationId="{E69638F7-F30A-4DD6-955D-677A3067D0E0}"/>
          </ac:spMkLst>
        </pc:spChg>
        <pc:spChg chg="add del mod">
          <ac:chgData name="Derei Wu" userId="935b1b74ff2f2987" providerId="LiveId" clId="{2FF1EA3B-BB44-453C-9823-562CC6FBA2BF}" dt="2021-04-07T01:44:59.058" v="189" actId="21"/>
          <ac:spMkLst>
            <pc:docMk/>
            <pc:sldMk cId="542880972" sldId="273"/>
            <ac:spMk id="83" creationId="{A60BC150-5922-4F96-B472-60DF6598B560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85" creationId="{3FE5A902-52FA-4B00-95A2-E68CBF4830FB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94" creationId="{720137DA-4B07-4BC6-B00C-FE30BB802520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95" creationId="{5F167114-D7B6-41BF-BD15-A2F599C83511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96" creationId="{52A7079F-12D1-4814-B5C1-DFA3BB1BB5A0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97" creationId="{378017E8-C115-4CB2-B57F-0A3A93F71FB6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98" creationId="{7A20979D-AD31-4185-B949-A4872BFE31D3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99" creationId="{B982E2E7-2D50-4DCD-8ACE-D239481BD3B0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00" creationId="{64CFCAEC-456C-4A45-9B35-109EBF21AC0A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01" creationId="{A47D1034-8569-44AE-99F9-E34B9DA2767E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02" creationId="{9523433B-3481-4F48-958C-8A29790D3B65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03" creationId="{CC1374A8-FAF9-4816-A21B-E0F25C7C5E22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04" creationId="{8905357B-04DA-4B42-883A-352DCA7398B2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05" creationId="{621F3A70-F369-4A4B-BF1C-6FA5DBB7FC25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06" creationId="{82B1615A-8979-4BB3-8770-99757AA9E434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07" creationId="{4273561E-834B-45F8-8B85-472C0DF30A21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08" creationId="{E8939391-59D7-4B79-B479-91055C84BF8E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09" creationId="{64E18155-9EBC-446B-8325-AFFCE6AF1873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10" creationId="{C52D8388-25AF-4D23-BAD9-E56ADFAA51D1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11" creationId="{D0277F2A-4C21-4AFA-8D5E-8F23010950A7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12" creationId="{5FCA1C42-9410-4779-B1C9-BE672747CDE4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13" creationId="{97BA77FA-A2DC-4FE4-B803-D4593F9F61E5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14" creationId="{E064DFDB-2634-40F0-898A-38F4225D7033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15" creationId="{FE7D06F6-C6BC-4CE7-8A82-751D18BA0EFE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16" creationId="{D243E93C-B175-48E7-AE1D-7396BAFF9764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17" creationId="{B4E454DF-300A-486A-A30A-00B2B21B1E3C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18" creationId="{2EAE12F2-4AA3-45F5-9DBC-45E60415D4A2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19" creationId="{CD207CF4-8747-427A-BE47-2F7F924A6606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20" creationId="{9994D376-FCEB-4192-9695-E427838043A3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21" creationId="{BC991AFA-0284-4AE9-A74F-75189FD10AF7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22" creationId="{828EA015-47B7-4A9F-B9C6-E51AE175C6F9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23" creationId="{AF7A8FF4-2133-41F2-9698-7AF62A0EB297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24" creationId="{82B7B18C-1B2A-4476-BD14-679E775B7EF4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25" creationId="{6F27BD3E-54EE-4163-95B9-2519E41791E5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26" creationId="{B29420FC-6A4F-4FA8-96D4-CCC63158CDAD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27" creationId="{404080DF-999F-4C2A-86F5-891224400A56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28" creationId="{B697A6D3-8B38-4D05-BC01-B0FE31E3472E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29" creationId="{CEA584C8-33D7-41B9-96B2-CD150749B86D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30" creationId="{2E281DC5-F270-4FE1-8EAF-20915A46BD1D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31" creationId="{27CFC548-7D63-4962-91C2-51D616BFB135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32" creationId="{EEB1853C-FCC0-4C8D-B233-EF796650D469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33" creationId="{D079B9B0-3C24-4A20-9101-7FDCE71242E3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34" creationId="{715DEB90-41F4-4F2F-BB69-A42603B9A4BD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35" creationId="{47FB05C7-D6BD-4137-8C9B-111A4B81FBAE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36" creationId="{336F66E3-93EA-43ED-96CF-DAB61ADE43AA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37" creationId="{E472FA91-0270-448C-8B20-FD88D5707B37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38" creationId="{BA043AD0-3F43-4FFA-A06D-213368EDC0D0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39" creationId="{9DB6C312-9D92-4377-BDD2-D280EFF102F0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40" creationId="{A25EF7C5-9E10-4E3B-B56A-F95EFEB59C8D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41" creationId="{6B0CC8E3-42FD-4763-BF7F-B7506BCF9472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42" creationId="{6E400132-BC0E-4BDF-B6B9-944985BB0B49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43" creationId="{119BACAD-8D0F-43E2-8BA0-4EDD36D3079B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44" creationId="{8D90F093-8406-46B7-BC89-B0469CB5AA40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45" creationId="{5999C8E6-0610-434D-B537-F4EF8FA61723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46" creationId="{4DD195A1-C4BB-4333-8D20-1EBE3E16298B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47" creationId="{4B504755-B910-4C32-94E7-0393A8461EE3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48" creationId="{25E5F079-0310-45D1-ACA4-B2BD6CB10096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49" creationId="{B6FF09A2-E6E6-4FB8-B769-0E456190B2F4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50" creationId="{44249EDE-71F2-4F65-AA7F-4EC74BA4FBD9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51" creationId="{82495309-CEE7-40A4-AC89-B02C3DE78690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52" creationId="{DCDF8CF1-4F15-445F-A5B9-1A79C3CE8DB6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55" creationId="{77302038-0B72-4272-8B86-EAC346B64867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57" creationId="{07CE6C00-9987-488C-AA3F-EF5E56D67B5C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58" creationId="{D3929F2A-C6EF-4835-B880-92BBE1B7A175}"/>
          </ac:spMkLst>
        </pc:spChg>
        <pc:spChg chg="add del mod">
          <ac:chgData name="Derei Wu" userId="935b1b74ff2f2987" providerId="LiveId" clId="{2FF1EA3B-BB44-453C-9823-562CC6FBA2BF}" dt="2021-04-07T01:33:21.020" v="21"/>
          <ac:spMkLst>
            <pc:docMk/>
            <pc:sldMk cId="542880972" sldId="273"/>
            <ac:spMk id="160" creationId="{E9BE00C0-FA60-476B-8634-A88D1DBF8F51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169" creationId="{1C87507F-7A60-4644-ACF3-1D6A8D3D8539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170" creationId="{EEEEEFC8-5C61-4A40-8B3D-89475019E2E5}"/>
          </ac:spMkLst>
        </pc:spChg>
        <pc:spChg chg="add del mod">
          <ac:chgData name="Derei Wu" userId="935b1b74ff2f2987" providerId="LiveId" clId="{2FF1EA3B-BB44-453C-9823-562CC6FBA2BF}" dt="2021-04-07T01:49:53.626" v="311" actId="478"/>
          <ac:spMkLst>
            <pc:docMk/>
            <pc:sldMk cId="542880972" sldId="273"/>
            <ac:spMk id="171" creationId="{A3423066-57DE-4327-84BA-A9E34ADD9F81}"/>
          </ac:spMkLst>
        </pc:spChg>
        <pc:spChg chg="add del mod">
          <ac:chgData name="Derei Wu" userId="935b1b74ff2f2987" providerId="LiveId" clId="{2FF1EA3B-BB44-453C-9823-562CC6FBA2BF}" dt="2021-04-07T01:49:54.479" v="312" actId="478"/>
          <ac:spMkLst>
            <pc:docMk/>
            <pc:sldMk cId="542880972" sldId="273"/>
            <ac:spMk id="172" creationId="{3BE16214-11FD-46B9-83DC-53073A8C31F7}"/>
          </ac:spMkLst>
        </pc:spChg>
        <pc:spChg chg="add del mod">
          <ac:chgData name="Derei Wu" userId="935b1b74ff2f2987" providerId="LiveId" clId="{2FF1EA3B-BB44-453C-9823-562CC6FBA2BF}" dt="2021-04-07T01:49:58.191" v="315" actId="478"/>
          <ac:spMkLst>
            <pc:docMk/>
            <pc:sldMk cId="542880972" sldId="273"/>
            <ac:spMk id="173" creationId="{B81C7812-3121-4C32-95F9-F0DDFC1EFE39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174" creationId="{FE6AA35F-3138-48D7-B9EC-E623470EB555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175" creationId="{A64B0213-DD16-4A5D-9C2E-D13F9C955F47}"/>
          </ac:spMkLst>
        </pc:spChg>
        <pc:spChg chg="add del mod">
          <ac:chgData name="Derei Wu" userId="935b1b74ff2f2987" providerId="LiveId" clId="{2FF1EA3B-BB44-453C-9823-562CC6FBA2BF}" dt="2021-04-07T01:50:01.528" v="319" actId="478"/>
          <ac:spMkLst>
            <pc:docMk/>
            <pc:sldMk cId="542880972" sldId="273"/>
            <ac:spMk id="176" creationId="{598B3A84-ACAB-4872-A802-6AB7C7E2B2CC}"/>
          </ac:spMkLst>
        </pc:spChg>
        <pc:spChg chg="add del mod">
          <ac:chgData name="Derei Wu" userId="935b1b74ff2f2987" providerId="LiveId" clId="{2FF1EA3B-BB44-453C-9823-562CC6FBA2BF}" dt="2021-04-07T01:50:00.638" v="318" actId="478"/>
          <ac:spMkLst>
            <pc:docMk/>
            <pc:sldMk cId="542880972" sldId="273"/>
            <ac:spMk id="177" creationId="{147E1CF7-FD31-4AE0-8AC1-E55C1D8ABAEB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178" creationId="{65DC23DA-6CE7-49C8-90B0-199859589FD3}"/>
          </ac:spMkLst>
        </pc:spChg>
        <pc:spChg chg="add del mod">
          <ac:chgData name="Derei Wu" userId="935b1b74ff2f2987" providerId="LiveId" clId="{2FF1EA3B-BB44-453C-9823-562CC6FBA2BF}" dt="2021-04-07T01:50:03.630" v="321" actId="478"/>
          <ac:spMkLst>
            <pc:docMk/>
            <pc:sldMk cId="542880972" sldId="273"/>
            <ac:spMk id="179" creationId="{9FB88B4A-9343-40B9-8322-96F424ADE909}"/>
          </ac:spMkLst>
        </pc:spChg>
        <pc:spChg chg="add del mod">
          <ac:chgData name="Derei Wu" userId="935b1b74ff2f2987" providerId="LiveId" clId="{2FF1EA3B-BB44-453C-9823-562CC6FBA2BF}" dt="2021-04-07T01:50:04.270" v="322" actId="478"/>
          <ac:spMkLst>
            <pc:docMk/>
            <pc:sldMk cId="542880972" sldId="273"/>
            <ac:spMk id="180" creationId="{553228EF-BABD-444D-9A1B-B69DA00597B0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181" creationId="{BA56DA78-D606-43E5-BEA4-C05BA98F3356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182" creationId="{C373382E-9B1E-43BC-B9F1-FA9F0E4A97A8}"/>
          </ac:spMkLst>
        </pc:spChg>
        <pc:spChg chg="add del mod">
          <ac:chgData name="Derei Wu" userId="935b1b74ff2f2987" providerId="LiveId" clId="{2FF1EA3B-BB44-453C-9823-562CC6FBA2BF}" dt="2021-04-07T01:49:56.854" v="314" actId="478"/>
          <ac:spMkLst>
            <pc:docMk/>
            <pc:sldMk cId="542880972" sldId="273"/>
            <ac:spMk id="183" creationId="{43DE246F-76AD-4C99-B004-32A5EC34A78B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184" creationId="{78EB57EB-1DC0-4353-97A0-D691E9C62C57}"/>
          </ac:spMkLst>
        </pc:spChg>
        <pc:spChg chg="add mod">
          <ac:chgData name="Derei Wu" userId="935b1b74ff2f2987" providerId="LiveId" clId="{2FF1EA3B-BB44-453C-9823-562CC6FBA2BF}" dt="2021-04-07T02:02:03.730" v="432" actId="1076"/>
          <ac:spMkLst>
            <pc:docMk/>
            <pc:sldMk cId="542880972" sldId="273"/>
            <ac:spMk id="185" creationId="{7BED54DB-3456-415B-B70B-4D86AA7CDB16}"/>
          </ac:spMkLst>
        </pc:spChg>
        <pc:spChg chg="add del mod">
          <ac:chgData name="Derei Wu" userId="935b1b74ff2f2987" providerId="LiveId" clId="{2FF1EA3B-BB44-453C-9823-562CC6FBA2BF}" dt="2021-04-07T01:50:08.930" v="325" actId="478"/>
          <ac:spMkLst>
            <pc:docMk/>
            <pc:sldMk cId="542880972" sldId="273"/>
            <ac:spMk id="186" creationId="{58061D4F-14B7-41BF-8DC2-7432961543ED}"/>
          </ac:spMkLst>
        </pc:spChg>
        <pc:spChg chg="add del mod">
          <ac:chgData name="Derei Wu" userId="935b1b74ff2f2987" providerId="LiveId" clId="{2FF1EA3B-BB44-453C-9823-562CC6FBA2BF}" dt="2021-04-07T01:50:08.133" v="324" actId="478"/>
          <ac:spMkLst>
            <pc:docMk/>
            <pc:sldMk cId="542880972" sldId="273"/>
            <ac:spMk id="187" creationId="{94626707-6646-46A0-A57D-94025B8E0D43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188" creationId="{242DDE5B-6E56-4031-8D01-BCA949F55A73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189" creationId="{8689DCF2-E35A-4910-9461-1F840717D50B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190" creationId="{299101C0-38BF-4E47-ADA5-2885130643F4}"/>
          </ac:spMkLst>
        </pc:spChg>
        <pc:spChg chg="add del mod">
          <ac:chgData name="Derei Wu" userId="935b1b74ff2f2987" providerId="LiveId" clId="{2FF1EA3B-BB44-453C-9823-562CC6FBA2BF}" dt="2021-04-07T01:50:10.320" v="326" actId="478"/>
          <ac:spMkLst>
            <pc:docMk/>
            <pc:sldMk cId="542880972" sldId="273"/>
            <ac:spMk id="191" creationId="{E35CA4EF-0242-40AD-8597-0C8CA00F09CD}"/>
          </ac:spMkLst>
        </pc:spChg>
        <pc:spChg chg="add del mod">
          <ac:chgData name="Derei Wu" userId="935b1b74ff2f2987" providerId="LiveId" clId="{2FF1EA3B-BB44-453C-9823-562CC6FBA2BF}" dt="2021-04-07T01:49:55.510" v="313" actId="478"/>
          <ac:spMkLst>
            <pc:docMk/>
            <pc:sldMk cId="542880972" sldId="273"/>
            <ac:spMk id="192" creationId="{066F527F-BD97-4FCD-89ED-D734AB2C8ED8}"/>
          </ac:spMkLst>
        </pc:spChg>
        <pc:spChg chg="add del mod">
          <ac:chgData name="Derei Wu" userId="935b1b74ff2f2987" providerId="LiveId" clId="{2FF1EA3B-BB44-453C-9823-562CC6FBA2BF}" dt="2021-04-07T01:53:50.553" v="388" actId="478"/>
          <ac:spMkLst>
            <pc:docMk/>
            <pc:sldMk cId="542880972" sldId="273"/>
            <ac:spMk id="193" creationId="{138D0A8D-8C29-4BBF-918E-F5E82B1CD95B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194" creationId="{70D4D1B2-59A5-4894-BE36-0AF8D73CCB4A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195" creationId="{EC9362A2-9D70-414B-BBCA-E87F3602A654}"/>
          </ac:spMkLst>
        </pc:spChg>
        <pc:spChg chg="add del mod">
          <ac:chgData name="Derei Wu" userId="935b1b74ff2f2987" providerId="LiveId" clId="{2FF1EA3B-BB44-453C-9823-562CC6FBA2BF}" dt="2021-04-07T01:50:11.679" v="327" actId="478"/>
          <ac:spMkLst>
            <pc:docMk/>
            <pc:sldMk cId="542880972" sldId="273"/>
            <ac:spMk id="196" creationId="{2F5D7E42-7A99-469E-90FA-077A71705573}"/>
          </ac:spMkLst>
        </pc:spChg>
        <pc:spChg chg="add del mod">
          <ac:chgData name="Derei Wu" userId="935b1b74ff2f2987" providerId="LiveId" clId="{2FF1EA3B-BB44-453C-9823-562CC6FBA2BF}" dt="2021-04-07T01:49:58.926" v="316" actId="478"/>
          <ac:spMkLst>
            <pc:docMk/>
            <pc:sldMk cId="542880972" sldId="273"/>
            <ac:spMk id="197" creationId="{6FBC7858-E167-4E39-A0FC-7E7B4E2B2CEF}"/>
          </ac:spMkLst>
        </pc:spChg>
        <pc:spChg chg="add del mod">
          <ac:chgData name="Derei Wu" userId="935b1b74ff2f2987" providerId="LiveId" clId="{2FF1EA3B-BB44-453C-9823-562CC6FBA2BF}" dt="2021-04-07T01:53:51.328" v="389" actId="478"/>
          <ac:spMkLst>
            <pc:docMk/>
            <pc:sldMk cId="542880972" sldId="273"/>
            <ac:spMk id="198" creationId="{6E199D19-794A-46CE-91E8-FB1C2C35C0C0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199" creationId="{F0CB7E3E-6559-4557-AF27-85E0D9141085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200" creationId="{F3E659AF-242E-45DE-8B86-BE7D5C0F7798}"/>
          </ac:spMkLst>
        </pc:spChg>
        <pc:spChg chg="add del mod">
          <ac:chgData name="Derei Wu" userId="935b1b74ff2f2987" providerId="LiveId" clId="{2FF1EA3B-BB44-453C-9823-562CC6FBA2BF}" dt="2021-04-07T01:50:13.924" v="329" actId="478"/>
          <ac:spMkLst>
            <pc:docMk/>
            <pc:sldMk cId="542880972" sldId="273"/>
            <ac:spMk id="201" creationId="{F83241FD-3363-444E-B4B1-4C0F15C47BB0}"/>
          </ac:spMkLst>
        </pc:spChg>
        <pc:spChg chg="add del mod">
          <ac:chgData name="Derei Wu" userId="935b1b74ff2f2987" providerId="LiveId" clId="{2FF1EA3B-BB44-453C-9823-562CC6FBA2BF}" dt="2021-04-07T01:50:02.863" v="320" actId="478"/>
          <ac:spMkLst>
            <pc:docMk/>
            <pc:sldMk cId="542880972" sldId="273"/>
            <ac:spMk id="202" creationId="{0393DC7D-8106-4C6B-B586-4F65CA2B8EDA}"/>
          </ac:spMkLst>
        </pc:spChg>
        <pc:spChg chg="add del mod">
          <ac:chgData name="Derei Wu" userId="935b1b74ff2f2987" providerId="LiveId" clId="{2FF1EA3B-BB44-453C-9823-562CC6FBA2BF}" dt="2021-04-07T01:53:52.242" v="390" actId="478"/>
          <ac:spMkLst>
            <pc:docMk/>
            <pc:sldMk cId="542880972" sldId="273"/>
            <ac:spMk id="203" creationId="{B899F98A-8A8B-4B9A-A36B-8EBAA8F75866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204" creationId="{A32CC8FE-F6F2-4551-8013-1AEF5BA554F9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205" creationId="{2684D760-7CBB-4433-A1A9-434C85B2EF99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206" creationId="{96F7349B-714F-4468-81CC-504867FB1C62}"/>
          </ac:spMkLst>
        </pc:spChg>
        <pc:spChg chg="add del mod">
          <ac:chgData name="Derei Wu" userId="935b1b74ff2f2987" providerId="LiveId" clId="{2FF1EA3B-BB44-453C-9823-562CC6FBA2BF}" dt="2021-04-07T01:52:33.135" v="366" actId="478"/>
          <ac:spMkLst>
            <pc:docMk/>
            <pc:sldMk cId="542880972" sldId="273"/>
            <ac:spMk id="207" creationId="{286654BA-B989-4C56-83BE-C1FAA5973160}"/>
          </ac:spMkLst>
        </pc:spChg>
        <pc:spChg chg="add del mod">
          <ac:chgData name="Derei Wu" userId="935b1b74ff2f2987" providerId="LiveId" clId="{2FF1EA3B-BB44-453C-9823-562CC6FBA2BF}" dt="2021-04-07T01:50:06.661" v="323" actId="478"/>
          <ac:spMkLst>
            <pc:docMk/>
            <pc:sldMk cId="542880972" sldId="273"/>
            <ac:spMk id="208" creationId="{B0C8FB92-C56B-43E1-9FBA-C31AA9C6A09A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209" creationId="{E07113D7-2D5F-40F3-9121-3AEC53A8FEFB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210" creationId="{111032F3-0974-46EE-BC67-2A09BDB06A41}"/>
          </ac:spMkLst>
        </pc:spChg>
        <pc:spChg chg="add del mod">
          <ac:chgData name="Derei Wu" userId="935b1b74ff2f2987" providerId="LiveId" clId="{2FF1EA3B-BB44-453C-9823-562CC6FBA2BF}" dt="2021-04-07T01:52:32.041" v="365" actId="478"/>
          <ac:spMkLst>
            <pc:docMk/>
            <pc:sldMk cId="542880972" sldId="273"/>
            <ac:spMk id="211" creationId="{01DF1535-FFAA-4E23-A341-33D938EB3A44}"/>
          </ac:spMkLst>
        </pc:spChg>
        <pc:spChg chg="add del mod">
          <ac:chgData name="Derei Wu" userId="935b1b74ff2f2987" providerId="LiveId" clId="{2FF1EA3B-BB44-453C-9823-562CC6FBA2BF}" dt="2021-04-07T01:50:23.837" v="330" actId="478"/>
          <ac:spMkLst>
            <pc:docMk/>
            <pc:sldMk cId="542880972" sldId="273"/>
            <ac:spMk id="212" creationId="{984C45BD-5654-482F-B8CB-A768EA7465C0}"/>
          </ac:spMkLst>
        </pc:spChg>
        <pc:spChg chg="add del mod">
          <ac:chgData name="Derei Wu" userId="935b1b74ff2f2987" providerId="LiveId" clId="{2FF1EA3B-BB44-453C-9823-562CC6FBA2BF}" dt="2021-04-07T01:54:06.441" v="393" actId="478"/>
          <ac:spMkLst>
            <pc:docMk/>
            <pc:sldMk cId="542880972" sldId="273"/>
            <ac:spMk id="213" creationId="{66FA288B-67D6-42EB-BE31-9E1D60A86D06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214" creationId="{48BDF6D8-3AA0-4249-A050-486B61D8EB7F}"/>
          </ac:spMkLst>
        </pc:spChg>
        <pc:spChg chg="add del mod">
          <ac:chgData name="Derei Wu" userId="935b1b74ff2f2987" providerId="LiveId" clId="{2FF1EA3B-BB44-453C-9823-562CC6FBA2BF}" dt="2021-04-07T01:52:34.707" v="367" actId="478"/>
          <ac:spMkLst>
            <pc:docMk/>
            <pc:sldMk cId="542880972" sldId="273"/>
            <ac:spMk id="215" creationId="{734F6F9D-320B-4338-9CEA-6AD491FF34D6}"/>
          </ac:spMkLst>
        </pc:spChg>
        <pc:spChg chg="add del mod">
          <ac:chgData name="Derei Wu" userId="935b1b74ff2f2987" providerId="LiveId" clId="{2FF1EA3B-BB44-453C-9823-562CC6FBA2BF}" dt="2021-04-07T01:50:25.196" v="331" actId="478"/>
          <ac:spMkLst>
            <pc:docMk/>
            <pc:sldMk cId="542880972" sldId="273"/>
            <ac:spMk id="216" creationId="{5795AE7D-A4CC-4B7F-A424-65B346DB4B0C}"/>
          </ac:spMkLst>
        </pc:spChg>
        <pc:spChg chg="add del mod">
          <ac:chgData name="Derei Wu" userId="935b1b74ff2f2987" providerId="LiveId" clId="{2FF1EA3B-BB44-453C-9823-562CC6FBA2BF}" dt="2021-04-07T01:54:07.201" v="394" actId="478"/>
          <ac:spMkLst>
            <pc:docMk/>
            <pc:sldMk cId="542880972" sldId="273"/>
            <ac:spMk id="217" creationId="{A3A7D224-9723-4325-A272-7DDD13F44CD7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218" creationId="{E6D0CCC1-3E51-4275-A90F-D01164C9A0AE}"/>
          </ac:spMkLst>
        </pc:spChg>
        <pc:spChg chg="add del mod">
          <ac:chgData name="Derei Wu" userId="935b1b74ff2f2987" providerId="LiveId" clId="{2FF1EA3B-BB44-453C-9823-562CC6FBA2BF}" dt="2021-04-07T01:52:36.098" v="368" actId="478"/>
          <ac:spMkLst>
            <pc:docMk/>
            <pc:sldMk cId="542880972" sldId="273"/>
            <ac:spMk id="219" creationId="{A43AFB5C-015F-4390-8A33-2D30AE4D7BB4}"/>
          </ac:spMkLst>
        </pc:spChg>
        <pc:spChg chg="add del mod">
          <ac:chgData name="Derei Wu" userId="935b1b74ff2f2987" providerId="LiveId" clId="{2FF1EA3B-BB44-453C-9823-562CC6FBA2BF}" dt="2021-04-07T01:50:12.907" v="328" actId="478"/>
          <ac:spMkLst>
            <pc:docMk/>
            <pc:sldMk cId="542880972" sldId="273"/>
            <ac:spMk id="220" creationId="{4D429B92-D113-4E40-BD75-099719EB62AA}"/>
          </ac:spMkLst>
        </pc:spChg>
        <pc:spChg chg="add del mod">
          <ac:chgData name="Derei Wu" userId="935b1b74ff2f2987" providerId="LiveId" clId="{2FF1EA3B-BB44-453C-9823-562CC6FBA2BF}" dt="2021-04-07T01:54:08.201" v="395" actId="478"/>
          <ac:spMkLst>
            <pc:docMk/>
            <pc:sldMk cId="542880972" sldId="273"/>
            <ac:spMk id="221" creationId="{0226BEAB-D317-41BC-B9C9-F5EA0D71B9CE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222" creationId="{0C917632-6C9D-4BE6-B3F2-A51954E227E9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223" creationId="{94742BCF-9485-4601-847D-BD2360DBC34E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224" creationId="{288665E0-DE63-41BC-ADFD-9284FF5EDB64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225" creationId="{1B2FD6AD-F9E1-43C9-B96F-D621D8BA33E2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226" creationId="{1D0CE1A6-8B58-47FA-8172-2BFC397749DA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227" creationId="{F30BCB72-46E7-49AB-A3EE-BC5A638FCAAE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230" creationId="{11911681-118A-48D1-B4E0-9E12967A1FD7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232" creationId="{84B662E6-AA26-431C-B1D7-074829354AE6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233" creationId="{4DB7A03D-67C9-4D81-9895-E604FF81E0B3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235" creationId="{5C50ED2B-E102-4AD4-9F18-537C0E9254CB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236" creationId="{56FAD2A8-5885-4E25-BC36-A30A13420308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237" creationId="{ADC4ABA5-7183-4690-973A-50B05EB84006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239" creationId="{3C4A5792-F7BE-49BB-80EB-B1FFA8E0C450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240" creationId="{B29AE643-A0C1-4D98-B5C2-E64C7408EC4D}"/>
          </ac:spMkLst>
        </pc:spChg>
        <pc:spChg chg="add mod">
          <ac:chgData name="Derei Wu" userId="935b1b74ff2f2987" providerId="LiveId" clId="{2FF1EA3B-BB44-453C-9823-562CC6FBA2BF}" dt="2021-04-07T01:53:14.329" v="381" actId="1076"/>
          <ac:spMkLst>
            <pc:docMk/>
            <pc:sldMk cId="542880972" sldId="273"/>
            <ac:spMk id="241" creationId="{E6E6CB30-6123-4183-9EE5-8AA3B967AFFC}"/>
          </ac:spMkLst>
        </pc:spChg>
        <pc:spChg chg="add mod">
          <ac:chgData name="Derei Wu" userId="935b1b74ff2f2987" providerId="LiveId" clId="{2FF1EA3B-BB44-453C-9823-562CC6FBA2BF}" dt="2021-04-07T02:01:53.183" v="429" actId="1076"/>
          <ac:spMkLst>
            <pc:docMk/>
            <pc:sldMk cId="542880972" sldId="273"/>
            <ac:spMk id="243" creationId="{64CCD2D5-566B-4D14-802D-52219EB8E1A8}"/>
          </ac:spMkLst>
        </pc:spChg>
        <pc:graphicFrameChg chg="del">
          <ac:chgData name="Derei Wu" userId="935b1b74ff2f2987" providerId="LiveId" clId="{2FF1EA3B-BB44-453C-9823-562CC6FBA2BF}" dt="2021-04-07T01:27:27.251" v="1" actId="478"/>
          <ac:graphicFrameMkLst>
            <pc:docMk/>
            <pc:sldMk cId="542880972" sldId="273"/>
            <ac:graphicFrameMk id="18" creationId="{536730EC-35FE-4652-AD57-B65FF6013799}"/>
          </ac:graphicFrameMkLst>
        </pc:graphicFrameChg>
        <pc:graphicFrameChg chg="del">
          <ac:chgData name="Derei Wu" userId="935b1b74ff2f2987" providerId="LiveId" clId="{2FF1EA3B-BB44-453C-9823-562CC6FBA2BF}" dt="2021-04-07T01:27:27.251" v="1" actId="478"/>
          <ac:graphicFrameMkLst>
            <pc:docMk/>
            <pc:sldMk cId="542880972" sldId="273"/>
            <ac:graphicFrameMk id="19" creationId="{7094C618-2B23-4602-BA91-DA2279FBF61D}"/>
          </ac:graphicFrameMkLst>
        </pc:graphicFrameChg>
        <pc:picChg chg="add mod">
          <ac:chgData name="Derei Wu" userId="935b1b74ff2f2987" providerId="LiveId" clId="{2FF1EA3B-BB44-453C-9823-562CC6FBA2BF}" dt="2021-04-07T01:53:14.329" v="381" actId="1076"/>
          <ac:picMkLst>
            <pc:docMk/>
            <pc:sldMk cId="542880972" sldId="273"/>
            <ac:picMk id="28" creationId="{68701139-93EB-419B-82A6-A18A7A99844E}"/>
          </ac:picMkLst>
        </pc:picChg>
        <pc:picChg chg="add mod">
          <ac:chgData name="Derei Wu" userId="935b1b74ff2f2987" providerId="LiveId" clId="{2FF1EA3B-BB44-453C-9823-562CC6FBA2BF}" dt="2021-04-07T01:53:14.329" v="381" actId="1076"/>
          <ac:picMkLst>
            <pc:docMk/>
            <pc:sldMk cId="542880972" sldId="273"/>
            <ac:picMk id="29" creationId="{22C1FF2C-F1B7-49C7-B0C2-4733F7818707}"/>
          </ac:picMkLst>
        </pc:picChg>
        <pc:picChg chg="add mod">
          <ac:chgData name="Derei Wu" userId="935b1b74ff2f2987" providerId="LiveId" clId="{2FF1EA3B-BB44-453C-9823-562CC6FBA2BF}" dt="2021-04-07T01:53:14.329" v="381" actId="1076"/>
          <ac:picMkLst>
            <pc:docMk/>
            <pc:sldMk cId="542880972" sldId="273"/>
            <ac:picMk id="30" creationId="{E433B968-0EE9-4CD2-B75C-3ABFB898BFD0}"/>
          </ac:picMkLst>
        </pc:picChg>
        <pc:picChg chg="add mod">
          <ac:chgData name="Derei Wu" userId="935b1b74ff2f2987" providerId="LiveId" clId="{2FF1EA3B-BB44-453C-9823-562CC6FBA2BF}" dt="2021-04-07T01:53:14.329" v="381" actId="1076"/>
          <ac:picMkLst>
            <pc:docMk/>
            <pc:sldMk cId="542880972" sldId="273"/>
            <ac:picMk id="31" creationId="{44FA4B2C-F0ED-4A29-9864-6EDB88C3BA1D}"/>
          </ac:picMkLst>
        </pc:picChg>
        <pc:picChg chg="add mod">
          <ac:chgData name="Derei Wu" userId="935b1b74ff2f2987" providerId="LiveId" clId="{2FF1EA3B-BB44-453C-9823-562CC6FBA2BF}" dt="2021-04-07T01:53:14.329" v="381" actId="1076"/>
          <ac:picMkLst>
            <pc:docMk/>
            <pc:sldMk cId="542880972" sldId="273"/>
            <ac:picMk id="53" creationId="{A33B49C5-0659-4A54-A2C1-38B4D9ACE97A}"/>
          </ac:picMkLst>
        </pc:picChg>
        <pc:picChg chg="add mod">
          <ac:chgData name="Derei Wu" userId="935b1b74ff2f2987" providerId="LiveId" clId="{2FF1EA3B-BB44-453C-9823-562CC6FBA2BF}" dt="2021-04-07T01:53:14.329" v="381" actId="1076"/>
          <ac:picMkLst>
            <pc:docMk/>
            <pc:sldMk cId="542880972" sldId="273"/>
            <ac:picMk id="54" creationId="{5693DEE2-F9ED-4989-83C0-9ACF329D15A2}"/>
          </ac:picMkLst>
        </pc:picChg>
        <pc:picChg chg="add mod">
          <ac:chgData name="Derei Wu" userId="935b1b74ff2f2987" providerId="LiveId" clId="{2FF1EA3B-BB44-453C-9823-562CC6FBA2BF}" dt="2021-04-07T01:53:14.329" v="381" actId="1076"/>
          <ac:picMkLst>
            <pc:docMk/>
            <pc:sldMk cId="542880972" sldId="273"/>
            <ac:picMk id="55" creationId="{D76E0DF2-24BF-46BF-B765-E9E6AFC8E25F}"/>
          </ac:picMkLst>
        </pc:picChg>
        <pc:picChg chg="add mod">
          <ac:chgData name="Derei Wu" userId="935b1b74ff2f2987" providerId="LiveId" clId="{2FF1EA3B-BB44-453C-9823-562CC6FBA2BF}" dt="2021-04-07T01:53:14.329" v="381" actId="1076"/>
          <ac:picMkLst>
            <pc:docMk/>
            <pc:sldMk cId="542880972" sldId="273"/>
            <ac:picMk id="56" creationId="{54B7DB4A-9A40-4E8B-B362-5D0C6A6A8A4C}"/>
          </ac:picMkLst>
        </pc:picChg>
        <pc:picChg chg="add mod">
          <ac:chgData name="Derei Wu" userId="935b1b74ff2f2987" providerId="LiveId" clId="{2FF1EA3B-BB44-453C-9823-562CC6FBA2BF}" dt="2021-04-07T01:53:14.329" v="381" actId="1076"/>
          <ac:picMkLst>
            <pc:docMk/>
            <pc:sldMk cId="542880972" sldId="273"/>
            <ac:picMk id="78" creationId="{33720D61-B989-4146-8B3B-7BE5E77A84C9}"/>
          </ac:picMkLst>
        </pc:picChg>
        <pc:picChg chg="add mod">
          <ac:chgData name="Derei Wu" userId="935b1b74ff2f2987" providerId="LiveId" clId="{2FF1EA3B-BB44-453C-9823-562CC6FBA2BF}" dt="2021-04-07T01:53:14.329" v="381" actId="1076"/>
          <ac:picMkLst>
            <pc:docMk/>
            <pc:sldMk cId="542880972" sldId="273"/>
            <ac:picMk id="80" creationId="{5DFFB2EC-5D34-4B72-8143-F4258600C2DA}"/>
          </ac:picMkLst>
        </pc:picChg>
        <pc:picChg chg="add del mod">
          <ac:chgData name="Derei Wu" userId="935b1b74ff2f2987" providerId="LiveId" clId="{2FF1EA3B-BB44-453C-9823-562CC6FBA2BF}" dt="2021-04-07T01:44:59.058" v="189" actId="21"/>
          <ac:picMkLst>
            <pc:docMk/>
            <pc:sldMk cId="542880972" sldId="273"/>
            <ac:picMk id="81" creationId="{270F8AB3-1282-4876-BB6E-E0C96C279573}"/>
          </ac:picMkLst>
        </pc:picChg>
        <pc:picChg chg="add mod">
          <ac:chgData name="Derei Wu" userId="935b1b74ff2f2987" providerId="LiveId" clId="{2FF1EA3B-BB44-453C-9823-562CC6FBA2BF}" dt="2021-04-07T01:53:14.329" v="381" actId="1076"/>
          <ac:picMkLst>
            <pc:docMk/>
            <pc:sldMk cId="542880972" sldId="273"/>
            <ac:picMk id="84" creationId="{622F28BA-43FB-42A7-A46A-99F0CCBE9B4B}"/>
          </ac:picMkLst>
        </pc:picChg>
        <pc:picChg chg="add del mod">
          <ac:chgData name="Derei Wu" userId="935b1b74ff2f2987" providerId="LiveId" clId="{2FF1EA3B-BB44-453C-9823-562CC6FBA2BF}" dt="2021-04-07T01:33:21.020" v="21"/>
          <ac:picMkLst>
            <pc:docMk/>
            <pc:sldMk cId="542880972" sldId="273"/>
            <ac:picMk id="86" creationId="{05671A7B-9B0E-4527-A666-D935812DD46B}"/>
          </ac:picMkLst>
        </pc:picChg>
        <pc:picChg chg="add del mod">
          <ac:chgData name="Derei Wu" userId="935b1b74ff2f2987" providerId="LiveId" clId="{2FF1EA3B-BB44-453C-9823-562CC6FBA2BF}" dt="2021-04-07T01:33:21.020" v="21"/>
          <ac:picMkLst>
            <pc:docMk/>
            <pc:sldMk cId="542880972" sldId="273"/>
            <ac:picMk id="87" creationId="{AC70B8DB-F93E-4235-8BC3-70FCE2C62934}"/>
          </ac:picMkLst>
        </pc:picChg>
        <pc:picChg chg="add del mod">
          <ac:chgData name="Derei Wu" userId="935b1b74ff2f2987" providerId="LiveId" clId="{2FF1EA3B-BB44-453C-9823-562CC6FBA2BF}" dt="2021-04-07T01:33:21.020" v="21"/>
          <ac:picMkLst>
            <pc:docMk/>
            <pc:sldMk cId="542880972" sldId="273"/>
            <ac:picMk id="88" creationId="{7032040D-6F50-4CD8-86FD-60ABC751A422}"/>
          </ac:picMkLst>
        </pc:picChg>
        <pc:picChg chg="add del mod">
          <ac:chgData name="Derei Wu" userId="935b1b74ff2f2987" providerId="LiveId" clId="{2FF1EA3B-BB44-453C-9823-562CC6FBA2BF}" dt="2021-04-07T01:33:21.020" v="21"/>
          <ac:picMkLst>
            <pc:docMk/>
            <pc:sldMk cId="542880972" sldId="273"/>
            <ac:picMk id="89" creationId="{35AB13A5-EC86-42BA-822C-E6E7CD4271DA}"/>
          </ac:picMkLst>
        </pc:picChg>
        <pc:picChg chg="add del mod">
          <ac:chgData name="Derei Wu" userId="935b1b74ff2f2987" providerId="LiveId" clId="{2FF1EA3B-BB44-453C-9823-562CC6FBA2BF}" dt="2021-04-07T01:33:21.020" v="21"/>
          <ac:picMkLst>
            <pc:docMk/>
            <pc:sldMk cId="542880972" sldId="273"/>
            <ac:picMk id="90" creationId="{23CEC106-1655-4D9A-B5B9-EBBC0EF5A9AA}"/>
          </ac:picMkLst>
        </pc:picChg>
        <pc:picChg chg="add del mod">
          <ac:chgData name="Derei Wu" userId="935b1b74ff2f2987" providerId="LiveId" clId="{2FF1EA3B-BB44-453C-9823-562CC6FBA2BF}" dt="2021-04-07T01:33:21.020" v="21"/>
          <ac:picMkLst>
            <pc:docMk/>
            <pc:sldMk cId="542880972" sldId="273"/>
            <ac:picMk id="91" creationId="{019A3B90-BD8D-4665-A7EB-62EE39C30FAA}"/>
          </ac:picMkLst>
        </pc:picChg>
        <pc:picChg chg="add del mod">
          <ac:chgData name="Derei Wu" userId="935b1b74ff2f2987" providerId="LiveId" clId="{2FF1EA3B-BB44-453C-9823-562CC6FBA2BF}" dt="2021-04-07T01:33:21.020" v="21"/>
          <ac:picMkLst>
            <pc:docMk/>
            <pc:sldMk cId="542880972" sldId="273"/>
            <ac:picMk id="92" creationId="{5CD75117-5F11-4645-867C-9B2B1B82698B}"/>
          </ac:picMkLst>
        </pc:picChg>
        <pc:picChg chg="add del mod">
          <ac:chgData name="Derei Wu" userId="935b1b74ff2f2987" providerId="LiveId" clId="{2FF1EA3B-BB44-453C-9823-562CC6FBA2BF}" dt="2021-04-07T01:33:21.020" v="21"/>
          <ac:picMkLst>
            <pc:docMk/>
            <pc:sldMk cId="542880972" sldId="273"/>
            <ac:picMk id="93" creationId="{BF20F231-A2FE-454B-B10C-E49F3E987890}"/>
          </ac:picMkLst>
        </pc:picChg>
        <pc:picChg chg="add del mod">
          <ac:chgData name="Derei Wu" userId="935b1b74ff2f2987" providerId="LiveId" clId="{2FF1EA3B-BB44-453C-9823-562CC6FBA2BF}" dt="2021-04-07T01:33:21.020" v="21"/>
          <ac:picMkLst>
            <pc:docMk/>
            <pc:sldMk cId="542880972" sldId="273"/>
            <ac:picMk id="153" creationId="{E96AF62A-361C-470A-B1B8-F62D628F4976}"/>
          </ac:picMkLst>
        </pc:picChg>
        <pc:picChg chg="add del mod">
          <ac:chgData name="Derei Wu" userId="935b1b74ff2f2987" providerId="LiveId" clId="{2FF1EA3B-BB44-453C-9823-562CC6FBA2BF}" dt="2021-04-07T01:33:21.020" v="21"/>
          <ac:picMkLst>
            <pc:docMk/>
            <pc:sldMk cId="542880972" sldId="273"/>
            <ac:picMk id="154" creationId="{B04C649E-3338-4D5B-89CB-7AA777D7BE8E}"/>
          </ac:picMkLst>
        </pc:picChg>
        <pc:picChg chg="add del mod">
          <ac:chgData name="Derei Wu" userId="935b1b74ff2f2987" providerId="LiveId" clId="{2FF1EA3B-BB44-453C-9823-562CC6FBA2BF}" dt="2021-04-07T01:33:21.020" v="21"/>
          <ac:picMkLst>
            <pc:docMk/>
            <pc:sldMk cId="542880972" sldId="273"/>
            <ac:picMk id="156" creationId="{8E28C8EC-A8DE-4906-BE0B-A0EC1915D2F8}"/>
          </ac:picMkLst>
        </pc:picChg>
        <pc:picChg chg="add del mod">
          <ac:chgData name="Derei Wu" userId="935b1b74ff2f2987" providerId="LiveId" clId="{2FF1EA3B-BB44-453C-9823-562CC6FBA2BF}" dt="2021-04-07T01:33:21.020" v="21"/>
          <ac:picMkLst>
            <pc:docMk/>
            <pc:sldMk cId="542880972" sldId="273"/>
            <ac:picMk id="159" creationId="{325A7376-669E-4E0A-9A8B-2C1D434B3F65}"/>
          </ac:picMkLst>
        </pc:picChg>
        <pc:picChg chg="add mod">
          <ac:chgData name="Derei Wu" userId="935b1b74ff2f2987" providerId="LiveId" clId="{2FF1EA3B-BB44-453C-9823-562CC6FBA2BF}" dt="2021-04-07T02:01:53.183" v="429" actId="1076"/>
          <ac:picMkLst>
            <pc:docMk/>
            <pc:sldMk cId="542880972" sldId="273"/>
            <ac:picMk id="161" creationId="{DE64C329-1FF3-4D97-9252-1485C7D43B8C}"/>
          </ac:picMkLst>
        </pc:picChg>
        <pc:picChg chg="add mod">
          <ac:chgData name="Derei Wu" userId="935b1b74ff2f2987" providerId="LiveId" clId="{2FF1EA3B-BB44-453C-9823-562CC6FBA2BF}" dt="2021-04-07T02:01:53.183" v="429" actId="1076"/>
          <ac:picMkLst>
            <pc:docMk/>
            <pc:sldMk cId="542880972" sldId="273"/>
            <ac:picMk id="162" creationId="{E1489A57-8DF3-4262-B330-BB861F5CADA4}"/>
          </ac:picMkLst>
        </pc:picChg>
        <pc:picChg chg="add mod">
          <ac:chgData name="Derei Wu" userId="935b1b74ff2f2987" providerId="LiveId" clId="{2FF1EA3B-BB44-453C-9823-562CC6FBA2BF}" dt="2021-04-07T02:01:53.183" v="429" actId="1076"/>
          <ac:picMkLst>
            <pc:docMk/>
            <pc:sldMk cId="542880972" sldId="273"/>
            <ac:picMk id="163" creationId="{8A7A7CD7-4753-45C1-8BE8-603716C4A402}"/>
          </ac:picMkLst>
        </pc:picChg>
        <pc:picChg chg="add mod">
          <ac:chgData name="Derei Wu" userId="935b1b74ff2f2987" providerId="LiveId" clId="{2FF1EA3B-BB44-453C-9823-562CC6FBA2BF}" dt="2021-04-07T02:01:53.183" v="429" actId="1076"/>
          <ac:picMkLst>
            <pc:docMk/>
            <pc:sldMk cId="542880972" sldId="273"/>
            <ac:picMk id="164" creationId="{C6A3484F-BA67-4B86-843F-A31441654B9A}"/>
          </ac:picMkLst>
        </pc:picChg>
        <pc:picChg chg="add mod">
          <ac:chgData name="Derei Wu" userId="935b1b74ff2f2987" providerId="LiveId" clId="{2FF1EA3B-BB44-453C-9823-562CC6FBA2BF}" dt="2021-04-07T02:01:53.183" v="429" actId="1076"/>
          <ac:picMkLst>
            <pc:docMk/>
            <pc:sldMk cId="542880972" sldId="273"/>
            <ac:picMk id="165" creationId="{A0D78E65-44F3-4841-8935-21F9657A9F40}"/>
          </ac:picMkLst>
        </pc:picChg>
        <pc:picChg chg="add mod">
          <ac:chgData name="Derei Wu" userId="935b1b74ff2f2987" providerId="LiveId" clId="{2FF1EA3B-BB44-453C-9823-562CC6FBA2BF}" dt="2021-04-07T02:01:53.183" v="429" actId="1076"/>
          <ac:picMkLst>
            <pc:docMk/>
            <pc:sldMk cId="542880972" sldId="273"/>
            <ac:picMk id="166" creationId="{0EF127C0-8C22-4FB2-82D0-00C1987AD9C4}"/>
          </ac:picMkLst>
        </pc:picChg>
        <pc:picChg chg="add mod">
          <ac:chgData name="Derei Wu" userId="935b1b74ff2f2987" providerId="LiveId" clId="{2FF1EA3B-BB44-453C-9823-562CC6FBA2BF}" dt="2021-04-07T02:01:53.183" v="429" actId="1076"/>
          <ac:picMkLst>
            <pc:docMk/>
            <pc:sldMk cId="542880972" sldId="273"/>
            <ac:picMk id="167" creationId="{C8A1BCA2-733C-4172-9BC2-73373088413E}"/>
          </ac:picMkLst>
        </pc:picChg>
        <pc:picChg chg="add mod">
          <ac:chgData name="Derei Wu" userId="935b1b74ff2f2987" providerId="LiveId" clId="{2FF1EA3B-BB44-453C-9823-562CC6FBA2BF}" dt="2021-04-07T02:01:53.183" v="429" actId="1076"/>
          <ac:picMkLst>
            <pc:docMk/>
            <pc:sldMk cId="542880972" sldId="273"/>
            <ac:picMk id="168" creationId="{749F9DD0-BB49-4342-B568-C34E15A49ABC}"/>
          </ac:picMkLst>
        </pc:picChg>
        <pc:picChg chg="add mod">
          <ac:chgData name="Derei Wu" userId="935b1b74ff2f2987" providerId="LiveId" clId="{2FF1EA3B-BB44-453C-9823-562CC6FBA2BF}" dt="2021-04-07T02:01:53.183" v="429" actId="1076"/>
          <ac:picMkLst>
            <pc:docMk/>
            <pc:sldMk cId="542880972" sldId="273"/>
            <ac:picMk id="228" creationId="{3432EDB2-F027-4B0E-821E-E7F25E1CCE0D}"/>
          </ac:picMkLst>
        </pc:picChg>
        <pc:picChg chg="add mod">
          <ac:chgData name="Derei Wu" userId="935b1b74ff2f2987" providerId="LiveId" clId="{2FF1EA3B-BB44-453C-9823-562CC6FBA2BF}" dt="2021-04-07T02:01:53.183" v="429" actId="1076"/>
          <ac:picMkLst>
            <pc:docMk/>
            <pc:sldMk cId="542880972" sldId="273"/>
            <ac:picMk id="229" creationId="{50A79FAE-20B3-4B56-8753-1F05BF4B5E61}"/>
          </ac:picMkLst>
        </pc:picChg>
        <pc:picChg chg="add mod">
          <ac:chgData name="Derei Wu" userId="935b1b74ff2f2987" providerId="LiveId" clId="{2FF1EA3B-BB44-453C-9823-562CC6FBA2BF}" dt="2021-04-07T02:01:53.183" v="429" actId="1076"/>
          <ac:picMkLst>
            <pc:docMk/>
            <pc:sldMk cId="542880972" sldId="273"/>
            <ac:picMk id="231" creationId="{39363777-97EE-4338-8ED1-51101ADB0CC5}"/>
          </ac:picMkLst>
        </pc:picChg>
        <pc:picChg chg="add mod">
          <ac:chgData name="Derei Wu" userId="935b1b74ff2f2987" providerId="LiveId" clId="{2FF1EA3B-BB44-453C-9823-562CC6FBA2BF}" dt="2021-04-07T02:01:53.183" v="429" actId="1076"/>
          <ac:picMkLst>
            <pc:docMk/>
            <pc:sldMk cId="542880972" sldId="273"/>
            <ac:picMk id="234" creationId="{696E7330-D0E0-4373-AA9A-86915BC811AC}"/>
          </ac:picMkLst>
        </pc:picChg>
        <pc:picChg chg="add mod">
          <ac:chgData name="Derei Wu" userId="935b1b74ff2f2987" providerId="LiveId" clId="{2FF1EA3B-BB44-453C-9823-562CC6FBA2BF}" dt="2021-04-07T01:53:14.329" v="381" actId="1076"/>
          <ac:picMkLst>
            <pc:docMk/>
            <pc:sldMk cId="542880972" sldId="273"/>
            <ac:picMk id="238" creationId="{6C738BEE-C020-45C8-94BC-D46F61E1AD17}"/>
          </ac:picMkLst>
        </pc:picChg>
        <pc:cxnChg chg="add mod">
          <ac:chgData name="Derei Wu" userId="935b1b74ff2f2987" providerId="LiveId" clId="{2FF1EA3B-BB44-453C-9823-562CC6FBA2BF}" dt="2021-04-07T01:53:14.329" v="381" actId="1076"/>
          <ac:cxnSpMkLst>
            <pc:docMk/>
            <pc:sldMk cId="542880972" sldId="273"/>
            <ac:cxnSpMk id="4" creationId="{09BB4D3A-6FB7-419B-8CC6-7399FD7667D9}"/>
          </ac:cxnSpMkLst>
        </pc:cxnChg>
        <pc:cxnChg chg="add mod">
          <ac:chgData name="Derei Wu" userId="935b1b74ff2f2987" providerId="LiveId" clId="{2FF1EA3B-BB44-453C-9823-562CC6FBA2BF}" dt="2021-04-07T01:53:14.329" v="381" actId="1076"/>
          <ac:cxnSpMkLst>
            <pc:docMk/>
            <pc:sldMk cId="542880972" sldId="273"/>
            <ac:cxnSpMk id="242" creationId="{C11D5677-70F8-485D-BDAA-5FAA0D623E19}"/>
          </ac:cxnSpMkLst>
        </pc:cxnChg>
      </pc:sldChg>
    </pc:docChg>
  </pc:docChgLst>
  <pc:docChgLst>
    <pc:chgData name="Derei Wu" userId="935b1b74ff2f2987" providerId="LiveId" clId="{68BBCC5B-FA81-4D7D-8EF6-2D075259F7E1}"/>
    <pc:docChg chg="modSld">
      <pc:chgData name="Derei Wu" userId="935b1b74ff2f2987" providerId="LiveId" clId="{68BBCC5B-FA81-4D7D-8EF6-2D075259F7E1}" dt="2021-02-22T05:45:14.510" v="0" actId="6549"/>
      <pc:docMkLst>
        <pc:docMk/>
      </pc:docMkLst>
      <pc:sldChg chg="modSp mod">
        <pc:chgData name="Derei Wu" userId="935b1b74ff2f2987" providerId="LiveId" clId="{68BBCC5B-FA81-4D7D-8EF6-2D075259F7E1}" dt="2021-02-22T05:45:14.510" v="0" actId="6549"/>
        <pc:sldMkLst>
          <pc:docMk/>
          <pc:sldMk cId="3107955919" sldId="260"/>
        </pc:sldMkLst>
        <pc:spChg chg="mod">
          <ac:chgData name="Derei Wu" userId="935b1b74ff2f2987" providerId="LiveId" clId="{68BBCC5B-FA81-4D7D-8EF6-2D075259F7E1}" dt="2021-02-22T05:45:14.510" v="0" actId="6549"/>
          <ac:spMkLst>
            <pc:docMk/>
            <pc:sldMk cId="3107955919" sldId="260"/>
            <ac:spMk id="13" creationId="{00000000-0000-0000-0000-000000000000}"/>
          </ac:spMkLst>
        </pc:spChg>
      </pc:sldChg>
    </pc:docChg>
  </pc:docChgLst>
  <pc:docChgLst>
    <pc:chgData name="Derei Wu" userId="935b1b74ff2f2987" providerId="LiveId" clId="{32A1DC13-3FFC-4D2B-BD9C-A115A5625E05}"/>
    <pc:docChg chg="custSel addSld modSld">
      <pc:chgData name="Derei Wu" userId="935b1b74ff2f2987" providerId="LiveId" clId="{32A1DC13-3FFC-4D2B-BD9C-A115A5625E05}" dt="2021-02-28T07:55:54.942" v="44" actId="1035"/>
      <pc:docMkLst>
        <pc:docMk/>
      </pc:docMkLst>
      <pc:sldChg chg="addSp delSp modSp mod">
        <pc:chgData name="Derei Wu" userId="935b1b74ff2f2987" providerId="LiveId" clId="{32A1DC13-3FFC-4D2B-BD9C-A115A5625E05}" dt="2021-02-28T07:55:54.942" v="44" actId="1035"/>
        <pc:sldMkLst>
          <pc:docMk/>
          <pc:sldMk cId="3197682673" sldId="263"/>
        </pc:sldMkLst>
        <pc:spChg chg="del mod">
          <ac:chgData name="Derei Wu" userId="935b1b74ff2f2987" providerId="LiveId" clId="{32A1DC13-3FFC-4D2B-BD9C-A115A5625E05}" dt="2021-02-28T07:54:28.760" v="18" actId="478"/>
          <ac:spMkLst>
            <pc:docMk/>
            <pc:sldMk cId="3197682673" sldId="263"/>
            <ac:spMk id="5" creationId="{00000000-0000-0000-0000-000000000000}"/>
          </ac:spMkLst>
        </pc:spChg>
        <pc:spChg chg="mod">
          <ac:chgData name="Derei Wu" userId="935b1b74ff2f2987" providerId="LiveId" clId="{32A1DC13-3FFC-4D2B-BD9C-A115A5625E05}" dt="2021-02-28T07:55:54.942" v="44" actId="1035"/>
          <ac:spMkLst>
            <pc:docMk/>
            <pc:sldMk cId="3197682673" sldId="263"/>
            <ac:spMk id="7" creationId="{00000000-0000-0000-0000-000000000000}"/>
          </ac:spMkLst>
        </pc:spChg>
        <pc:spChg chg="del mod">
          <ac:chgData name="Derei Wu" userId="935b1b74ff2f2987" providerId="LiveId" clId="{32A1DC13-3FFC-4D2B-BD9C-A115A5625E05}" dt="2021-02-28T07:54:27.838" v="17" actId="478"/>
          <ac:spMkLst>
            <pc:docMk/>
            <pc:sldMk cId="3197682673" sldId="263"/>
            <ac:spMk id="11" creationId="{00000000-0000-0000-0000-000000000000}"/>
          </ac:spMkLst>
        </pc:spChg>
        <pc:spChg chg="del">
          <ac:chgData name="Derei Wu" userId="935b1b74ff2f2987" providerId="LiveId" clId="{32A1DC13-3FFC-4D2B-BD9C-A115A5625E05}" dt="2021-02-28T07:54:29.728" v="19" actId="478"/>
          <ac:spMkLst>
            <pc:docMk/>
            <pc:sldMk cId="3197682673" sldId="263"/>
            <ac:spMk id="13" creationId="{00000000-0000-0000-0000-000000000000}"/>
          </ac:spMkLst>
        </pc:spChg>
        <pc:spChg chg="mod">
          <ac:chgData name="Derei Wu" userId="935b1b74ff2f2987" providerId="LiveId" clId="{32A1DC13-3FFC-4D2B-BD9C-A115A5625E05}" dt="2021-02-28T07:55:39.352" v="30" actId="164"/>
          <ac:spMkLst>
            <pc:docMk/>
            <pc:sldMk cId="3197682673" sldId="263"/>
            <ac:spMk id="87" creationId="{0DEE7DF7-3DA6-4F3C-ADF6-77EAA0B2B782}"/>
          </ac:spMkLst>
        </pc:spChg>
        <pc:spChg chg="mod">
          <ac:chgData name="Derei Wu" userId="935b1b74ff2f2987" providerId="LiveId" clId="{32A1DC13-3FFC-4D2B-BD9C-A115A5625E05}" dt="2021-02-28T07:55:45.288" v="34" actId="164"/>
          <ac:spMkLst>
            <pc:docMk/>
            <pc:sldMk cId="3197682673" sldId="263"/>
            <ac:spMk id="89" creationId="{4978A823-B75A-4A8C-9A39-57BB610C3BE9}"/>
          </ac:spMkLst>
        </pc:spChg>
        <pc:grpChg chg="add mod">
          <ac:chgData name="Derei Wu" userId="935b1b74ff2f2987" providerId="LiveId" clId="{32A1DC13-3FFC-4D2B-BD9C-A115A5625E05}" dt="2021-02-28T07:55:40.789" v="33" actId="1035"/>
          <ac:grpSpMkLst>
            <pc:docMk/>
            <pc:sldMk cId="3197682673" sldId="263"/>
            <ac:grpSpMk id="18" creationId="{A247D2F2-F3A5-4364-9205-BD89DEF1A1D7}"/>
          </ac:grpSpMkLst>
        </pc:grpChg>
        <pc:grpChg chg="add mod">
          <ac:chgData name="Derei Wu" userId="935b1b74ff2f2987" providerId="LiveId" clId="{32A1DC13-3FFC-4D2B-BD9C-A115A5625E05}" dt="2021-02-28T07:55:46.319" v="38" actId="1035"/>
          <ac:grpSpMkLst>
            <pc:docMk/>
            <pc:sldMk cId="3197682673" sldId="263"/>
            <ac:grpSpMk id="21" creationId="{88A9FEEE-4510-4884-9FBA-A7095690C984}"/>
          </ac:grpSpMkLst>
        </pc:grpChg>
        <pc:grpChg chg="del">
          <ac:chgData name="Derei Wu" userId="935b1b74ff2f2987" providerId="LiveId" clId="{32A1DC13-3FFC-4D2B-BD9C-A115A5625E05}" dt="2021-02-28T07:53:37.069" v="3" actId="478"/>
          <ac:grpSpMkLst>
            <pc:docMk/>
            <pc:sldMk cId="3197682673" sldId="263"/>
            <ac:grpSpMk id="42" creationId="{157057FD-F97E-4166-9F04-4DE9BFF214EC}"/>
          </ac:grpSpMkLst>
        </pc:grpChg>
        <pc:grpChg chg="del">
          <ac:chgData name="Derei Wu" userId="935b1b74ff2f2987" providerId="LiveId" clId="{32A1DC13-3FFC-4D2B-BD9C-A115A5625E05}" dt="2021-02-28T07:53:38.272" v="4" actId="478"/>
          <ac:grpSpMkLst>
            <pc:docMk/>
            <pc:sldMk cId="3197682673" sldId="263"/>
            <ac:grpSpMk id="44" creationId="{8A4DFB1A-17B1-4AA7-A32B-FED4EDB07451}"/>
          </ac:grpSpMkLst>
        </pc:grpChg>
        <pc:graphicFrameChg chg="mod">
          <ac:chgData name="Derei Wu" userId="935b1b74ff2f2987" providerId="LiveId" clId="{32A1DC13-3FFC-4D2B-BD9C-A115A5625E05}" dt="2021-02-28T07:55:54.942" v="44" actId="1035"/>
          <ac:graphicFrameMkLst>
            <pc:docMk/>
            <pc:sldMk cId="3197682673" sldId="263"/>
            <ac:graphicFrameMk id="2" creationId="{8405D2E2-0F6F-472E-A653-BEFB08500646}"/>
          </ac:graphicFrameMkLst>
        </pc:graphicFrameChg>
        <pc:graphicFrameChg chg="mod">
          <ac:chgData name="Derei Wu" userId="935b1b74ff2f2987" providerId="LiveId" clId="{32A1DC13-3FFC-4D2B-BD9C-A115A5625E05}" dt="2021-02-28T07:55:54.942" v="44" actId="1035"/>
          <ac:graphicFrameMkLst>
            <pc:docMk/>
            <pc:sldMk cId="3197682673" sldId="263"/>
            <ac:graphicFrameMk id="8" creationId="{6F8D418C-CC74-400F-BB00-26765C6FE6DB}"/>
          </ac:graphicFrameMkLst>
        </pc:graphicFrameChg>
        <pc:graphicFrameChg chg="mod">
          <ac:chgData name="Derei Wu" userId="935b1b74ff2f2987" providerId="LiveId" clId="{32A1DC13-3FFC-4D2B-BD9C-A115A5625E05}" dt="2021-02-28T07:55:54.942" v="44" actId="1035"/>
          <ac:graphicFrameMkLst>
            <pc:docMk/>
            <pc:sldMk cId="3197682673" sldId="263"/>
            <ac:graphicFrameMk id="9" creationId="{BD7B4165-BEB7-40A3-9C20-3618B5232259}"/>
          </ac:graphicFrameMkLst>
        </pc:graphicFrameChg>
        <pc:graphicFrameChg chg="mod">
          <ac:chgData name="Derei Wu" userId="935b1b74ff2f2987" providerId="LiveId" clId="{32A1DC13-3FFC-4D2B-BD9C-A115A5625E05}" dt="2021-02-28T07:55:54.942" v="44" actId="1035"/>
          <ac:graphicFrameMkLst>
            <pc:docMk/>
            <pc:sldMk cId="3197682673" sldId="263"/>
            <ac:graphicFrameMk id="61" creationId="{AB543B76-7168-40E3-B8CB-EA19CF8ADC80}"/>
          </ac:graphicFrameMkLst>
        </pc:graphicFrameChg>
        <pc:cxnChg chg="mod">
          <ac:chgData name="Derei Wu" userId="935b1b74ff2f2987" providerId="LiveId" clId="{32A1DC13-3FFC-4D2B-BD9C-A115A5625E05}" dt="2021-02-28T07:55:39.352" v="30" actId="164"/>
          <ac:cxnSpMkLst>
            <pc:docMk/>
            <pc:sldMk cId="3197682673" sldId="263"/>
            <ac:cxnSpMk id="19" creationId="{5142E83F-082B-4D3E-A8FD-2B46624DB53A}"/>
          </ac:cxnSpMkLst>
        </pc:cxnChg>
        <pc:cxnChg chg="mod">
          <ac:chgData name="Derei Wu" userId="935b1b74ff2f2987" providerId="LiveId" clId="{32A1DC13-3FFC-4D2B-BD9C-A115A5625E05}" dt="2021-02-28T07:55:45.288" v="34" actId="164"/>
          <ac:cxnSpMkLst>
            <pc:docMk/>
            <pc:sldMk cId="3197682673" sldId="263"/>
            <ac:cxnSpMk id="88" creationId="{1C8A78A0-32E2-48BB-9D8A-5711F38E14D4}"/>
          </ac:cxnSpMkLst>
        </pc:cxnChg>
      </pc:sldChg>
      <pc:sldChg chg="addSp delSp modSp new mod">
        <pc:chgData name="Derei Wu" userId="935b1b74ff2f2987" providerId="LiveId" clId="{32A1DC13-3FFC-4D2B-BD9C-A115A5625E05}" dt="2021-02-28T07:52:58.484" v="2"/>
        <pc:sldMkLst>
          <pc:docMk/>
          <pc:sldMk cId="3417956895" sldId="272"/>
        </pc:sldMkLst>
        <pc:spChg chg="del">
          <ac:chgData name="Derei Wu" userId="935b1b74ff2f2987" providerId="LiveId" clId="{32A1DC13-3FFC-4D2B-BD9C-A115A5625E05}" dt="2021-02-28T07:52:57.359" v="1" actId="478"/>
          <ac:spMkLst>
            <pc:docMk/>
            <pc:sldMk cId="3417956895" sldId="272"/>
            <ac:spMk id="2" creationId="{71253F87-912C-4487-88D1-62D0E9565938}"/>
          </ac:spMkLst>
        </pc:spChg>
        <pc:spChg chg="del">
          <ac:chgData name="Derei Wu" userId="935b1b74ff2f2987" providerId="LiveId" clId="{32A1DC13-3FFC-4D2B-BD9C-A115A5625E05}" dt="2021-02-28T07:52:57.359" v="1" actId="478"/>
          <ac:spMkLst>
            <pc:docMk/>
            <pc:sldMk cId="3417956895" sldId="272"/>
            <ac:spMk id="3" creationId="{01843250-CFAE-436C-A5F3-BEB434310CFE}"/>
          </ac:spMkLst>
        </pc:spChg>
        <pc:graphicFrameChg chg="add mod">
          <ac:chgData name="Derei Wu" userId="935b1b74ff2f2987" providerId="LiveId" clId="{32A1DC13-3FFC-4D2B-BD9C-A115A5625E05}" dt="2021-02-28T07:52:58.484" v="2"/>
          <ac:graphicFrameMkLst>
            <pc:docMk/>
            <pc:sldMk cId="3417956895" sldId="272"/>
            <ac:graphicFrameMk id="6" creationId="{784FF160-BD47-4790-A8AB-7A5FD27DFF8B}"/>
          </ac:graphicFrameMkLst>
        </pc:graphicFrameChg>
        <pc:graphicFrameChg chg="add mod">
          <ac:chgData name="Derei Wu" userId="935b1b74ff2f2987" providerId="LiveId" clId="{32A1DC13-3FFC-4D2B-BD9C-A115A5625E05}" dt="2021-02-28T07:52:58.484" v="2"/>
          <ac:graphicFrameMkLst>
            <pc:docMk/>
            <pc:sldMk cId="3417956895" sldId="272"/>
            <ac:graphicFrameMk id="7" creationId="{797CD684-3DF8-4503-A341-C7260662DF1A}"/>
          </ac:graphicFrameMkLst>
        </pc:graphicFrameChg>
        <pc:graphicFrameChg chg="add mod">
          <ac:chgData name="Derei Wu" userId="935b1b74ff2f2987" providerId="LiveId" clId="{32A1DC13-3FFC-4D2B-BD9C-A115A5625E05}" dt="2021-02-28T07:52:58.484" v="2"/>
          <ac:graphicFrameMkLst>
            <pc:docMk/>
            <pc:sldMk cId="3417956895" sldId="272"/>
            <ac:graphicFrameMk id="8" creationId="{562C7574-41FF-43EE-A3FC-EA99A2CB650C}"/>
          </ac:graphicFrameMkLst>
        </pc:graphicFrameChg>
        <pc:graphicFrameChg chg="add mod">
          <ac:chgData name="Derei Wu" userId="935b1b74ff2f2987" providerId="LiveId" clId="{32A1DC13-3FFC-4D2B-BD9C-A115A5625E05}" dt="2021-02-28T07:52:58.484" v="2"/>
          <ac:graphicFrameMkLst>
            <pc:docMk/>
            <pc:sldMk cId="3417956895" sldId="272"/>
            <ac:graphicFrameMk id="9" creationId="{EC5F4A62-EE9B-45D7-BC63-1AD7FAD398F5}"/>
          </ac:graphicFrameMkLst>
        </pc:graphicFrameChg>
        <pc:graphicFrameChg chg="add mod">
          <ac:chgData name="Derei Wu" userId="935b1b74ff2f2987" providerId="LiveId" clId="{32A1DC13-3FFC-4D2B-BD9C-A115A5625E05}" dt="2021-02-28T07:52:58.484" v="2"/>
          <ac:graphicFrameMkLst>
            <pc:docMk/>
            <pc:sldMk cId="3417956895" sldId="272"/>
            <ac:graphicFrameMk id="10" creationId="{044EECF5-D84D-416C-ABF4-DC9BD433D7F0}"/>
          </ac:graphicFrameMkLst>
        </pc:graphicFrameChg>
        <pc:graphicFrameChg chg="add mod">
          <ac:chgData name="Derei Wu" userId="935b1b74ff2f2987" providerId="LiveId" clId="{32A1DC13-3FFC-4D2B-BD9C-A115A5625E05}" dt="2021-02-28T07:52:58.484" v="2"/>
          <ac:graphicFrameMkLst>
            <pc:docMk/>
            <pc:sldMk cId="3417956895" sldId="272"/>
            <ac:graphicFrameMk id="11" creationId="{AAC4ECFB-DBED-450C-852B-4E24592DBCB9}"/>
          </ac:graphicFrameMkLst>
        </pc:graphicFrameChg>
        <pc:picChg chg="add mod">
          <ac:chgData name="Derei Wu" userId="935b1b74ff2f2987" providerId="LiveId" clId="{32A1DC13-3FFC-4D2B-BD9C-A115A5625E05}" dt="2021-02-28T07:52:58.484" v="2"/>
          <ac:picMkLst>
            <pc:docMk/>
            <pc:sldMk cId="3417956895" sldId="272"/>
            <ac:picMk id="4" creationId="{B59D524A-D825-4993-A747-FD96C3AFAA6C}"/>
          </ac:picMkLst>
        </pc:picChg>
        <pc:picChg chg="add mod">
          <ac:chgData name="Derei Wu" userId="935b1b74ff2f2987" providerId="LiveId" clId="{32A1DC13-3FFC-4D2B-BD9C-A115A5625E05}" dt="2021-02-28T07:52:58.484" v="2"/>
          <ac:picMkLst>
            <pc:docMk/>
            <pc:sldMk cId="3417956895" sldId="272"/>
            <ac:picMk id="5" creationId="{248928A5-4373-43FF-93D5-1C68669D3B6B}"/>
          </ac:picMkLst>
        </pc:picChg>
      </pc:sldChg>
    </pc:docChg>
  </pc:docChgLst>
  <pc:docChgLst>
    <pc:chgData name="Derei Wu" userId="935b1b74ff2f2987" providerId="LiveId" clId="{5E7F6E5C-3D2D-4D61-9419-758C5E1DEF31}"/>
    <pc:docChg chg="custSel modSld">
      <pc:chgData name="Derei Wu" userId="935b1b74ff2f2987" providerId="LiveId" clId="{5E7F6E5C-3D2D-4D61-9419-758C5E1DEF31}" dt="2020-11-27T06:27:35.623" v="119" actId="1076"/>
      <pc:docMkLst>
        <pc:docMk/>
      </pc:docMkLst>
      <pc:sldChg chg="modSp">
        <pc:chgData name="Derei Wu" userId="935b1b74ff2f2987" providerId="LiveId" clId="{5E7F6E5C-3D2D-4D61-9419-758C5E1DEF31}" dt="2020-11-27T06:08:57.582" v="55"/>
        <pc:sldMkLst>
          <pc:docMk/>
          <pc:sldMk cId="598588755" sldId="256"/>
        </pc:sldMkLst>
        <pc:graphicFrameChg chg="mod">
          <ac:chgData name="Derei Wu" userId="935b1b74ff2f2987" providerId="LiveId" clId="{5E7F6E5C-3D2D-4D61-9419-758C5E1DEF31}" dt="2020-11-27T06:08:57.582" v="55"/>
          <ac:graphicFrameMkLst>
            <pc:docMk/>
            <pc:sldMk cId="598588755" sldId="256"/>
            <ac:graphicFrameMk id="19" creationId="{7094C618-2B23-4602-BA91-DA2279FBF61D}"/>
          </ac:graphicFrameMkLst>
        </pc:graphicFrameChg>
      </pc:sldChg>
      <pc:sldChg chg="addSp delSp modSp mod">
        <pc:chgData name="Derei Wu" userId="935b1b74ff2f2987" providerId="LiveId" clId="{5E7F6E5C-3D2D-4D61-9419-758C5E1DEF31}" dt="2020-11-27T06:27:35.623" v="119" actId="1076"/>
        <pc:sldMkLst>
          <pc:docMk/>
          <pc:sldMk cId="1266171639" sldId="257"/>
        </pc:sldMkLst>
        <pc:spChg chg="mod">
          <ac:chgData name="Derei Wu" userId="935b1b74ff2f2987" providerId="LiveId" clId="{5E7F6E5C-3D2D-4D61-9419-758C5E1DEF31}" dt="2020-11-23T08:13:48.082" v="7" actId="1036"/>
          <ac:spMkLst>
            <pc:docMk/>
            <pc:sldMk cId="1266171639" sldId="257"/>
            <ac:spMk id="3" creationId="{74249C33-8D32-4729-88C2-5C0D3AD1FCD5}"/>
          </ac:spMkLst>
        </pc:spChg>
        <pc:spChg chg="del mod">
          <ac:chgData name="Derei Wu" userId="935b1b74ff2f2987" providerId="LiveId" clId="{5E7F6E5C-3D2D-4D61-9419-758C5E1DEF31}" dt="2020-11-27T06:27:31.075" v="118" actId="478"/>
          <ac:spMkLst>
            <pc:docMk/>
            <pc:sldMk cId="1266171639" sldId="257"/>
            <ac:spMk id="5" creationId="{920DA6E4-0B2C-4CE7-AD66-652F41C3A47A}"/>
          </ac:spMkLst>
        </pc:spChg>
        <pc:spChg chg="mod">
          <ac:chgData name="Derei Wu" userId="935b1b74ff2f2987" providerId="LiveId" clId="{5E7F6E5C-3D2D-4D61-9419-758C5E1DEF31}" dt="2020-11-27T06:27:11.185" v="115" actId="1036"/>
          <ac:spMkLst>
            <pc:docMk/>
            <pc:sldMk cId="1266171639" sldId="257"/>
            <ac:spMk id="7" creationId="{00000000-0000-0000-0000-000000000000}"/>
          </ac:spMkLst>
        </pc:spChg>
        <pc:spChg chg="mod">
          <ac:chgData name="Derei Wu" userId="935b1b74ff2f2987" providerId="LiveId" clId="{5E7F6E5C-3D2D-4D61-9419-758C5E1DEF31}" dt="2020-11-27T06:27:28.920" v="117" actId="1076"/>
          <ac:spMkLst>
            <pc:docMk/>
            <pc:sldMk cId="1266171639" sldId="257"/>
            <ac:spMk id="14" creationId="{F38CC67F-308D-427F-BAF0-5293F16EDE71}"/>
          </ac:spMkLst>
        </pc:spChg>
        <pc:spChg chg="del">
          <ac:chgData name="Derei Wu" userId="935b1b74ff2f2987" providerId="LiveId" clId="{5E7F6E5C-3D2D-4D61-9419-758C5E1DEF31}" dt="2020-11-27T06:27:25.483" v="116" actId="478"/>
          <ac:spMkLst>
            <pc:docMk/>
            <pc:sldMk cId="1266171639" sldId="257"/>
            <ac:spMk id="15" creationId="{5D7987AA-424B-47CD-B74B-F49C87CFCDED}"/>
          </ac:spMkLst>
        </pc:spChg>
        <pc:spChg chg="add mod">
          <ac:chgData name="Derei Wu" userId="935b1b74ff2f2987" providerId="LiveId" clId="{5E7F6E5C-3D2D-4D61-9419-758C5E1DEF31}" dt="2020-11-19T07:20:12.618" v="3" actId="1076"/>
          <ac:spMkLst>
            <pc:docMk/>
            <pc:sldMk cId="1266171639" sldId="257"/>
            <ac:spMk id="16" creationId="{F70C9ADA-B7A2-4363-B7EA-BAB950D79FFF}"/>
          </ac:spMkLst>
        </pc:spChg>
        <pc:spChg chg="mod">
          <ac:chgData name="Derei Wu" userId="935b1b74ff2f2987" providerId="LiveId" clId="{5E7F6E5C-3D2D-4D61-9419-758C5E1DEF31}" dt="2020-11-27T06:27:35.623" v="119" actId="1076"/>
          <ac:spMkLst>
            <pc:docMk/>
            <pc:sldMk cId="1266171639" sldId="257"/>
            <ac:spMk id="17" creationId="{56A47AE5-2986-481B-9D3D-A19B37168983}"/>
          </ac:spMkLst>
        </pc:spChg>
        <pc:graphicFrameChg chg="del">
          <ac:chgData name="Derei Wu" userId="935b1b74ff2f2987" providerId="LiveId" clId="{5E7F6E5C-3D2D-4D61-9419-758C5E1DEF31}" dt="2020-11-19T07:12:35.861" v="1" actId="478"/>
          <ac:graphicFrameMkLst>
            <pc:docMk/>
            <pc:sldMk cId="1266171639" sldId="257"/>
            <ac:graphicFrameMk id="9" creationId="{734C0E0F-A776-4F33-AC6C-49ED31C50089}"/>
          </ac:graphicFrameMkLst>
        </pc:graphicFrameChg>
        <pc:graphicFrameChg chg="add mod">
          <ac:chgData name="Derei Wu" userId="935b1b74ff2f2987" providerId="LiveId" clId="{5E7F6E5C-3D2D-4D61-9419-758C5E1DEF31}" dt="2020-11-27T06:27:11.185" v="115" actId="1036"/>
          <ac:graphicFrameMkLst>
            <pc:docMk/>
            <pc:sldMk cId="1266171639" sldId="257"/>
            <ac:graphicFrameMk id="18" creationId="{EDA875E1-07B8-42FA-87C2-4EB65FE9DB7E}"/>
          </ac:graphicFrameMkLst>
        </pc:graphicFrameChg>
        <pc:graphicFrameChg chg="add mod">
          <ac:chgData name="Derei Wu" userId="935b1b74ff2f2987" providerId="LiveId" clId="{5E7F6E5C-3D2D-4D61-9419-758C5E1DEF31}" dt="2020-11-27T06:27:11.185" v="115" actId="1036"/>
          <ac:graphicFrameMkLst>
            <pc:docMk/>
            <pc:sldMk cId="1266171639" sldId="257"/>
            <ac:graphicFrameMk id="19" creationId="{BB8764C8-66FA-4778-8595-3F5E6DC8C8F7}"/>
          </ac:graphicFrameMkLst>
        </pc:graphicFrameChg>
        <pc:picChg chg="del">
          <ac:chgData name="Derei Wu" userId="935b1b74ff2f2987" providerId="LiveId" clId="{5E7F6E5C-3D2D-4D61-9419-758C5E1DEF31}" dt="2020-11-19T07:12:34.074" v="0" actId="478"/>
          <ac:picMkLst>
            <pc:docMk/>
            <pc:sldMk cId="1266171639" sldId="257"/>
            <ac:picMk id="4" creationId="{03E8737F-00E1-4493-B1E3-D5417E49DA17}"/>
          </ac:picMkLst>
        </pc:picChg>
      </pc:sldChg>
      <pc:sldChg chg="addSp modSp mod">
        <pc:chgData name="Derei Wu" userId="935b1b74ff2f2987" providerId="LiveId" clId="{5E7F6E5C-3D2D-4D61-9419-758C5E1DEF31}" dt="2020-11-27T06:11:07.622" v="101" actId="1036"/>
        <pc:sldMkLst>
          <pc:docMk/>
          <pc:sldMk cId="3513237702" sldId="258"/>
        </pc:sldMkLst>
        <pc:spChg chg="add mod">
          <ac:chgData name="Derei Wu" userId="935b1b74ff2f2987" providerId="LiveId" clId="{5E7F6E5C-3D2D-4D61-9419-758C5E1DEF31}" dt="2020-11-27T06:09:53.211" v="66" actId="21"/>
          <ac:spMkLst>
            <pc:docMk/>
            <pc:sldMk cId="3513237702" sldId="258"/>
            <ac:spMk id="15" creationId="{29E5701F-F528-455A-9510-5ADA8BC37EB6}"/>
          </ac:spMkLst>
        </pc:spChg>
        <pc:spChg chg="add mod">
          <ac:chgData name="Derei Wu" userId="935b1b74ff2f2987" providerId="LiveId" clId="{5E7F6E5C-3D2D-4D61-9419-758C5E1DEF31}" dt="2020-11-27T06:10:15.255" v="74" actId="403"/>
          <ac:spMkLst>
            <pc:docMk/>
            <pc:sldMk cId="3513237702" sldId="258"/>
            <ac:spMk id="16" creationId="{A34B90FE-1765-47F3-B0A0-F78C83A64B84}"/>
          </ac:spMkLst>
        </pc:spChg>
        <pc:spChg chg="add mod">
          <ac:chgData name="Derei Wu" userId="935b1b74ff2f2987" providerId="LiveId" clId="{5E7F6E5C-3D2D-4D61-9419-758C5E1DEF31}" dt="2020-11-27T06:11:07.622" v="101" actId="1036"/>
          <ac:spMkLst>
            <pc:docMk/>
            <pc:sldMk cId="3513237702" sldId="258"/>
            <ac:spMk id="36" creationId="{3D0A8270-6FF1-4980-B357-B768474D0AE8}"/>
          </ac:spMkLst>
        </pc:spChg>
        <pc:spChg chg="add mod">
          <ac:chgData name="Derei Wu" userId="935b1b74ff2f2987" providerId="LiveId" clId="{5E7F6E5C-3D2D-4D61-9419-758C5E1DEF31}" dt="2020-11-27T06:10:54.101" v="94" actId="1038"/>
          <ac:spMkLst>
            <pc:docMk/>
            <pc:sldMk cId="3513237702" sldId="258"/>
            <ac:spMk id="37" creationId="{AF5301D9-CF99-4445-A870-0D49A5063C81}"/>
          </ac:spMkLst>
        </pc:spChg>
      </pc:sldChg>
      <pc:sldChg chg="modSp mod">
        <pc:chgData name="Derei Wu" userId="935b1b74ff2f2987" providerId="LiveId" clId="{5E7F6E5C-3D2D-4D61-9419-758C5E1DEF31}" dt="2020-11-27T05:50:09.614" v="16" actId="20577"/>
        <pc:sldMkLst>
          <pc:docMk/>
          <pc:sldMk cId="3107955919" sldId="260"/>
        </pc:sldMkLst>
        <pc:spChg chg="mod">
          <ac:chgData name="Derei Wu" userId="935b1b74ff2f2987" providerId="LiveId" clId="{5E7F6E5C-3D2D-4D61-9419-758C5E1DEF31}" dt="2020-11-27T05:50:09.614" v="16" actId="20577"/>
          <ac:spMkLst>
            <pc:docMk/>
            <pc:sldMk cId="3107955919" sldId="260"/>
            <ac:spMk id="8" creationId="{00000000-0000-0000-0000-000000000000}"/>
          </ac:spMkLst>
        </pc:spChg>
      </pc:sldChg>
      <pc:sldChg chg="addSp delSp modSp mod">
        <pc:chgData name="Derei Wu" userId="935b1b74ff2f2987" providerId="LiveId" clId="{5E7F6E5C-3D2D-4D61-9419-758C5E1DEF31}" dt="2020-11-27T06:05:55.809" v="34"/>
        <pc:sldMkLst>
          <pc:docMk/>
          <pc:sldMk cId="3197682673" sldId="263"/>
        </pc:sldMkLst>
        <pc:graphicFrameChg chg="add mod">
          <ac:chgData name="Derei Wu" userId="935b1b74ff2f2987" providerId="LiveId" clId="{5E7F6E5C-3D2D-4D61-9419-758C5E1DEF31}" dt="2020-11-27T06:05:35.466" v="31"/>
          <ac:graphicFrameMkLst>
            <pc:docMk/>
            <pc:sldMk cId="3197682673" sldId="263"/>
            <ac:graphicFrameMk id="2" creationId="{8405D2E2-0F6F-472E-A653-BEFB08500646}"/>
          </ac:graphicFrameMkLst>
        </pc:graphicFrameChg>
        <pc:graphicFrameChg chg="del mod">
          <ac:chgData name="Derei Wu" userId="935b1b74ff2f2987" providerId="LiveId" clId="{5E7F6E5C-3D2D-4D61-9419-758C5E1DEF31}" dt="2020-11-27T06:04:28.666" v="23" actId="478"/>
          <ac:graphicFrameMkLst>
            <pc:docMk/>
            <pc:sldMk cId="3197682673" sldId="263"/>
            <ac:graphicFrameMk id="47" creationId="{A8F83CF8-B7A6-4A1B-8D70-5A99D241A7D5}"/>
          </ac:graphicFrameMkLst>
        </pc:graphicFrameChg>
        <pc:graphicFrameChg chg="mod">
          <ac:chgData name="Derei Wu" userId="935b1b74ff2f2987" providerId="LiveId" clId="{5E7F6E5C-3D2D-4D61-9419-758C5E1DEF31}" dt="2020-11-27T06:05:55.809" v="34"/>
          <ac:graphicFrameMkLst>
            <pc:docMk/>
            <pc:sldMk cId="3197682673" sldId="263"/>
            <ac:graphicFrameMk id="61" creationId="{AB543B76-7168-40E3-B8CB-EA19CF8ADC80}"/>
          </ac:graphicFrameMkLst>
        </pc:graphicFrameChg>
      </pc:sldChg>
      <pc:sldChg chg="delSp modSp mod">
        <pc:chgData name="Derei Wu" userId="935b1b74ff2f2987" providerId="LiveId" clId="{5E7F6E5C-3D2D-4D61-9419-758C5E1DEF31}" dt="2020-11-27T06:14:12.044" v="102" actId="478"/>
        <pc:sldMkLst>
          <pc:docMk/>
          <pc:sldMk cId="2985042206" sldId="264"/>
        </pc:sldMkLst>
        <pc:spChg chg="del">
          <ac:chgData name="Derei Wu" userId="935b1b74ff2f2987" providerId="LiveId" clId="{5E7F6E5C-3D2D-4D61-9419-758C5E1DEF31}" dt="2020-11-27T06:14:12.044" v="102" actId="478"/>
          <ac:spMkLst>
            <pc:docMk/>
            <pc:sldMk cId="2985042206" sldId="264"/>
            <ac:spMk id="7" creationId="{9BB72A84-57B7-42E0-9D16-F1F863E2608D}"/>
          </ac:spMkLst>
        </pc:spChg>
        <pc:graphicFrameChg chg="del">
          <ac:chgData name="Derei Wu" userId="935b1b74ff2f2987" providerId="LiveId" clId="{5E7F6E5C-3D2D-4D61-9419-758C5E1DEF31}" dt="2020-11-27T06:14:12.044" v="102" actId="478"/>
          <ac:graphicFrameMkLst>
            <pc:docMk/>
            <pc:sldMk cId="2985042206" sldId="264"/>
            <ac:graphicFrameMk id="2" creationId="{B3D444F9-F167-49CA-906F-6EDB27397065}"/>
          </ac:graphicFrameMkLst>
        </pc:graphicFrameChg>
        <pc:graphicFrameChg chg="mod">
          <ac:chgData name="Derei Wu" userId="935b1b74ff2f2987" providerId="LiveId" clId="{5E7F6E5C-3D2D-4D61-9419-758C5E1DEF31}" dt="2020-11-27T06:06:50.959" v="40"/>
          <ac:graphicFrameMkLst>
            <pc:docMk/>
            <pc:sldMk cId="2985042206" sldId="264"/>
            <ac:graphicFrameMk id="3" creationId="{C7C00A1D-9AA8-4B81-826F-F93DD6D8D104}"/>
          </ac:graphicFrameMkLst>
        </pc:graphicFrameChg>
        <pc:graphicFrameChg chg="del">
          <ac:chgData name="Derei Wu" userId="935b1b74ff2f2987" providerId="LiveId" clId="{5E7F6E5C-3D2D-4D61-9419-758C5E1DEF31}" dt="2020-11-27T06:14:12.044" v="102" actId="478"/>
          <ac:graphicFrameMkLst>
            <pc:docMk/>
            <pc:sldMk cId="2985042206" sldId="264"/>
            <ac:graphicFrameMk id="4" creationId="{82CF71B8-99F1-45A8-866F-F928D48AE0DE}"/>
          </ac:graphicFrameMkLst>
        </pc:graphicFrameChg>
        <pc:graphicFrameChg chg="mod">
          <ac:chgData name="Derei Wu" userId="935b1b74ff2f2987" providerId="LiveId" clId="{5E7F6E5C-3D2D-4D61-9419-758C5E1DEF31}" dt="2020-11-27T06:06:20.892" v="37"/>
          <ac:graphicFrameMkLst>
            <pc:docMk/>
            <pc:sldMk cId="2985042206" sldId="264"/>
            <ac:graphicFrameMk id="9" creationId="{511AD0F2-34B3-42D1-BC91-C88A9B705C94}"/>
          </ac:graphicFrameMkLst>
        </pc:graphicFrameChg>
        <pc:graphicFrameChg chg="mod">
          <ac:chgData name="Derei Wu" userId="935b1b74ff2f2987" providerId="LiveId" clId="{5E7F6E5C-3D2D-4D61-9419-758C5E1DEF31}" dt="2020-11-27T06:07:36.614" v="52"/>
          <ac:graphicFrameMkLst>
            <pc:docMk/>
            <pc:sldMk cId="2985042206" sldId="264"/>
            <ac:graphicFrameMk id="12" creationId="{2AE4AA99-F720-445B-993D-D7AA003CE277}"/>
          </ac:graphicFrameMkLst>
        </pc:graphicFrameChg>
        <pc:graphicFrameChg chg="mod">
          <ac:chgData name="Derei Wu" userId="935b1b74ff2f2987" providerId="LiveId" clId="{5E7F6E5C-3D2D-4D61-9419-758C5E1DEF31}" dt="2020-11-27T06:07:27.393" v="49"/>
          <ac:graphicFrameMkLst>
            <pc:docMk/>
            <pc:sldMk cId="2985042206" sldId="264"/>
            <ac:graphicFrameMk id="22" creationId="{86DB521F-1E55-474B-A9F3-DD8E5CCC4DCD}"/>
          </ac:graphicFrameMkLst>
        </pc:graphicFrameChg>
        <pc:graphicFrameChg chg="mod">
          <ac:chgData name="Derei Wu" userId="935b1b74ff2f2987" providerId="LiveId" clId="{5E7F6E5C-3D2D-4D61-9419-758C5E1DEF31}" dt="2020-11-27T06:07:03.056" v="43"/>
          <ac:graphicFrameMkLst>
            <pc:docMk/>
            <pc:sldMk cId="2985042206" sldId="264"/>
            <ac:graphicFrameMk id="23" creationId="{A22C243A-1B0B-408F-9A0C-EF266D23E891}"/>
          </ac:graphicFrameMkLst>
        </pc:graphicFrameChg>
        <pc:graphicFrameChg chg="mod">
          <ac:chgData name="Derei Wu" userId="935b1b74ff2f2987" providerId="LiveId" clId="{5E7F6E5C-3D2D-4D61-9419-758C5E1DEF31}" dt="2020-11-27T06:07:18.304" v="46"/>
          <ac:graphicFrameMkLst>
            <pc:docMk/>
            <pc:sldMk cId="2985042206" sldId="264"/>
            <ac:graphicFrameMk id="24" creationId="{4B9A2F81-D86D-4DB4-8958-DBF96D583D76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A064BE-D90E-44AE-A691-9055ACE68065}" type="datetimeFigureOut">
              <a:rPr lang="zh-CN" altLang="en-US" smtClean="0"/>
              <a:t>2021/4/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F353F7-2CE0-4C36-A276-9571BD146A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15323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400" b="1" kern="1200" dirty="0">
                <a:solidFill>
                  <a:schemeClr val="tx1"/>
                </a:solidFill>
                <a:effectLst/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. Figure 2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FF353F7-2CE0-4C36-A276-9571BD146A99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428010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kern="1200" dirty="0">
                <a:solidFill>
                  <a:schemeClr val="tx1"/>
                </a:solidFill>
                <a:effectLst/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. Figure 3</a:t>
            </a:r>
            <a:endParaRPr lang="zh-CN" altLang="en-US" sz="12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FF353F7-2CE0-4C36-A276-9571BD146A99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781053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400" b="1" kern="1200" dirty="0">
                <a:solidFill>
                  <a:schemeClr val="tx1"/>
                </a:solidFill>
                <a:effectLst/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. Figure 2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FF353F7-2CE0-4C36-A276-9571BD146A99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19920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A9487-505F-48FE-9213-BCD153B75BFE}" type="datetimeFigureOut">
              <a:rPr lang="zh-CN" altLang="en-US" smtClean="0"/>
              <a:t>2021/4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650AD-34BC-40F7-85E3-F476CFC435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92668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A9487-505F-48FE-9213-BCD153B75BFE}" type="datetimeFigureOut">
              <a:rPr lang="zh-CN" altLang="en-US" smtClean="0"/>
              <a:t>2021/4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650AD-34BC-40F7-85E3-F476CFC435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76298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A9487-505F-48FE-9213-BCD153B75BFE}" type="datetimeFigureOut">
              <a:rPr lang="zh-CN" altLang="en-US" smtClean="0"/>
              <a:t>2021/4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650AD-34BC-40F7-85E3-F476CFC435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2665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A9487-505F-48FE-9213-BCD153B75BFE}" type="datetimeFigureOut">
              <a:rPr lang="zh-CN" altLang="en-US" smtClean="0"/>
              <a:t>2021/4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650AD-34BC-40F7-85E3-F476CFC435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24873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A9487-505F-48FE-9213-BCD153B75BFE}" type="datetimeFigureOut">
              <a:rPr lang="zh-CN" altLang="en-US" smtClean="0"/>
              <a:t>2021/4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650AD-34BC-40F7-85E3-F476CFC435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45581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A9487-505F-48FE-9213-BCD153B75BFE}" type="datetimeFigureOut">
              <a:rPr lang="zh-CN" altLang="en-US" smtClean="0"/>
              <a:t>2021/4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650AD-34BC-40F7-85E3-F476CFC435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88114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A9487-505F-48FE-9213-BCD153B75BFE}" type="datetimeFigureOut">
              <a:rPr lang="zh-CN" altLang="en-US" smtClean="0"/>
              <a:t>2021/4/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650AD-34BC-40F7-85E3-F476CFC435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98436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A9487-505F-48FE-9213-BCD153B75BFE}" type="datetimeFigureOut">
              <a:rPr lang="zh-CN" altLang="en-US" smtClean="0"/>
              <a:t>2021/4/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650AD-34BC-40F7-85E3-F476CFC435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41077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A9487-505F-48FE-9213-BCD153B75BFE}" type="datetimeFigureOut">
              <a:rPr lang="zh-CN" altLang="en-US" smtClean="0"/>
              <a:t>2021/4/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650AD-34BC-40F7-85E3-F476CFC435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19797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A9487-505F-48FE-9213-BCD153B75BFE}" type="datetimeFigureOut">
              <a:rPr lang="zh-CN" altLang="en-US" smtClean="0"/>
              <a:t>2021/4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650AD-34BC-40F7-85E3-F476CFC435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62754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A9487-505F-48FE-9213-BCD153B75BFE}" type="datetimeFigureOut">
              <a:rPr lang="zh-CN" altLang="en-US" smtClean="0"/>
              <a:t>2021/4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650AD-34BC-40F7-85E3-F476CFC435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90803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1A9487-505F-48FE-9213-BCD153B75BFE}" type="datetimeFigureOut">
              <a:rPr lang="zh-CN" altLang="en-US" smtClean="0"/>
              <a:t>2021/4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A650AD-34BC-40F7-85E3-F476CFC435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97678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26" Type="http://schemas.openxmlformats.org/officeDocument/2006/relationships/image" Target="../media/image24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5" Type="http://schemas.openxmlformats.org/officeDocument/2006/relationships/image" Target="../media/image23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2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emf"/><Relationship Id="rId13" Type="http://schemas.openxmlformats.org/officeDocument/2006/relationships/image" Target="../media/image31.png"/><Relationship Id="rId18" Type="http://schemas.openxmlformats.org/officeDocument/2006/relationships/image" Target="../media/image34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2.bin"/><Relationship Id="rId12" Type="http://schemas.openxmlformats.org/officeDocument/2006/relationships/image" Target="../media/image30.emf"/><Relationship Id="rId17" Type="http://schemas.openxmlformats.org/officeDocument/2006/relationships/oleObject" Target="../embeddings/oleObject6.bin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33.emf"/><Relationship Id="rId20" Type="http://schemas.openxmlformats.org/officeDocument/2006/relationships/image" Target="../media/image35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7.png"/><Relationship Id="rId11" Type="http://schemas.openxmlformats.org/officeDocument/2006/relationships/oleObject" Target="../embeddings/oleObject4.bin"/><Relationship Id="rId5" Type="http://schemas.openxmlformats.org/officeDocument/2006/relationships/image" Target="../media/image26.png"/><Relationship Id="rId15" Type="http://schemas.openxmlformats.org/officeDocument/2006/relationships/oleObject" Target="../embeddings/oleObject5.bin"/><Relationship Id="rId10" Type="http://schemas.openxmlformats.org/officeDocument/2006/relationships/image" Target="../media/image29.emf"/><Relationship Id="rId19" Type="http://schemas.openxmlformats.org/officeDocument/2006/relationships/oleObject" Target="../embeddings/oleObject7.bin"/><Relationship Id="rId4" Type="http://schemas.openxmlformats.org/officeDocument/2006/relationships/image" Target="../media/image25.emf"/><Relationship Id="rId9" Type="http://schemas.openxmlformats.org/officeDocument/2006/relationships/oleObject" Target="../embeddings/oleObject3.bin"/><Relationship Id="rId14" Type="http://schemas.openxmlformats.org/officeDocument/2006/relationships/image" Target="../media/image3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8.bin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7.emf"/><Relationship Id="rId5" Type="http://schemas.openxmlformats.org/officeDocument/2006/relationships/oleObject" Target="../embeddings/oleObject9.bin"/><Relationship Id="rId4" Type="http://schemas.openxmlformats.org/officeDocument/2006/relationships/image" Target="../media/image36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3.bin"/><Relationship Id="rId13" Type="http://schemas.openxmlformats.org/officeDocument/2006/relationships/image" Target="../media/image43.emf"/><Relationship Id="rId18" Type="http://schemas.openxmlformats.org/officeDocument/2006/relationships/oleObject" Target="../embeddings/oleObject18.bin"/><Relationship Id="rId26" Type="http://schemas.openxmlformats.org/officeDocument/2006/relationships/image" Target="../media/image50.png"/><Relationship Id="rId3" Type="http://schemas.openxmlformats.org/officeDocument/2006/relationships/image" Target="../media/image38.emf"/><Relationship Id="rId21" Type="http://schemas.openxmlformats.org/officeDocument/2006/relationships/image" Target="../media/image47.emf"/><Relationship Id="rId7" Type="http://schemas.openxmlformats.org/officeDocument/2006/relationships/image" Target="../media/image40.emf"/><Relationship Id="rId12" Type="http://schemas.openxmlformats.org/officeDocument/2006/relationships/oleObject" Target="../embeddings/oleObject15.bin"/><Relationship Id="rId17" Type="http://schemas.openxmlformats.org/officeDocument/2006/relationships/image" Target="../media/image45.emf"/><Relationship Id="rId25" Type="http://schemas.openxmlformats.org/officeDocument/2006/relationships/image" Target="../media/image49.emf"/><Relationship Id="rId2" Type="http://schemas.openxmlformats.org/officeDocument/2006/relationships/oleObject" Target="../embeddings/oleObject10.bin"/><Relationship Id="rId16" Type="http://schemas.openxmlformats.org/officeDocument/2006/relationships/oleObject" Target="../embeddings/oleObject17.bin"/><Relationship Id="rId20" Type="http://schemas.openxmlformats.org/officeDocument/2006/relationships/oleObject" Target="../embeddings/oleObject19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2.bin"/><Relationship Id="rId11" Type="http://schemas.openxmlformats.org/officeDocument/2006/relationships/image" Target="../media/image42.emf"/><Relationship Id="rId24" Type="http://schemas.openxmlformats.org/officeDocument/2006/relationships/oleObject" Target="../embeddings/oleObject21.bin"/><Relationship Id="rId5" Type="http://schemas.openxmlformats.org/officeDocument/2006/relationships/image" Target="../media/image39.emf"/><Relationship Id="rId15" Type="http://schemas.openxmlformats.org/officeDocument/2006/relationships/image" Target="../media/image44.emf"/><Relationship Id="rId23" Type="http://schemas.openxmlformats.org/officeDocument/2006/relationships/image" Target="../media/image48.emf"/><Relationship Id="rId10" Type="http://schemas.openxmlformats.org/officeDocument/2006/relationships/oleObject" Target="../embeddings/oleObject14.bin"/><Relationship Id="rId19" Type="http://schemas.openxmlformats.org/officeDocument/2006/relationships/image" Target="../media/image46.emf"/><Relationship Id="rId4" Type="http://schemas.openxmlformats.org/officeDocument/2006/relationships/oleObject" Target="../embeddings/oleObject11.bin"/><Relationship Id="rId9" Type="http://schemas.openxmlformats.org/officeDocument/2006/relationships/image" Target="../media/image41.emf"/><Relationship Id="rId14" Type="http://schemas.openxmlformats.org/officeDocument/2006/relationships/oleObject" Target="../embeddings/oleObject16.bin"/><Relationship Id="rId22" Type="http://schemas.openxmlformats.org/officeDocument/2006/relationships/oleObject" Target="../embeddings/oleObject20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4.bin"/><Relationship Id="rId13" Type="http://schemas.openxmlformats.org/officeDocument/2006/relationships/image" Target="../media/image57.emf"/><Relationship Id="rId3" Type="http://schemas.openxmlformats.org/officeDocument/2006/relationships/image" Target="../media/image52.png"/><Relationship Id="rId7" Type="http://schemas.openxmlformats.org/officeDocument/2006/relationships/image" Target="../media/image54.emf"/><Relationship Id="rId12" Type="http://schemas.openxmlformats.org/officeDocument/2006/relationships/oleObject" Target="../embeddings/oleObject26.bin"/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23.bin"/><Relationship Id="rId11" Type="http://schemas.openxmlformats.org/officeDocument/2006/relationships/image" Target="../media/image56.emf"/><Relationship Id="rId5" Type="http://schemas.openxmlformats.org/officeDocument/2006/relationships/image" Target="../media/image53.emf"/><Relationship Id="rId15" Type="http://schemas.openxmlformats.org/officeDocument/2006/relationships/image" Target="../media/image58.emf"/><Relationship Id="rId10" Type="http://schemas.openxmlformats.org/officeDocument/2006/relationships/oleObject" Target="../embeddings/oleObject25.bin"/><Relationship Id="rId4" Type="http://schemas.openxmlformats.org/officeDocument/2006/relationships/oleObject" Target="../embeddings/oleObject22.bin"/><Relationship Id="rId9" Type="http://schemas.openxmlformats.org/officeDocument/2006/relationships/image" Target="../media/image55.emf"/><Relationship Id="rId14" Type="http://schemas.openxmlformats.org/officeDocument/2006/relationships/oleObject" Target="../embeddings/oleObject27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2F784D4-BB17-4505-8C8C-5053215D4A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7" y="3248380"/>
            <a:ext cx="5915025" cy="1320445"/>
          </a:xfrm>
        </p:spPr>
        <p:txBody>
          <a:bodyPr/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upplementary Materials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298913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DA89DD4-2B01-4ACB-9D80-C5BB10CEBDF0}"/>
              </a:ext>
            </a:extLst>
          </p:cNvPr>
          <p:cNvSpPr txBox="1"/>
          <p:nvPr/>
        </p:nvSpPr>
        <p:spPr>
          <a:xfrm>
            <a:off x="1363454" y="85113"/>
            <a:ext cx="453358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zh-CN" altLang="en-US" sz="2400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045BE53F-C4BE-4378-9F4B-67019B966F27}"/>
              </a:ext>
            </a:extLst>
          </p:cNvPr>
          <p:cNvSpPr txBox="1"/>
          <p:nvPr/>
        </p:nvSpPr>
        <p:spPr>
          <a:xfrm rot="10800000">
            <a:off x="438660" y="1314556"/>
            <a:ext cx="353943" cy="47545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100" b="1" dirty="0">
                <a:latin typeface="Calibri (正文)"/>
              </a:rPr>
              <a:t>SSC-A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B311CAA3-4ACC-4568-BF6B-8E4413B250E0}"/>
              </a:ext>
            </a:extLst>
          </p:cNvPr>
          <p:cNvSpPr txBox="1"/>
          <p:nvPr/>
        </p:nvSpPr>
        <p:spPr>
          <a:xfrm>
            <a:off x="1014290" y="2106049"/>
            <a:ext cx="5373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Calibri (正文)"/>
              </a:rPr>
              <a:t>FSC-A</a:t>
            </a:r>
            <a:endParaRPr lang="zh-CN" altLang="en-US" sz="1400" b="1" dirty="0">
              <a:latin typeface="Calibri (正文)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161D8A25-02D0-4EB3-A45D-F609720FDDCE}"/>
              </a:ext>
            </a:extLst>
          </p:cNvPr>
          <p:cNvSpPr txBox="1"/>
          <p:nvPr/>
        </p:nvSpPr>
        <p:spPr>
          <a:xfrm rot="10800000" flipH="1">
            <a:off x="1828964" y="1124414"/>
            <a:ext cx="353943" cy="673429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100" b="1" dirty="0">
                <a:latin typeface="Calibri (正文)"/>
              </a:rPr>
              <a:t>SSC-A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FD4E9D47-5423-471D-BFE6-D266D029E6F0}"/>
              </a:ext>
            </a:extLst>
          </p:cNvPr>
          <p:cNvSpPr txBox="1"/>
          <p:nvPr/>
        </p:nvSpPr>
        <p:spPr>
          <a:xfrm>
            <a:off x="2310137" y="2076691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Calibri (正文)"/>
              </a:rPr>
              <a:t>CD3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9D9560D8-0598-4B47-A577-78A947CCF5BA}"/>
              </a:ext>
            </a:extLst>
          </p:cNvPr>
          <p:cNvSpPr txBox="1"/>
          <p:nvPr/>
        </p:nvSpPr>
        <p:spPr>
          <a:xfrm rot="16200000">
            <a:off x="3035412" y="1335147"/>
            <a:ext cx="5392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Calibri (正文)"/>
                <a:sym typeface="Symbol" panose="05050102010706020507" pitchFamily="18" charset="2"/>
              </a:rPr>
              <a:t> </a:t>
            </a:r>
            <a:r>
              <a:rPr lang="el-GR" altLang="zh-CN" sz="1100" b="1" dirty="0">
                <a:latin typeface="Calibri (正文)"/>
                <a:sym typeface="Symbol" panose="05050102010706020507" pitchFamily="18" charset="2"/>
              </a:rPr>
              <a:t>δ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B3DBD64B-292B-4749-A763-21A93A23DCF6}"/>
              </a:ext>
            </a:extLst>
          </p:cNvPr>
          <p:cNvSpPr txBox="1"/>
          <p:nvPr/>
        </p:nvSpPr>
        <p:spPr>
          <a:xfrm>
            <a:off x="3701830" y="2113724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Calibri (正文)"/>
              </a:rPr>
              <a:t>CD3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3E99C5AF-791D-40B2-8368-70025E106B08}"/>
              </a:ext>
            </a:extLst>
          </p:cNvPr>
          <p:cNvSpPr/>
          <p:nvPr/>
        </p:nvSpPr>
        <p:spPr>
          <a:xfrm>
            <a:off x="256717" y="653281"/>
            <a:ext cx="81137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>
                <a:latin typeface="Calibri (正文)"/>
              </a:rPr>
              <a:t>Healthy:</a:t>
            </a:r>
            <a:endParaRPr lang="zh-CN" altLang="en-US" sz="1400" b="1" dirty="0">
              <a:latin typeface="Calibri (正文)"/>
            </a:endParaRPr>
          </a:p>
        </p:txBody>
      </p:sp>
      <p:pic>
        <p:nvPicPr>
          <p:cNvPr id="28" name="图片 27">
            <a:extLst>
              <a:ext uri="{FF2B5EF4-FFF2-40B4-BE49-F238E27FC236}">
                <a16:creationId xmlns:a16="http://schemas.microsoft.com/office/drawing/2014/main" id="{68701139-93EB-419B-82A6-A18A7A99844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09626" y="2441984"/>
            <a:ext cx="1082062" cy="1080000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22C1FF2C-F1B7-49C7-B0C2-4733F7818707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6121" y="2421263"/>
            <a:ext cx="1088261" cy="1080000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E433B968-0EE9-4CD2-B75C-3ABFB898BFD0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2975" y="2409223"/>
            <a:ext cx="1084122" cy="1080000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44FA4B2C-F0ED-4A29-9864-6EDB88C3BA1D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5932" y="2411213"/>
            <a:ext cx="1080000" cy="1080000"/>
          </a:xfrm>
          <a:prstGeom prst="rect">
            <a:avLst/>
          </a:prstGeom>
        </p:spPr>
      </p:pic>
      <p:sp>
        <p:nvSpPr>
          <p:cNvPr id="34" name="文本框 33">
            <a:extLst>
              <a:ext uri="{FF2B5EF4-FFF2-40B4-BE49-F238E27FC236}">
                <a16:creationId xmlns:a16="http://schemas.microsoft.com/office/drawing/2014/main" id="{780DCABB-01AB-4A45-BE5E-ED7F20EEA10A}"/>
              </a:ext>
            </a:extLst>
          </p:cNvPr>
          <p:cNvSpPr txBox="1"/>
          <p:nvPr/>
        </p:nvSpPr>
        <p:spPr>
          <a:xfrm>
            <a:off x="1377983" y="2434789"/>
            <a:ext cx="8515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Vδ2+NKG2D+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99.7%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750F5316-BF07-4EDF-8DC7-8BA711EE9B9D}"/>
              </a:ext>
            </a:extLst>
          </p:cNvPr>
          <p:cNvSpPr txBox="1"/>
          <p:nvPr/>
        </p:nvSpPr>
        <p:spPr>
          <a:xfrm rot="16200000">
            <a:off x="576977" y="2770704"/>
            <a:ext cx="5392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Calibri (正文)"/>
              </a:rPr>
              <a:t>V</a:t>
            </a:r>
            <a:r>
              <a:rPr lang="el-GR" altLang="zh-CN" sz="1100" b="1" dirty="0">
                <a:latin typeface="Calibri (正文)"/>
                <a:sym typeface="Symbol" panose="05050102010706020507" pitchFamily="18" charset="2"/>
              </a:rPr>
              <a:t>δ</a:t>
            </a:r>
            <a:r>
              <a:rPr lang="en-US" altLang="zh-CN" sz="1100" b="1" dirty="0">
                <a:latin typeface="Calibri (正文)"/>
              </a:rPr>
              <a:t>2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913B9385-F1A2-4878-A228-A7BEF0E21917}"/>
              </a:ext>
            </a:extLst>
          </p:cNvPr>
          <p:cNvSpPr txBox="1"/>
          <p:nvPr/>
        </p:nvSpPr>
        <p:spPr>
          <a:xfrm>
            <a:off x="1220386" y="3468156"/>
            <a:ext cx="6694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Calibri (正文)"/>
              </a:rPr>
              <a:t>NKG2D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D1ED2D15-9BF1-40BC-9677-2F583C4343F5}"/>
              </a:ext>
            </a:extLst>
          </p:cNvPr>
          <p:cNvSpPr txBox="1"/>
          <p:nvPr/>
        </p:nvSpPr>
        <p:spPr>
          <a:xfrm>
            <a:off x="2517060" y="3476050"/>
            <a:ext cx="6541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Calibri (正文)"/>
              </a:rPr>
              <a:t>NKP30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5C0DF90A-5951-4D61-8143-9C14293DDFDD}"/>
              </a:ext>
            </a:extLst>
          </p:cNvPr>
          <p:cNvSpPr txBox="1"/>
          <p:nvPr/>
        </p:nvSpPr>
        <p:spPr>
          <a:xfrm>
            <a:off x="2557933" y="2443466"/>
            <a:ext cx="8242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Vδ2+NKP30+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0.9%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DD6EF3B3-1924-44D5-9DAF-0C46C39EFFFD}"/>
              </a:ext>
            </a:extLst>
          </p:cNvPr>
          <p:cNvSpPr txBox="1"/>
          <p:nvPr/>
        </p:nvSpPr>
        <p:spPr>
          <a:xfrm>
            <a:off x="3685903" y="3483145"/>
            <a:ext cx="5986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Calibri (正文)"/>
              </a:rPr>
              <a:t>NKP46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03E91209-2E0B-486A-ACA3-DAB705949869}"/>
              </a:ext>
            </a:extLst>
          </p:cNvPr>
          <p:cNvSpPr txBox="1"/>
          <p:nvPr/>
        </p:nvSpPr>
        <p:spPr>
          <a:xfrm>
            <a:off x="3786588" y="2443515"/>
            <a:ext cx="8242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Vδ2+NKP46+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.4%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9DBDE58D-1329-4EBF-8C40-94010EBF2CBC}"/>
              </a:ext>
            </a:extLst>
          </p:cNvPr>
          <p:cNvSpPr txBox="1"/>
          <p:nvPr/>
        </p:nvSpPr>
        <p:spPr>
          <a:xfrm>
            <a:off x="4984363" y="3505613"/>
            <a:ext cx="4667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Calibri (正文)"/>
              </a:rPr>
              <a:t>PD-1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A9209B37-01E4-4112-B919-60787C1C693D}"/>
              </a:ext>
            </a:extLst>
          </p:cNvPr>
          <p:cNvSpPr txBox="1"/>
          <p:nvPr/>
        </p:nvSpPr>
        <p:spPr>
          <a:xfrm>
            <a:off x="5064568" y="2448468"/>
            <a:ext cx="7264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Vδ2+PD-1+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.7%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403219E2-7FC8-40CE-A636-E00D7FF5BF06}"/>
              </a:ext>
            </a:extLst>
          </p:cNvPr>
          <p:cNvSpPr txBox="1"/>
          <p:nvPr/>
        </p:nvSpPr>
        <p:spPr>
          <a:xfrm>
            <a:off x="604137" y="2318681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Calibri (正文)"/>
              </a:rPr>
              <a:t>(B)</a:t>
            </a:r>
            <a:endParaRPr lang="zh-CN" altLang="en-US" sz="1400" b="1" dirty="0">
              <a:latin typeface="Calibri (正文)"/>
            </a:endParaRPr>
          </a:p>
        </p:txBody>
      </p:sp>
      <p:pic>
        <p:nvPicPr>
          <p:cNvPr id="53" name="图片 52">
            <a:extLst>
              <a:ext uri="{FF2B5EF4-FFF2-40B4-BE49-F238E27FC236}">
                <a16:creationId xmlns:a16="http://schemas.microsoft.com/office/drawing/2014/main" id="{A33B49C5-0659-4A54-A2C1-38B4D9ACE97A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6980" y="3796278"/>
            <a:ext cx="1084130" cy="1080000"/>
          </a:xfrm>
          <a:prstGeom prst="rect">
            <a:avLst/>
          </a:prstGeom>
        </p:spPr>
      </p:pic>
      <p:pic>
        <p:nvPicPr>
          <p:cNvPr id="54" name="图片 53">
            <a:extLst>
              <a:ext uri="{FF2B5EF4-FFF2-40B4-BE49-F238E27FC236}">
                <a16:creationId xmlns:a16="http://schemas.microsoft.com/office/drawing/2014/main" id="{5693DEE2-F9ED-4989-83C0-9ACF329D15A2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2799" y="3805093"/>
            <a:ext cx="1086195" cy="1080000"/>
          </a:xfrm>
          <a:prstGeom prst="rect">
            <a:avLst/>
          </a:prstGeom>
        </p:spPr>
      </p:pic>
      <p:pic>
        <p:nvPicPr>
          <p:cNvPr id="55" name="图片 54">
            <a:extLst>
              <a:ext uri="{FF2B5EF4-FFF2-40B4-BE49-F238E27FC236}">
                <a16:creationId xmlns:a16="http://schemas.microsoft.com/office/drawing/2014/main" id="{D76E0DF2-24BF-46BF-B765-E9E6AFC8E25F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0023" y="3806226"/>
            <a:ext cx="1073852" cy="1080000"/>
          </a:xfrm>
          <a:prstGeom prst="rect">
            <a:avLst/>
          </a:prstGeom>
        </p:spPr>
      </p:pic>
      <p:pic>
        <p:nvPicPr>
          <p:cNvPr id="56" name="图片 55">
            <a:extLst>
              <a:ext uri="{FF2B5EF4-FFF2-40B4-BE49-F238E27FC236}">
                <a16:creationId xmlns:a16="http://schemas.microsoft.com/office/drawing/2014/main" id="{54B7DB4A-9A40-4E8B-B362-5D0C6A6A8A4C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7820" y="3792856"/>
            <a:ext cx="1084114" cy="1080000"/>
          </a:xfrm>
          <a:prstGeom prst="rect">
            <a:avLst/>
          </a:prstGeom>
        </p:spPr>
      </p:pic>
      <p:sp>
        <p:nvSpPr>
          <p:cNvPr id="59" name="文本框 58">
            <a:extLst>
              <a:ext uri="{FF2B5EF4-FFF2-40B4-BE49-F238E27FC236}">
                <a16:creationId xmlns:a16="http://schemas.microsoft.com/office/drawing/2014/main" id="{B2B4B575-173C-4C1A-A07E-60DFDB14BF6C}"/>
              </a:ext>
            </a:extLst>
          </p:cNvPr>
          <p:cNvSpPr txBox="1"/>
          <p:nvPr/>
        </p:nvSpPr>
        <p:spPr>
          <a:xfrm rot="16200000">
            <a:off x="632274" y="4196474"/>
            <a:ext cx="5392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Calibri (正文)"/>
              </a:rPr>
              <a:t>V</a:t>
            </a:r>
            <a:r>
              <a:rPr lang="el-GR" altLang="zh-CN" sz="1100" b="1" dirty="0">
                <a:latin typeface="Calibri (正文)"/>
                <a:sym typeface="Symbol" panose="05050102010706020507" pitchFamily="18" charset="2"/>
              </a:rPr>
              <a:t>δ</a:t>
            </a:r>
            <a:r>
              <a:rPr lang="en-US" altLang="zh-CN" sz="1100" b="1" dirty="0">
                <a:latin typeface="Calibri (正文)"/>
              </a:rPr>
              <a:t>1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9F7E56F7-C59C-484E-A3FD-7005E50E1A84}"/>
              </a:ext>
            </a:extLst>
          </p:cNvPr>
          <p:cNvSpPr txBox="1"/>
          <p:nvPr/>
        </p:nvSpPr>
        <p:spPr>
          <a:xfrm>
            <a:off x="1269128" y="4901942"/>
            <a:ext cx="5373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Calibri (正文)"/>
              </a:rPr>
              <a:t>NKG2D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03FF4DCC-A647-446C-87CC-4CFF9F0E746F}"/>
              </a:ext>
            </a:extLst>
          </p:cNvPr>
          <p:cNvSpPr txBox="1"/>
          <p:nvPr/>
        </p:nvSpPr>
        <p:spPr>
          <a:xfrm>
            <a:off x="2491415" y="4895143"/>
            <a:ext cx="5373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Calibri (正文)"/>
              </a:rPr>
              <a:t>NKP30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FD435261-161A-4450-8393-EC6D8EADD594}"/>
              </a:ext>
            </a:extLst>
          </p:cNvPr>
          <p:cNvSpPr txBox="1"/>
          <p:nvPr/>
        </p:nvSpPr>
        <p:spPr>
          <a:xfrm>
            <a:off x="3753036" y="4901942"/>
            <a:ext cx="5373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Calibri (正文)"/>
              </a:rPr>
              <a:t>NKP46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1FF8C43C-8D6A-425E-85E7-36FBE130B1B5}"/>
              </a:ext>
            </a:extLst>
          </p:cNvPr>
          <p:cNvSpPr txBox="1"/>
          <p:nvPr/>
        </p:nvSpPr>
        <p:spPr>
          <a:xfrm>
            <a:off x="4947223" y="4903332"/>
            <a:ext cx="4667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Calibri (正文)"/>
              </a:rPr>
              <a:t>PD-1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51045177-6F58-4014-917A-19313D0B3090}"/>
              </a:ext>
            </a:extLst>
          </p:cNvPr>
          <p:cNvSpPr txBox="1"/>
          <p:nvPr/>
        </p:nvSpPr>
        <p:spPr>
          <a:xfrm>
            <a:off x="1372942" y="3826283"/>
            <a:ext cx="8515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Vδ1+NKG2D+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96.6%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AECBD202-55CB-478C-BDE2-9F3B8F650E86}"/>
              </a:ext>
            </a:extLst>
          </p:cNvPr>
          <p:cNvSpPr txBox="1"/>
          <p:nvPr/>
        </p:nvSpPr>
        <p:spPr>
          <a:xfrm>
            <a:off x="2576601" y="3836876"/>
            <a:ext cx="8242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Vδ1+NKP30+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0.9%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B759B65C-CB31-4ADC-A7CF-A2106E29023B}"/>
              </a:ext>
            </a:extLst>
          </p:cNvPr>
          <p:cNvSpPr txBox="1"/>
          <p:nvPr/>
        </p:nvSpPr>
        <p:spPr>
          <a:xfrm>
            <a:off x="3760872" y="3845784"/>
            <a:ext cx="8242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Vδ1+NKP46+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.7%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10E4BFBD-5400-4886-871D-2ED7126E7155}"/>
              </a:ext>
            </a:extLst>
          </p:cNvPr>
          <p:cNvSpPr txBox="1"/>
          <p:nvPr/>
        </p:nvSpPr>
        <p:spPr>
          <a:xfrm>
            <a:off x="5061797" y="3835657"/>
            <a:ext cx="7264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Vδ1+PD-1+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7.2%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9A401BE7-9F3B-4E69-A376-F039290EF909}"/>
              </a:ext>
            </a:extLst>
          </p:cNvPr>
          <p:cNvSpPr txBox="1"/>
          <p:nvPr/>
        </p:nvSpPr>
        <p:spPr>
          <a:xfrm>
            <a:off x="605338" y="3672263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Calibri (正文)"/>
              </a:rPr>
              <a:t>(C)</a:t>
            </a:r>
            <a:endParaRPr lang="zh-CN" altLang="en-US" sz="1400" b="1" dirty="0">
              <a:latin typeface="Calibri (正文)"/>
            </a:endParaRPr>
          </a:p>
        </p:txBody>
      </p:sp>
      <p:pic>
        <p:nvPicPr>
          <p:cNvPr id="78" name="图片 77">
            <a:extLst>
              <a:ext uri="{FF2B5EF4-FFF2-40B4-BE49-F238E27FC236}">
                <a16:creationId xmlns:a16="http://schemas.microsoft.com/office/drawing/2014/main" id="{33720D61-B989-4146-8B3B-7BE5E77A84C9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096395" y="981280"/>
            <a:ext cx="1126173" cy="1080000"/>
          </a:xfrm>
          <a:prstGeom prst="rect">
            <a:avLst/>
          </a:prstGeom>
        </p:spPr>
      </p:pic>
      <p:sp>
        <p:nvSpPr>
          <p:cNvPr id="79" name="文本框 78">
            <a:extLst>
              <a:ext uri="{FF2B5EF4-FFF2-40B4-BE49-F238E27FC236}">
                <a16:creationId xmlns:a16="http://schemas.microsoft.com/office/drawing/2014/main" id="{323E7C38-888F-4F1C-B7BB-F6094EDCA8DE}"/>
              </a:ext>
            </a:extLst>
          </p:cNvPr>
          <p:cNvSpPr txBox="1"/>
          <p:nvPr/>
        </p:nvSpPr>
        <p:spPr>
          <a:xfrm>
            <a:off x="2726168" y="1017492"/>
            <a:ext cx="4780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D3+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82.9%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0" name="图片 79">
            <a:extLst>
              <a:ext uri="{FF2B5EF4-FFF2-40B4-BE49-F238E27FC236}">
                <a16:creationId xmlns:a16="http://schemas.microsoft.com/office/drawing/2014/main" id="{5DFFB2EC-5D34-4B72-8143-F4258600C2DA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05067" y="994917"/>
            <a:ext cx="1164535" cy="1080000"/>
          </a:xfrm>
          <a:prstGeom prst="rect">
            <a:avLst/>
          </a:prstGeom>
        </p:spPr>
      </p:pic>
      <p:pic>
        <p:nvPicPr>
          <p:cNvPr id="84" name="图片 83">
            <a:extLst>
              <a:ext uri="{FF2B5EF4-FFF2-40B4-BE49-F238E27FC236}">
                <a16:creationId xmlns:a16="http://schemas.microsoft.com/office/drawing/2014/main" id="{622F28BA-43FB-42A7-A46A-99F0CCBE9B4B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407319" y="981544"/>
            <a:ext cx="1125047" cy="1080000"/>
          </a:xfrm>
          <a:prstGeom prst="rect">
            <a:avLst/>
          </a:prstGeom>
        </p:spPr>
      </p:pic>
      <p:sp>
        <p:nvSpPr>
          <p:cNvPr id="85" name="文本框 84">
            <a:extLst>
              <a:ext uri="{FF2B5EF4-FFF2-40B4-BE49-F238E27FC236}">
                <a16:creationId xmlns:a16="http://schemas.microsoft.com/office/drawing/2014/main" id="{3FE5A902-52FA-4B00-95A2-E68CBF4830FB}"/>
              </a:ext>
            </a:extLst>
          </p:cNvPr>
          <p:cNvSpPr txBox="1"/>
          <p:nvPr/>
        </p:nvSpPr>
        <p:spPr>
          <a:xfrm>
            <a:off x="3960842" y="982065"/>
            <a:ext cx="7467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CD3+γδ+</a:t>
            </a:r>
          </a:p>
          <a:p>
            <a:r>
              <a:rPr lang="en-US" altLang="zh-CN" sz="8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8.4%</a:t>
            </a:r>
            <a:endParaRPr lang="zh-CN" altLang="en-US" sz="8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  <p:pic>
        <p:nvPicPr>
          <p:cNvPr id="161" name="图片 160">
            <a:extLst>
              <a:ext uri="{FF2B5EF4-FFF2-40B4-BE49-F238E27FC236}">
                <a16:creationId xmlns:a16="http://schemas.microsoft.com/office/drawing/2014/main" id="{DE64C329-1FF3-4D97-9252-1485C7D43B8C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5718" y="8279708"/>
            <a:ext cx="1082057" cy="1080000"/>
          </a:xfrm>
          <a:prstGeom prst="rect">
            <a:avLst/>
          </a:prstGeom>
        </p:spPr>
      </p:pic>
      <p:pic>
        <p:nvPicPr>
          <p:cNvPr id="162" name="图片 161">
            <a:extLst>
              <a:ext uri="{FF2B5EF4-FFF2-40B4-BE49-F238E27FC236}">
                <a16:creationId xmlns:a16="http://schemas.microsoft.com/office/drawing/2014/main" id="{E1489A57-8DF3-4262-B330-BB861F5CADA4}"/>
              </a:ext>
            </a:extLst>
          </p:cNvPr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2210" y="8269902"/>
            <a:ext cx="1082057" cy="1080000"/>
          </a:xfrm>
          <a:prstGeom prst="rect">
            <a:avLst/>
          </a:prstGeom>
        </p:spPr>
      </p:pic>
      <p:pic>
        <p:nvPicPr>
          <p:cNvPr id="163" name="图片 162">
            <a:extLst>
              <a:ext uri="{FF2B5EF4-FFF2-40B4-BE49-F238E27FC236}">
                <a16:creationId xmlns:a16="http://schemas.microsoft.com/office/drawing/2014/main" id="{8A7A7CD7-4753-45C1-8BE8-603716C4A402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9991" y="8269902"/>
            <a:ext cx="1082054" cy="1080000"/>
          </a:xfrm>
          <a:prstGeom prst="rect">
            <a:avLst/>
          </a:prstGeom>
        </p:spPr>
      </p:pic>
      <p:pic>
        <p:nvPicPr>
          <p:cNvPr id="164" name="图片 163">
            <a:extLst>
              <a:ext uri="{FF2B5EF4-FFF2-40B4-BE49-F238E27FC236}">
                <a16:creationId xmlns:a16="http://schemas.microsoft.com/office/drawing/2014/main" id="{C6A3484F-BA67-4B86-843F-A31441654B9A}"/>
              </a:ext>
            </a:extLst>
          </p:cNvPr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9381" y="8259766"/>
            <a:ext cx="1094456" cy="1080000"/>
          </a:xfrm>
          <a:prstGeom prst="rect">
            <a:avLst/>
          </a:prstGeom>
        </p:spPr>
      </p:pic>
      <p:pic>
        <p:nvPicPr>
          <p:cNvPr id="165" name="图片 164">
            <a:extLst>
              <a:ext uri="{FF2B5EF4-FFF2-40B4-BE49-F238E27FC236}">
                <a16:creationId xmlns:a16="http://schemas.microsoft.com/office/drawing/2014/main" id="{A0D78E65-44F3-4841-8935-21F9657A9F40}"/>
              </a:ext>
            </a:extLst>
          </p:cNvPr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63638" y="7000725"/>
            <a:ext cx="1073863" cy="1080000"/>
          </a:xfrm>
          <a:prstGeom prst="rect">
            <a:avLst/>
          </a:prstGeom>
        </p:spPr>
      </p:pic>
      <p:pic>
        <p:nvPicPr>
          <p:cNvPr id="166" name="图片 165">
            <a:extLst>
              <a:ext uri="{FF2B5EF4-FFF2-40B4-BE49-F238E27FC236}">
                <a16:creationId xmlns:a16="http://schemas.microsoft.com/office/drawing/2014/main" id="{0EF127C0-8C22-4FB2-82D0-00C1987AD9C4}"/>
              </a:ext>
            </a:extLst>
          </p:cNvPr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5883" y="6991230"/>
            <a:ext cx="1084114" cy="1080000"/>
          </a:xfrm>
          <a:prstGeom prst="rect">
            <a:avLst/>
          </a:prstGeom>
        </p:spPr>
      </p:pic>
      <p:pic>
        <p:nvPicPr>
          <p:cNvPr id="167" name="图片 166">
            <a:extLst>
              <a:ext uri="{FF2B5EF4-FFF2-40B4-BE49-F238E27FC236}">
                <a16:creationId xmlns:a16="http://schemas.microsoft.com/office/drawing/2014/main" id="{C8A1BCA2-733C-4172-9BC2-73373088413E}"/>
              </a:ext>
            </a:extLst>
          </p:cNvPr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6059" y="6962625"/>
            <a:ext cx="1086183" cy="1080000"/>
          </a:xfrm>
          <a:prstGeom prst="rect">
            <a:avLst/>
          </a:prstGeom>
        </p:spPr>
      </p:pic>
      <p:pic>
        <p:nvPicPr>
          <p:cNvPr id="168" name="图片 167">
            <a:extLst>
              <a:ext uri="{FF2B5EF4-FFF2-40B4-BE49-F238E27FC236}">
                <a16:creationId xmlns:a16="http://schemas.microsoft.com/office/drawing/2014/main" id="{749F9DD0-BB49-4342-B568-C34E15A49ABC}"/>
              </a:ext>
            </a:extLst>
          </p:cNvPr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8008" y="6958245"/>
            <a:ext cx="1090344" cy="1080000"/>
          </a:xfrm>
          <a:prstGeom prst="rect">
            <a:avLst/>
          </a:prstGeom>
        </p:spPr>
      </p:pic>
      <p:sp>
        <p:nvSpPr>
          <p:cNvPr id="169" name="文本框 168">
            <a:extLst>
              <a:ext uri="{FF2B5EF4-FFF2-40B4-BE49-F238E27FC236}">
                <a16:creationId xmlns:a16="http://schemas.microsoft.com/office/drawing/2014/main" id="{1C87507F-7A60-4644-ACF3-1D6A8D3D8539}"/>
              </a:ext>
            </a:extLst>
          </p:cNvPr>
          <p:cNvSpPr txBox="1"/>
          <p:nvPr/>
        </p:nvSpPr>
        <p:spPr>
          <a:xfrm rot="10800000">
            <a:off x="549614" y="5936010"/>
            <a:ext cx="353943" cy="47545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100" b="1" dirty="0">
                <a:latin typeface="Calibri (正文)"/>
              </a:rPr>
              <a:t>SSC-A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170" name="文本框 169">
            <a:extLst>
              <a:ext uri="{FF2B5EF4-FFF2-40B4-BE49-F238E27FC236}">
                <a16:creationId xmlns:a16="http://schemas.microsoft.com/office/drawing/2014/main" id="{EEEEEFC8-5C61-4A40-8B3D-89475019E2E5}"/>
              </a:ext>
            </a:extLst>
          </p:cNvPr>
          <p:cNvSpPr txBox="1"/>
          <p:nvPr/>
        </p:nvSpPr>
        <p:spPr>
          <a:xfrm>
            <a:off x="1068093" y="6671030"/>
            <a:ext cx="5373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Calibri (正文)"/>
              </a:rPr>
              <a:t>FSC-A</a:t>
            </a:r>
            <a:endParaRPr lang="zh-CN" altLang="en-US" sz="1400" b="1" dirty="0">
              <a:latin typeface="Calibri (正文)"/>
            </a:endParaRPr>
          </a:p>
        </p:txBody>
      </p:sp>
      <p:sp>
        <p:nvSpPr>
          <p:cNvPr id="174" name="文本框 173">
            <a:extLst>
              <a:ext uri="{FF2B5EF4-FFF2-40B4-BE49-F238E27FC236}">
                <a16:creationId xmlns:a16="http://schemas.microsoft.com/office/drawing/2014/main" id="{FE6AA35F-3138-48D7-B9EC-E623470EB555}"/>
              </a:ext>
            </a:extLst>
          </p:cNvPr>
          <p:cNvSpPr txBox="1"/>
          <p:nvPr/>
        </p:nvSpPr>
        <p:spPr>
          <a:xfrm rot="10800000" flipH="1">
            <a:off x="1831464" y="5734136"/>
            <a:ext cx="353943" cy="673429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100" b="1" dirty="0">
                <a:latin typeface="Calibri (正文)"/>
              </a:rPr>
              <a:t>SSC-A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175" name="文本框 174">
            <a:extLst>
              <a:ext uri="{FF2B5EF4-FFF2-40B4-BE49-F238E27FC236}">
                <a16:creationId xmlns:a16="http://schemas.microsoft.com/office/drawing/2014/main" id="{A64B0213-DD16-4A5D-9C2E-D13F9C955F47}"/>
              </a:ext>
            </a:extLst>
          </p:cNvPr>
          <p:cNvSpPr txBox="1"/>
          <p:nvPr/>
        </p:nvSpPr>
        <p:spPr>
          <a:xfrm>
            <a:off x="2507457" y="6708835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Calibri (正文)"/>
              </a:rPr>
              <a:t>CD3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178" name="文本框 177">
            <a:extLst>
              <a:ext uri="{FF2B5EF4-FFF2-40B4-BE49-F238E27FC236}">
                <a16:creationId xmlns:a16="http://schemas.microsoft.com/office/drawing/2014/main" id="{65DC23DA-6CE7-49C8-90B0-199859589FD3}"/>
              </a:ext>
            </a:extLst>
          </p:cNvPr>
          <p:cNvSpPr txBox="1"/>
          <p:nvPr/>
        </p:nvSpPr>
        <p:spPr>
          <a:xfrm rot="16200000">
            <a:off x="3017903" y="5940675"/>
            <a:ext cx="5392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Calibri (正文)"/>
                <a:sym typeface="Symbol" panose="05050102010706020507" pitchFamily="18" charset="2"/>
              </a:rPr>
              <a:t> </a:t>
            </a:r>
            <a:r>
              <a:rPr lang="el-GR" altLang="zh-CN" sz="1100" b="1" dirty="0">
                <a:latin typeface="Calibri (正文)"/>
                <a:sym typeface="Symbol" panose="05050102010706020507" pitchFamily="18" charset="2"/>
              </a:rPr>
              <a:t>δ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181" name="文本框 180">
            <a:extLst>
              <a:ext uri="{FF2B5EF4-FFF2-40B4-BE49-F238E27FC236}">
                <a16:creationId xmlns:a16="http://schemas.microsoft.com/office/drawing/2014/main" id="{BA56DA78-D606-43E5-BEA4-C05BA98F3356}"/>
              </a:ext>
            </a:extLst>
          </p:cNvPr>
          <p:cNvSpPr txBox="1"/>
          <p:nvPr/>
        </p:nvSpPr>
        <p:spPr>
          <a:xfrm rot="16200000">
            <a:off x="4262262" y="5988071"/>
            <a:ext cx="9382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Calibri (正文)"/>
                <a:sym typeface="Symbol" panose="05050102010706020507" pitchFamily="18" charset="2"/>
              </a:rPr>
              <a:t>TCR V</a:t>
            </a:r>
            <a:r>
              <a:rPr lang="el-GR" altLang="zh-CN" sz="1100" b="1" dirty="0">
                <a:latin typeface="Calibri (正文)"/>
                <a:sym typeface="Symbol" panose="05050102010706020507" pitchFamily="18" charset="2"/>
              </a:rPr>
              <a:t>δ</a:t>
            </a:r>
            <a:r>
              <a:rPr lang="en-US" altLang="zh-CN" sz="1100" b="1" dirty="0">
                <a:latin typeface="Calibri (正文)"/>
                <a:sym typeface="Symbol" panose="05050102010706020507" pitchFamily="18" charset="2"/>
              </a:rPr>
              <a:t>2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182" name="文本框 181">
            <a:extLst>
              <a:ext uri="{FF2B5EF4-FFF2-40B4-BE49-F238E27FC236}">
                <a16:creationId xmlns:a16="http://schemas.microsoft.com/office/drawing/2014/main" id="{C373382E-9B1E-43BC-B9F1-FA9F0E4A97A8}"/>
              </a:ext>
            </a:extLst>
          </p:cNvPr>
          <p:cNvSpPr txBox="1"/>
          <p:nvPr/>
        </p:nvSpPr>
        <p:spPr>
          <a:xfrm>
            <a:off x="5096319" y="6743308"/>
            <a:ext cx="7489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Calibri (正文)"/>
              </a:rPr>
              <a:t>TCR V</a:t>
            </a:r>
            <a:r>
              <a:rPr lang="el-GR" altLang="zh-CN" sz="1100" b="1" dirty="0">
                <a:latin typeface="Calibri (正文)"/>
              </a:rPr>
              <a:t>δ</a:t>
            </a:r>
            <a:r>
              <a:rPr lang="en-US" altLang="zh-CN" sz="1100" b="1" dirty="0">
                <a:latin typeface="Calibri (正文)"/>
              </a:rPr>
              <a:t>1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184" name="文本框 183">
            <a:extLst>
              <a:ext uri="{FF2B5EF4-FFF2-40B4-BE49-F238E27FC236}">
                <a16:creationId xmlns:a16="http://schemas.microsoft.com/office/drawing/2014/main" id="{78EB57EB-1DC0-4353-97A0-D691E9C62C57}"/>
              </a:ext>
            </a:extLst>
          </p:cNvPr>
          <p:cNvSpPr txBox="1"/>
          <p:nvPr/>
        </p:nvSpPr>
        <p:spPr>
          <a:xfrm>
            <a:off x="3819388" y="6700507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Calibri (正文)"/>
              </a:rPr>
              <a:t>CD3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185" name="矩形 184">
            <a:extLst>
              <a:ext uri="{FF2B5EF4-FFF2-40B4-BE49-F238E27FC236}">
                <a16:creationId xmlns:a16="http://schemas.microsoft.com/office/drawing/2014/main" id="{7BED54DB-3456-415B-B70B-4D86AA7CDB16}"/>
              </a:ext>
            </a:extLst>
          </p:cNvPr>
          <p:cNvSpPr/>
          <p:nvPr/>
        </p:nvSpPr>
        <p:spPr>
          <a:xfrm>
            <a:off x="272366" y="5214763"/>
            <a:ext cx="41870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>
                <a:latin typeface="Calibri (正文)"/>
              </a:rPr>
              <a:t>EP:</a:t>
            </a:r>
            <a:endParaRPr lang="zh-CN" altLang="en-US" sz="1400" b="1" dirty="0">
              <a:latin typeface="Calibri (正文)"/>
            </a:endParaRPr>
          </a:p>
        </p:txBody>
      </p:sp>
      <p:sp>
        <p:nvSpPr>
          <p:cNvPr id="188" name="文本框 187">
            <a:extLst>
              <a:ext uri="{FF2B5EF4-FFF2-40B4-BE49-F238E27FC236}">
                <a16:creationId xmlns:a16="http://schemas.microsoft.com/office/drawing/2014/main" id="{242DDE5B-6E56-4031-8D01-BCA949F55A73}"/>
              </a:ext>
            </a:extLst>
          </p:cNvPr>
          <p:cNvSpPr txBox="1"/>
          <p:nvPr/>
        </p:nvSpPr>
        <p:spPr>
          <a:xfrm>
            <a:off x="1423569" y="7498245"/>
            <a:ext cx="8515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Vδ2+NKG2D+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98.8%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文本框 188">
            <a:extLst>
              <a:ext uri="{FF2B5EF4-FFF2-40B4-BE49-F238E27FC236}">
                <a16:creationId xmlns:a16="http://schemas.microsoft.com/office/drawing/2014/main" id="{8689DCF2-E35A-4910-9461-1F840717D50B}"/>
              </a:ext>
            </a:extLst>
          </p:cNvPr>
          <p:cNvSpPr txBox="1"/>
          <p:nvPr/>
        </p:nvSpPr>
        <p:spPr>
          <a:xfrm rot="16200000">
            <a:off x="737513" y="7367440"/>
            <a:ext cx="5392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Calibri (正文)"/>
              </a:rPr>
              <a:t>V</a:t>
            </a:r>
            <a:r>
              <a:rPr lang="el-GR" altLang="zh-CN" sz="1100" b="1" dirty="0">
                <a:latin typeface="Calibri (正文)"/>
                <a:sym typeface="Symbol" panose="05050102010706020507" pitchFamily="18" charset="2"/>
              </a:rPr>
              <a:t>δ</a:t>
            </a:r>
            <a:r>
              <a:rPr lang="en-US" altLang="zh-CN" sz="1100" b="1" dirty="0">
                <a:latin typeface="Calibri (正文)"/>
              </a:rPr>
              <a:t>2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190" name="文本框 189">
            <a:extLst>
              <a:ext uri="{FF2B5EF4-FFF2-40B4-BE49-F238E27FC236}">
                <a16:creationId xmlns:a16="http://schemas.microsoft.com/office/drawing/2014/main" id="{299101C0-38BF-4E47-ADA5-2885130643F4}"/>
              </a:ext>
            </a:extLst>
          </p:cNvPr>
          <p:cNvSpPr txBox="1"/>
          <p:nvPr/>
        </p:nvSpPr>
        <p:spPr>
          <a:xfrm>
            <a:off x="1285694" y="7980334"/>
            <a:ext cx="6694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Calibri (正文)"/>
              </a:rPr>
              <a:t>NKG2D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194" name="文本框 193">
            <a:extLst>
              <a:ext uri="{FF2B5EF4-FFF2-40B4-BE49-F238E27FC236}">
                <a16:creationId xmlns:a16="http://schemas.microsoft.com/office/drawing/2014/main" id="{70D4D1B2-59A5-4894-BE36-0AF8D73CCB4A}"/>
              </a:ext>
            </a:extLst>
          </p:cNvPr>
          <p:cNvSpPr txBox="1"/>
          <p:nvPr/>
        </p:nvSpPr>
        <p:spPr>
          <a:xfrm>
            <a:off x="2547470" y="8000081"/>
            <a:ext cx="6541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Calibri (正文)"/>
              </a:rPr>
              <a:t>NKP30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195" name="文本框 194">
            <a:extLst>
              <a:ext uri="{FF2B5EF4-FFF2-40B4-BE49-F238E27FC236}">
                <a16:creationId xmlns:a16="http://schemas.microsoft.com/office/drawing/2014/main" id="{EC9362A2-9D70-414B-BBCA-E87F3602A654}"/>
              </a:ext>
            </a:extLst>
          </p:cNvPr>
          <p:cNvSpPr txBox="1"/>
          <p:nvPr/>
        </p:nvSpPr>
        <p:spPr>
          <a:xfrm>
            <a:off x="2669149" y="7502625"/>
            <a:ext cx="8242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Vδ2+NKP30+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.0%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文本框 198">
            <a:extLst>
              <a:ext uri="{FF2B5EF4-FFF2-40B4-BE49-F238E27FC236}">
                <a16:creationId xmlns:a16="http://schemas.microsoft.com/office/drawing/2014/main" id="{F0CB7E3E-6559-4557-AF27-85E0D9141085}"/>
              </a:ext>
            </a:extLst>
          </p:cNvPr>
          <p:cNvSpPr txBox="1"/>
          <p:nvPr/>
        </p:nvSpPr>
        <p:spPr>
          <a:xfrm>
            <a:off x="3766353" y="8036215"/>
            <a:ext cx="5986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Calibri (正文)"/>
              </a:rPr>
              <a:t>NKP46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200" name="文本框 199">
            <a:extLst>
              <a:ext uri="{FF2B5EF4-FFF2-40B4-BE49-F238E27FC236}">
                <a16:creationId xmlns:a16="http://schemas.microsoft.com/office/drawing/2014/main" id="{F3E659AF-242E-45DE-8B86-BE7D5C0F7798}"/>
              </a:ext>
            </a:extLst>
          </p:cNvPr>
          <p:cNvSpPr txBox="1"/>
          <p:nvPr/>
        </p:nvSpPr>
        <p:spPr>
          <a:xfrm>
            <a:off x="3706035" y="7520183"/>
            <a:ext cx="8242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Vδ2+NKP46+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.2%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文本框 203">
            <a:extLst>
              <a:ext uri="{FF2B5EF4-FFF2-40B4-BE49-F238E27FC236}">
                <a16:creationId xmlns:a16="http://schemas.microsoft.com/office/drawing/2014/main" id="{A32CC8FE-F6F2-4551-8013-1AEF5BA554F9}"/>
              </a:ext>
            </a:extLst>
          </p:cNvPr>
          <p:cNvSpPr txBox="1"/>
          <p:nvPr/>
        </p:nvSpPr>
        <p:spPr>
          <a:xfrm>
            <a:off x="5025844" y="8061205"/>
            <a:ext cx="4667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Calibri (正文)"/>
              </a:rPr>
              <a:t>PD-1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205" name="文本框 204">
            <a:extLst>
              <a:ext uri="{FF2B5EF4-FFF2-40B4-BE49-F238E27FC236}">
                <a16:creationId xmlns:a16="http://schemas.microsoft.com/office/drawing/2014/main" id="{2684D760-7CBB-4433-A1A9-434C85B2EF99}"/>
              </a:ext>
            </a:extLst>
          </p:cNvPr>
          <p:cNvSpPr txBox="1"/>
          <p:nvPr/>
        </p:nvSpPr>
        <p:spPr>
          <a:xfrm>
            <a:off x="5079933" y="7523668"/>
            <a:ext cx="7264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Vδ2+PD-1+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8.2%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文本框 205">
            <a:extLst>
              <a:ext uri="{FF2B5EF4-FFF2-40B4-BE49-F238E27FC236}">
                <a16:creationId xmlns:a16="http://schemas.microsoft.com/office/drawing/2014/main" id="{96F7349B-714F-4468-81CC-504867FB1C62}"/>
              </a:ext>
            </a:extLst>
          </p:cNvPr>
          <p:cNvSpPr txBox="1"/>
          <p:nvPr/>
        </p:nvSpPr>
        <p:spPr>
          <a:xfrm>
            <a:off x="647450" y="6895234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Calibri (正文)"/>
              </a:rPr>
              <a:t>(B)</a:t>
            </a:r>
            <a:endParaRPr lang="zh-CN" altLang="en-US" sz="1400" b="1" dirty="0">
              <a:latin typeface="Calibri (正文)"/>
            </a:endParaRPr>
          </a:p>
        </p:txBody>
      </p:sp>
      <p:sp>
        <p:nvSpPr>
          <p:cNvPr id="209" name="文本框 208">
            <a:extLst>
              <a:ext uri="{FF2B5EF4-FFF2-40B4-BE49-F238E27FC236}">
                <a16:creationId xmlns:a16="http://schemas.microsoft.com/office/drawing/2014/main" id="{E07113D7-2D5F-40F3-9121-3AEC53A8FEFB}"/>
              </a:ext>
            </a:extLst>
          </p:cNvPr>
          <p:cNvSpPr txBox="1"/>
          <p:nvPr/>
        </p:nvSpPr>
        <p:spPr>
          <a:xfrm rot="16200000">
            <a:off x="743679" y="8698422"/>
            <a:ext cx="5392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Calibri (正文)"/>
              </a:rPr>
              <a:t>V</a:t>
            </a:r>
            <a:r>
              <a:rPr lang="el-GR" altLang="zh-CN" sz="1100" b="1" dirty="0">
                <a:latin typeface="Calibri (正文)"/>
                <a:sym typeface="Symbol" panose="05050102010706020507" pitchFamily="18" charset="2"/>
              </a:rPr>
              <a:t>δ</a:t>
            </a:r>
            <a:r>
              <a:rPr lang="en-US" altLang="zh-CN" sz="1100" b="1" dirty="0">
                <a:latin typeface="Calibri (正文)"/>
              </a:rPr>
              <a:t>1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210" name="文本框 209">
            <a:extLst>
              <a:ext uri="{FF2B5EF4-FFF2-40B4-BE49-F238E27FC236}">
                <a16:creationId xmlns:a16="http://schemas.microsoft.com/office/drawing/2014/main" id="{111032F3-0974-46EE-BC67-2A09BDB06A41}"/>
              </a:ext>
            </a:extLst>
          </p:cNvPr>
          <p:cNvSpPr txBox="1"/>
          <p:nvPr/>
        </p:nvSpPr>
        <p:spPr>
          <a:xfrm>
            <a:off x="1332661" y="9329742"/>
            <a:ext cx="5373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Calibri (正文)"/>
              </a:rPr>
              <a:t>NKG2D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214" name="文本框 213">
            <a:extLst>
              <a:ext uri="{FF2B5EF4-FFF2-40B4-BE49-F238E27FC236}">
                <a16:creationId xmlns:a16="http://schemas.microsoft.com/office/drawing/2014/main" id="{48BDF6D8-3AA0-4249-A050-486B61D8EB7F}"/>
              </a:ext>
            </a:extLst>
          </p:cNvPr>
          <p:cNvSpPr txBox="1"/>
          <p:nvPr/>
        </p:nvSpPr>
        <p:spPr>
          <a:xfrm>
            <a:off x="2561512" y="9329742"/>
            <a:ext cx="5373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Calibri (正文)"/>
              </a:rPr>
              <a:t>NKP30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218" name="文本框 217">
            <a:extLst>
              <a:ext uri="{FF2B5EF4-FFF2-40B4-BE49-F238E27FC236}">
                <a16:creationId xmlns:a16="http://schemas.microsoft.com/office/drawing/2014/main" id="{E6D0CCC1-3E51-4275-A90F-D01164C9A0AE}"/>
              </a:ext>
            </a:extLst>
          </p:cNvPr>
          <p:cNvSpPr txBox="1"/>
          <p:nvPr/>
        </p:nvSpPr>
        <p:spPr>
          <a:xfrm>
            <a:off x="3706035" y="9349902"/>
            <a:ext cx="5373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Calibri (正文)"/>
              </a:rPr>
              <a:t>NKP46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222" name="文本框 221">
            <a:extLst>
              <a:ext uri="{FF2B5EF4-FFF2-40B4-BE49-F238E27FC236}">
                <a16:creationId xmlns:a16="http://schemas.microsoft.com/office/drawing/2014/main" id="{0C917632-6C9D-4BE6-B3F2-A51954E227E9}"/>
              </a:ext>
            </a:extLst>
          </p:cNvPr>
          <p:cNvSpPr txBox="1"/>
          <p:nvPr/>
        </p:nvSpPr>
        <p:spPr>
          <a:xfrm>
            <a:off x="4999845" y="9314501"/>
            <a:ext cx="4667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Calibri (正文)"/>
              </a:rPr>
              <a:t>PD-1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223" name="文本框 222">
            <a:extLst>
              <a:ext uri="{FF2B5EF4-FFF2-40B4-BE49-F238E27FC236}">
                <a16:creationId xmlns:a16="http://schemas.microsoft.com/office/drawing/2014/main" id="{94742BCF-9485-4601-847D-BD2360DBC34E}"/>
              </a:ext>
            </a:extLst>
          </p:cNvPr>
          <p:cNvSpPr txBox="1"/>
          <p:nvPr/>
        </p:nvSpPr>
        <p:spPr>
          <a:xfrm>
            <a:off x="1428796" y="8326357"/>
            <a:ext cx="8515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Vδ1+NKG2D+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94.3%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文本框 223">
            <a:extLst>
              <a:ext uri="{FF2B5EF4-FFF2-40B4-BE49-F238E27FC236}">
                <a16:creationId xmlns:a16="http://schemas.microsoft.com/office/drawing/2014/main" id="{288665E0-DE63-41BC-ADFD-9284FF5EDB64}"/>
              </a:ext>
            </a:extLst>
          </p:cNvPr>
          <p:cNvSpPr txBox="1"/>
          <p:nvPr/>
        </p:nvSpPr>
        <p:spPr>
          <a:xfrm>
            <a:off x="2646019" y="8308385"/>
            <a:ext cx="8242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Vδ1+NKP30+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.9%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文本框 224">
            <a:extLst>
              <a:ext uri="{FF2B5EF4-FFF2-40B4-BE49-F238E27FC236}">
                <a16:creationId xmlns:a16="http://schemas.microsoft.com/office/drawing/2014/main" id="{1B2FD6AD-F9E1-43C9-B96F-D621D8BA33E2}"/>
              </a:ext>
            </a:extLst>
          </p:cNvPr>
          <p:cNvSpPr txBox="1"/>
          <p:nvPr/>
        </p:nvSpPr>
        <p:spPr>
          <a:xfrm>
            <a:off x="3812917" y="8328985"/>
            <a:ext cx="8242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Vδ1+NKP46+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8.4%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文本框 225">
            <a:extLst>
              <a:ext uri="{FF2B5EF4-FFF2-40B4-BE49-F238E27FC236}">
                <a16:creationId xmlns:a16="http://schemas.microsoft.com/office/drawing/2014/main" id="{1D0CE1A6-8B58-47FA-8172-2BFC397749DA}"/>
              </a:ext>
            </a:extLst>
          </p:cNvPr>
          <p:cNvSpPr txBox="1"/>
          <p:nvPr/>
        </p:nvSpPr>
        <p:spPr>
          <a:xfrm>
            <a:off x="5065667" y="8347206"/>
            <a:ext cx="7264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Vδ1+PD-1+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2.1%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文本框 226">
            <a:extLst>
              <a:ext uri="{FF2B5EF4-FFF2-40B4-BE49-F238E27FC236}">
                <a16:creationId xmlns:a16="http://schemas.microsoft.com/office/drawing/2014/main" id="{F30BCB72-46E7-49AB-A3EE-BC5A638FCAAE}"/>
              </a:ext>
            </a:extLst>
          </p:cNvPr>
          <p:cNvSpPr txBox="1"/>
          <p:nvPr/>
        </p:nvSpPr>
        <p:spPr>
          <a:xfrm>
            <a:off x="671637" y="8128010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Calibri (正文)"/>
              </a:rPr>
              <a:t>(C)</a:t>
            </a:r>
            <a:endParaRPr lang="zh-CN" altLang="en-US" sz="1400" b="1" dirty="0">
              <a:latin typeface="Calibri (正文)"/>
            </a:endParaRPr>
          </a:p>
        </p:txBody>
      </p:sp>
      <p:pic>
        <p:nvPicPr>
          <p:cNvPr id="228" name="图片 227">
            <a:extLst>
              <a:ext uri="{FF2B5EF4-FFF2-40B4-BE49-F238E27FC236}">
                <a16:creationId xmlns:a16="http://schemas.microsoft.com/office/drawing/2014/main" id="{3432EDB2-F027-4B0E-821E-E7F25E1CCE0D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827396" y="5616040"/>
            <a:ext cx="1091091" cy="1080000"/>
          </a:xfrm>
          <a:prstGeom prst="rect">
            <a:avLst/>
          </a:prstGeom>
        </p:spPr>
      </p:pic>
      <p:pic>
        <p:nvPicPr>
          <p:cNvPr id="229" name="图片 228">
            <a:extLst>
              <a:ext uri="{FF2B5EF4-FFF2-40B4-BE49-F238E27FC236}">
                <a16:creationId xmlns:a16="http://schemas.microsoft.com/office/drawing/2014/main" id="{50A79FAE-20B3-4B56-8753-1F05BF4B5E61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2110907" y="5634591"/>
            <a:ext cx="1091458" cy="1080000"/>
          </a:xfrm>
          <a:prstGeom prst="rect">
            <a:avLst/>
          </a:prstGeom>
        </p:spPr>
      </p:pic>
      <p:sp>
        <p:nvSpPr>
          <p:cNvPr id="230" name="文本框 229">
            <a:extLst>
              <a:ext uri="{FF2B5EF4-FFF2-40B4-BE49-F238E27FC236}">
                <a16:creationId xmlns:a16="http://schemas.microsoft.com/office/drawing/2014/main" id="{11911681-118A-48D1-B4E0-9E12967A1FD7}"/>
              </a:ext>
            </a:extLst>
          </p:cNvPr>
          <p:cNvSpPr txBox="1"/>
          <p:nvPr/>
        </p:nvSpPr>
        <p:spPr>
          <a:xfrm>
            <a:off x="2699326" y="5637596"/>
            <a:ext cx="4780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D3+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6.3%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1" name="图片 230">
            <a:extLst>
              <a:ext uri="{FF2B5EF4-FFF2-40B4-BE49-F238E27FC236}">
                <a16:creationId xmlns:a16="http://schemas.microsoft.com/office/drawing/2014/main" id="{39363777-97EE-4338-8ED1-51101ADB0CC5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4820941" y="5656261"/>
            <a:ext cx="1137015" cy="1080000"/>
          </a:xfrm>
          <a:prstGeom prst="rect">
            <a:avLst/>
          </a:prstGeom>
        </p:spPr>
      </p:pic>
      <p:sp>
        <p:nvSpPr>
          <p:cNvPr id="232" name="文本框 231">
            <a:extLst>
              <a:ext uri="{FF2B5EF4-FFF2-40B4-BE49-F238E27FC236}">
                <a16:creationId xmlns:a16="http://schemas.microsoft.com/office/drawing/2014/main" id="{84B662E6-AA26-431C-B1D7-074829354AE6}"/>
              </a:ext>
            </a:extLst>
          </p:cNvPr>
          <p:cNvSpPr txBox="1"/>
          <p:nvPr/>
        </p:nvSpPr>
        <p:spPr>
          <a:xfrm>
            <a:off x="5334662" y="5640025"/>
            <a:ext cx="6126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γδ+Vδ2+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0.7%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" name="文本框 232">
            <a:extLst>
              <a:ext uri="{FF2B5EF4-FFF2-40B4-BE49-F238E27FC236}">
                <a16:creationId xmlns:a16="http://schemas.microsoft.com/office/drawing/2014/main" id="{4DB7A03D-67C9-4D81-9895-E604FF81E0B3}"/>
              </a:ext>
            </a:extLst>
          </p:cNvPr>
          <p:cNvSpPr txBox="1"/>
          <p:nvPr/>
        </p:nvSpPr>
        <p:spPr>
          <a:xfrm>
            <a:off x="5398317" y="6309433"/>
            <a:ext cx="5966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γδ+Vδ1+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8.6%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4" name="图片 233">
            <a:extLst>
              <a:ext uri="{FF2B5EF4-FFF2-40B4-BE49-F238E27FC236}">
                <a16:creationId xmlns:a16="http://schemas.microsoft.com/office/drawing/2014/main" id="{696E7330-D0E0-4373-AA9A-86915BC811AC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3388710" y="5639221"/>
            <a:ext cx="1177891" cy="1080000"/>
          </a:xfrm>
          <a:prstGeom prst="rect">
            <a:avLst/>
          </a:prstGeom>
        </p:spPr>
      </p:pic>
      <p:sp>
        <p:nvSpPr>
          <p:cNvPr id="235" name="文本框 234">
            <a:extLst>
              <a:ext uri="{FF2B5EF4-FFF2-40B4-BE49-F238E27FC236}">
                <a16:creationId xmlns:a16="http://schemas.microsoft.com/office/drawing/2014/main" id="{5C50ED2B-E102-4AD4-9F18-537C0E9254CB}"/>
              </a:ext>
            </a:extLst>
          </p:cNvPr>
          <p:cNvSpPr txBox="1"/>
          <p:nvPr/>
        </p:nvSpPr>
        <p:spPr>
          <a:xfrm>
            <a:off x="3931801" y="5647885"/>
            <a:ext cx="7467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CD3+γδ+</a:t>
            </a:r>
          </a:p>
          <a:p>
            <a:r>
              <a:rPr lang="en-US" altLang="zh-CN" sz="8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4.6%</a:t>
            </a:r>
            <a:endParaRPr lang="zh-CN" altLang="en-US" sz="8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  <p:sp>
        <p:nvSpPr>
          <p:cNvPr id="236" name="文本框 235">
            <a:extLst>
              <a:ext uri="{FF2B5EF4-FFF2-40B4-BE49-F238E27FC236}">
                <a16:creationId xmlns:a16="http://schemas.microsoft.com/office/drawing/2014/main" id="{56FAD2A8-5885-4E25-BC36-A30A13420308}"/>
              </a:ext>
            </a:extLst>
          </p:cNvPr>
          <p:cNvSpPr txBox="1"/>
          <p:nvPr/>
        </p:nvSpPr>
        <p:spPr>
          <a:xfrm rot="16200000">
            <a:off x="4173909" y="1332694"/>
            <a:ext cx="9382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Calibri (正文)"/>
                <a:sym typeface="Symbol" panose="05050102010706020507" pitchFamily="18" charset="2"/>
              </a:rPr>
              <a:t>TCR V</a:t>
            </a:r>
            <a:r>
              <a:rPr lang="el-GR" altLang="zh-CN" sz="1100" b="1" dirty="0">
                <a:latin typeface="Calibri (正文)"/>
                <a:sym typeface="Symbol" panose="05050102010706020507" pitchFamily="18" charset="2"/>
              </a:rPr>
              <a:t>δ</a:t>
            </a:r>
            <a:r>
              <a:rPr lang="en-US" altLang="zh-CN" sz="1100" b="1" dirty="0">
                <a:latin typeface="Calibri (正文)"/>
                <a:sym typeface="Symbol" panose="05050102010706020507" pitchFamily="18" charset="2"/>
              </a:rPr>
              <a:t>2</a:t>
            </a:r>
            <a:endParaRPr lang="zh-CN" altLang="en-US" sz="1100" b="1" dirty="0">
              <a:latin typeface="Calibri (正文)"/>
            </a:endParaRPr>
          </a:p>
        </p:txBody>
      </p:sp>
      <p:sp>
        <p:nvSpPr>
          <p:cNvPr id="237" name="文本框 236">
            <a:extLst>
              <a:ext uri="{FF2B5EF4-FFF2-40B4-BE49-F238E27FC236}">
                <a16:creationId xmlns:a16="http://schemas.microsoft.com/office/drawing/2014/main" id="{ADC4ABA5-7183-4690-973A-50B05EB84006}"/>
              </a:ext>
            </a:extLst>
          </p:cNvPr>
          <p:cNvSpPr txBox="1"/>
          <p:nvPr/>
        </p:nvSpPr>
        <p:spPr>
          <a:xfrm>
            <a:off x="5010568" y="2077867"/>
            <a:ext cx="7489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Calibri (正文)"/>
              </a:rPr>
              <a:t>TCR V</a:t>
            </a:r>
            <a:r>
              <a:rPr lang="el-GR" altLang="zh-CN" sz="1100" b="1" dirty="0">
                <a:latin typeface="Calibri (正文)"/>
              </a:rPr>
              <a:t>δ</a:t>
            </a:r>
            <a:r>
              <a:rPr lang="en-US" altLang="zh-CN" sz="1100" b="1" dirty="0">
                <a:latin typeface="Calibri (正文)"/>
              </a:rPr>
              <a:t>1</a:t>
            </a:r>
            <a:endParaRPr lang="zh-CN" altLang="en-US" sz="1100" b="1" dirty="0">
              <a:latin typeface="Calibri (正文)"/>
            </a:endParaRPr>
          </a:p>
        </p:txBody>
      </p:sp>
      <p:pic>
        <p:nvPicPr>
          <p:cNvPr id="238" name="图片 237">
            <a:extLst>
              <a:ext uri="{FF2B5EF4-FFF2-40B4-BE49-F238E27FC236}">
                <a16:creationId xmlns:a16="http://schemas.microsoft.com/office/drawing/2014/main" id="{6C738BEE-C020-45C8-94BC-D46F61E1AD17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4743980" y="984005"/>
            <a:ext cx="1152260" cy="1080000"/>
          </a:xfrm>
          <a:prstGeom prst="rect">
            <a:avLst/>
          </a:prstGeom>
        </p:spPr>
      </p:pic>
      <p:sp>
        <p:nvSpPr>
          <p:cNvPr id="239" name="文本框 238">
            <a:extLst>
              <a:ext uri="{FF2B5EF4-FFF2-40B4-BE49-F238E27FC236}">
                <a16:creationId xmlns:a16="http://schemas.microsoft.com/office/drawing/2014/main" id="{3C4A5792-F7BE-49BB-80EB-B1FFA8E0C450}"/>
              </a:ext>
            </a:extLst>
          </p:cNvPr>
          <p:cNvSpPr txBox="1"/>
          <p:nvPr/>
        </p:nvSpPr>
        <p:spPr>
          <a:xfrm>
            <a:off x="5378591" y="1698332"/>
            <a:ext cx="5966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γδ+Vδ1+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.9%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0" name="文本框 239">
            <a:extLst>
              <a:ext uri="{FF2B5EF4-FFF2-40B4-BE49-F238E27FC236}">
                <a16:creationId xmlns:a16="http://schemas.microsoft.com/office/drawing/2014/main" id="{B29AE643-A0C1-4D98-B5C2-E64C7408EC4D}"/>
              </a:ext>
            </a:extLst>
          </p:cNvPr>
          <p:cNvSpPr txBox="1"/>
          <p:nvPr/>
        </p:nvSpPr>
        <p:spPr>
          <a:xfrm>
            <a:off x="5277518" y="1042278"/>
            <a:ext cx="5966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γδ+Vδ2+</a:t>
            </a: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81.7%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1" name="文本框 240">
            <a:extLst>
              <a:ext uri="{FF2B5EF4-FFF2-40B4-BE49-F238E27FC236}">
                <a16:creationId xmlns:a16="http://schemas.microsoft.com/office/drawing/2014/main" id="{E6E6CB30-6123-4183-9EE5-8AA3B967AFFC}"/>
              </a:ext>
            </a:extLst>
          </p:cNvPr>
          <p:cNvSpPr txBox="1"/>
          <p:nvPr/>
        </p:nvSpPr>
        <p:spPr>
          <a:xfrm>
            <a:off x="253326" y="954971"/>
            <a:ext cx="4058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Calibri (正文)"/>
              </a:rPr>
              <a:t>(A)</a:t>
            </a:r>
            <a:endParaRPr lang="zh-CN" altLang="en-US" sz="1400" b="1" dirty="0">
              <a:latin typeface="Calibri (正文)"/>
            </a:endParaRPr>
          </a:p>
        </p:txBody>
      </p:sp>
      <p:cxnSp>
        <p:nvCxnSpPr>
          <p:cNvPr id="4" name="直接箭头连接符 3">
            <a:extLst>
              <a:ext uri="{FF2B5EF4-FFF2-40B4-BE49-F238E27FC236}">
                <a16:creationId xmlns:a16="http://schemas.microsoft.com/office/drawing/2014/main" id="{09BB4D3A-6FB7-419B-8CC6-7399FD7667D9}"/>
              </a:ext>
            </a:extLst>
          </p:cNvPr>
          <p:cNvCxnSpPr/>
          <p:nvPr/>
        </p:nvCxnSpPr>
        <p:spPr>
          <a:xfrm flipV="1">
            <a:off x="1014290" y="3822753"/>
            <a:ext cx="0" cy="1044679"/>
          </a:xfrm>
          <a:prstGeom prst="straightConnector1">
            <a:avLst/>
          </a:prstGeom>
          <a:ln w="19050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2" name="直接箭头连接符 241">
            <a:extLst>
              <a:ext uri="{FF2B5EF4-FFF2-40B4-BE49-F238E27FC236}">
                <a16:creationId xmlns:a16="http://schemas.microsoft.com/office/drawing/2014/main" id="{C11D5677-70F8-485D-BDAA-5FAA0D623E19}"/>
              </a:ext>
            </a:extLst>
          </p:cNvPr>
          <p:cNvCxnSpPr/>
          <p:nvPr/>
        </p:nvCxnSpPr>
        <p:spPr>
          <a:xfrm flipV="1">
            <a:off x="988359" y="2421846"/>
            <a:ext cx="0" cy="1044679"/>
          </a:xfrm>
          <a:prstGeom prst="straightConnector1">
            <a:avLst/>
          </a:prstGeom>
          <a:ln w="19050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3" name="文本框 242">
            <a:extLst>
              <a:ext uri="{FF2B5EF4-FFF2-40B4-BE49-F238E27FC236}">
                <a16:creationId xmlns:a16="http://schemas.microsoft.com/office/drawing/2014/main" id="{64CCD2D5-566B-4D14-802D-52219EB8E1A8}"/>
              </a:ext>
            </a:extLst>
          </p:cNvPr>
          <p:cNvSpPr txBox="1"/>
          <p:nvPr/>
        </p:nvSpPr>
        <p:spPr>
          <a:xfrm>
            <a:off x="374482" y="5468248"/>
            <a:ext cx="4058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Calibri (正文)"/>
              </a:rPr>
              <a:t>(A)</a:t>
            </a:r>
            <a:endParaRPr lang="zh-CN" altLang="en-US" sz="1400" b="1" dirty="0">
              <a:latin typeface="Calibri (正文)"/>
            </a:endParaRPr>
          </a:p>
        </p:txBody>
      </p:sp>
    </p:spTree>
    <p:extLst>
      <p:ext uri="{BB962C8B-B14F-4D97-AF65-F5344CB8AC3E}">
        <p14:creationId xmlns:p14="http://schemas.microsoft.com/office/powerpoint/2010/main" val="5428809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9" name="对象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26857438"/>
              </p:ext>
            </p:extLst>
          </p:nvPr>
        </p:nvGraphicFramePr>
        <p:xfrm>
          <a:off x="3786775" y="1211824"/>
          <a:ext cx="2166523" cy="17780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3929981" imgH="3225976" progId="Prism8.Document">
                  <p:embed/>
                </p:oleObj>
              </mc:Choice>
              <mc:Fallback>
                <p:oleObj name="Prism 8" r:id="rId3" imgW="3929981" imgH="3225976" progId="Prism8.Document">
                  <p:embed/>
                  <p:pic>
                    <p:nvPicPr>
                      <p:cNvPr id="19" name="对象 18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786775" y="1211824"/>
                        <a:ext cx="2166523" cy="177801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" name="图片 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104" y="1102778"/>
            <a:ext cx="2219910" cy="1802429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1513" y="1211824"/>
            <a:ext cx="2186119" cy="1810742"/>
          </a:xfrm>
          <a:prstGeom prst="rect">
            <a:avLst/>
          </a:prstGeom>
        </p:spPr>
      </p:pic>
      <p:cxnSp>
        <p:nvCxnSpPr>
          <p:cNvPr id="8" name="直接箭头连接符 7"/>
          <p:cNvCxnSpPr/>
          <p:nvPr/>
        </p:nvCxnSpPr>
        <p:spPr>
          <a:xfrm flipV="1">
            <a:off x="716625" y="1695149"/>
            <a:ext cx="0" cy="22320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 rot="16200000">
            <a:off x="-620822" y="2730524"/>
            <a:ext cx="22557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% of CD4+T cells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1" name="对象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67254314"/>
              </p:ext>
            </p:extLst>
          </p:nvPr>
        </p:nvGraphicFramePr>
        <p:xfrm>
          <a:off x="5127168" y="1256503"/>
          <a:ext cx="2202434" cy="17840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3727327" imgH="3020078" progId="Prism8.Document">
                  <p:embed/>
                </p:oleObj>
              </mc:Choice>
              <mc:Fallback>
                <p:oleObj name="Prism 8" r:id="rId7" imgW="3727327" imgH="3020078" progId="Prism8.Document">
                  <p:embed/>
                  <p:pic>
                    <p:nvPicPr>
                      <p:cNvPr id="21" name="对象 20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127168" y="1256503"/>
                        <a:ext cx="2202434" cy="17840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文本框 21"/>
          <p:cNvSpPr txBox="1"/>
          <p:nvPr/>
        </p:nvSpPr>
        <p:spPr>
          <a:xfrm>
            <a:off x="3521118" y="1126262"/>
            <a:ext cx="5405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/>
              <a:t>(C)</a:t>
            </a:r>
            <a:endParaRPr lang="zh-CN" altLang="en-US" sz="2400" b="1" dirty="0"/>
          </a:p>
        </p:txBody>
      </p:sp>
      <p:sp>
        <p:nvSpPr>
          <p:cNvPr id="29" name="文本框 28"/>
          <p:cNvSpPr txBox="1"/>
          <p:nvPr/>
        </p:nvSpPr>
        <p:spPr>
          <a:xfrm rot="16200000">
            <a:off x="3381888" y="1898734"/>
            <a:ext cx="12779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% of Th cells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948D57DF-AEAB-4997-BCE4-3AB465F7C7CA}"/>
              </a:ext>
            </a:extLst>
          </p:cNvPr>
          <p:cNvSpPr txBox="1"/>
          <p:nvPr/>
        </p:nvSpPr>
        <p:spPr>
          <a:xfrm>
            <a:off x="278135" y="1155892"/>
            <a:ext cx="56297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/>
              <a:t>(A)</a:t>
            </a:r>
            <a:endParaRPr lang="zh-CN" altLang="en-US" sz="2400" b="1" dirty="0"/>
          </a:p>
        </p:txBody>
      </p:sp>
      <p:graphicFrame>
        <p:nvGraphicFramePr>
          <p:cNvPr id="28" name="对象 27">
            <a:extLst>
              <a:ext uri="{FF2B5EF4-FFF2-40B4-BE49-F238E27FC236}">
                <a16:creationId xmlns:a16="http://schemas.microsoft.com/office/drawing/2014/main" id="{33D2CF3E-1599-472F-BA26-3BD677F9455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96015283"/>
              </p:ext>
            </p:extLst>
          </p:nvPr>
        </p:nvGraphicFramePr>
        <p:xfrm>
          <a:off x="525279" y="4537462"/>
          <a:ext cx="2465571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9" imgW="3727327" imgH="3265572" progId="Prism8.Document">
                  <p:embed/>
                </p:oleObj>
              </mc:Choice>
              <mc:Fallback>
                <p:oleObj name="Prism 8" r:id="rId9" imgW="3727327" imgH="3265572" progId="Prism8.Document">
                  <p:embed/>
                  <p:pic>
                    <p:nvPicPr>
                      <p:cNvPr id="28" name="对象 27">
                        <a:extLst>
                          <a:ext uri="{FF2B5EF4-FFF2-40B4-BE49-F238E27FC236}">
                            <a16:creationId xmlns:a16="http://schemas.microsoft.com/office/drawing/2014/main" id="{33D2CF3E-1599-472F-BA26-3BD677F9455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25279" y="4537462"/>
                        <a:ext cx="2465571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1" name="矩形 30">
            <a:extLst>
              <a:ext uri="{FF2B5EF4-FFF2-40B4-BE49-F238E27FC236}">
                <a16:creationId xmlns:a16="http://schemas.microsoft.com/office/drawing/2014/main" id="{F5E08AB9-6C47-4704-A429-5D68A9C33149}"/>
              </a:ext>
            </a:extLst>
          </p:cNvPr>
          <p:cNvSpPr/>
          <p:nvPr/>
        </p:nvSpPr>
        <p:spPr>
          <a:xfrm rot="16200000">
            <a:off x="-517289" y="6392453"/>
            <a:ext cx="2255746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20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% of CD8+T cell</a:t>
            </a:r>
            <a:r>
              <a:rPr lang="en-US" altLang="zh-CN" sz="20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s</a:t>
            </a:r>
            <a:endParaRPr lang="zh-CN" altLang="en-US" sz="20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graphicFrame>
        <p:nvGraphicFramePr>
          <p:cNvPr id="35" name="对象 34">
            <a:extLst>
              <a:ext uri="{FF2B5EF4-FFF2-40B4-BE49-F238E27FC236}">
                <a16:creationId xmlns:a16="http://schemas.microsoft.com/office/drawing/2014/main" id="{1F297750-E09B-4EE7-9F89-6D2475575F8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42504604"/>
              </p:ext>
            </p:extLst>
          </p:nvPr>
        </p:nvGraphicFramePr>
        <p:xfrm>
          <a:off x="2137617" y="4568916"/>
          <a:ext cx="2561454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1" imgW="3727327" imgH="3143545" progId="Prism8.Document">
                  <p:embed/>
                </p:oleObj>
              </mc:Choice>
              <mc:Fallback>
                <p:oleObj name="Prism 8" r:id="rId11" imgW="3727327" imgH="3143545" progId="Prism8.Document">
                  <p:embed/>
                  <p:pic>
                    <p:nvPicPr>
                      <p:cNvPr id="35" name="对象 34">
                        <a:extLst>
                          <a:ext uri="{FF2B5EF4-FFF2-40B4-BE49-F238E27FC236}">
                            <a16:creationId xmlns:a16="http://schemas.microsoft.com/office/drawing/2014/main" id="{1F297750-E09B-4EE7-9F89-6D2475575F8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137617" y="4568916"/>
                        <a:ext cx="2561454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38" name="直接箭头连接符 37">
            <a:extLst>
              <a:ext uri="{FF2B5EF4-FFF2-40B4-BE49-F238E27FC236}">
                <a16:creationId xmlns:a16="http://schemas.microsoft.com/office/drawing/2014/main" id="{4A93721B-7690-4B57-B7E2-4E28364EF9EC}"/>
              </a:ext>
            </a:extLst>
          </p:cNvPr>
          <p:cNvCxnSpPr/>
          <p:nvPr/>
        </p:nvCxnSpPr>
        <p:spPr>
          <a:xfrm flipV="1">
            <a:off x="827712" y="5243949"/>
            <a:ext cx="0" cy="27000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文本框 40">
            <a:extLst>
              <a:ext uri="{FF2B5EF4-FFF2-40B4-BE49-F238E27FC236}">
                <a16:creationId xmlns:a16="http://schemas.microsoft.com/office/drawing/2014/main" id="{13B214C0-1D51-4A67-9466-8B8EFCFA8192}"/>
              </a:ext>
            </a:extLst>
          </p:cNvPr>
          <p:cNvSpPr txBox="1"/>
          <p:nvPr/>
        </p:nvSpPr>
        <p:spPr>
          <a:xfrm>
            <a:off x="293028" y="4537462"/>
            <a:ext cx="63511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/>
              <a:t>(B)</a:t>
            </a:r>
            <a:endParaRPr lang="zh-CN" altLang="en-US" sz="2800" b="1" dirty="0"/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7412ED34-F553-4F03-8558-D501EEC8439C}"/>
              </a:ext>
            </a:extLst>
          </p:cNvPr>
          <p:cNvSpPr/>
          <p:nvPr/>
        </p:nvSpPr>
        <p:spPr>
          <a:xfrm>
            <a:off x="979714" y="2547257"/>
            <a:ext cx="5669275" cy="2175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7237" y="2580571"/>
            <a:ext cx="2188060" cy="1830242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491" y="2580571"/>
            <a:ext cx="2166523" cy="1845884"/>
          </a:xfrm>
          <a:prstGeom prst="rect">
            <a:avLst/>
          </a:prstGeom>
        </p:spPr>
      </p:pic>
      <p:graphicFrame>
        <p:nvGraphicFramePr>
          <p:cNvPr id="30" name="对象 2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89295270"/>
              </p:ext>
            </p:extLst>
          </p:nvPr>
        </p:nvGraphicFramePr>
        <p:xfrm>
          <a:off x="3700028" y="2658264"/>
          <a:ext cx="2389284" cy="18195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5" imgW="3648137" imgH="2777824" progId="Prism8.Document">
                  <p:embed/>
                </p:oleObj>
              </mc:Choice>
              <mc:Fallback>
                <p:oleObj name="Prism 8" r:id="rId15" imgW="3648137" imgH="2777824" progId="Prism8.Document">
                  <p:embed/>
                  <p:pic>
                    <p:nvPicPr>
                      <p:cNvPr id="30" name="对象 29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700028" y="2658264"/>
                        <a:ext cx="2389284" cy="18195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4" name="文本框 33"/>
          <p:cNvSpPr txBox="1"/>
          <p:nvPr/>
        </p:nvSpPr>
        <p:spPr>
          <a:xfrm>
            <a:off x="3596689" y="2561977"/>
            <a:ext cx="5709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/>
              <a:t>(D)</a:t>
            </a:r>
            <a:endParaRPr lang="zh-CN" altLang="en-US" sz="2400" b="1" dirty="0"/>
          </a:p>
        </p:txBody>
      </p:sp>
      <p:sp>
        <p:nvSpPr>
          <p:cNvPr id="33" name="文本框 32"/>
          <p:cNvSpPr txBox="1"/>
          <p:nvPr/>
        </p:nvSpPr>
        <p:spPr>
          <a:xfrm rot="16200000">
            <a:off x="3283279" y="3395665"/>
            <a:ext cx="13372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% of Tfh cells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73026A5E-7B0A-4945-9305-9D02E1EDE3FB}"/>
              </a:ext>
            </a:extLst>
          </p:cNvPr>
          <p:cNvSpPr/>
          <p:nvPr/>
        </p:nvSpPr>
        <p:spPr>
          <a:xfrm>
            <a:off x="1016241" y="3967706"/>
            <a:ext cx="4835920" cy="34216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57DE1B84-2CCE-42A3-9288-3B88A3B48924}"/>
              </a:ext>
            </a:extLst>
          </p:cNvPr>
          <p:cNvSpPr txBox="1"/>
          <p:nvPr/>
        </p:nvSpPr>
        <p:spPr>
          <a:xfrm>
            <a:off x="905193" y="3940541"/>
            <a:ext cx="1265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0000FF"/>
                </a:solidFill>
                <a:latin typeface="Arial Narrow" panose="020B0606020202030204" pitchFamily="34" charset="0"/>
              </a:rPr>
              <a:t>Healthy</a:t>
            </a:r>
            <a:r>
              <a:rPr lang="en-US" altLang="zh-CN" b="1" dirty="0">
                <a:latin typeface="Arial Narrow" panose="020B0606020202030204" pitchFamily="34" charset="0"/>
              </a:rPr>
              <a:t>  </a:t>
            </a:r>
            <a:r>
              <a:rPr lang="en-US" altLang="zh-CN" b="1" dirty="0">
                <a:solidFill>
                  <a:srgbClr val="FF0000"/>
                </a:solidFill>
                <a:latin typeface="Arial Narrow" panose="020B0606020202030204" pitchFamily="34" charset="0"/>
              </a:rPr>
              <a:t>EP</a:t>
            </a:r>
            <a:endParaRPr lang="zh-CN" altLang="en-US" b="1" dirty="0">
              <a:solidFill>
                <a:srgbClr val="FF0000"/>
              </a:solidFill>
              <a:latin typeface="Arial Narrow" panose="020B060602020203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EB7EE39A-C3C5-41A5-ADE4-C115597BEF59}"/>
              </a:ext>
            </a:extLst>
          </p:cNvPr>
          <p:cNvSpPr txBox="1"/>
          <p:nvPr/>
        </p:nvSpPr>
        <p:spPr>
          <a:xfrm>
            <a:off x="2295837" y="3939116"/>
            <a:ext cx="1265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0000FF"/>
                </a:solidFill>
                <a:latin typeface="Arial Narrow" panose="020B0606020202030204" pitchFamily="34" charset="0"/>
              </a:rPr>
              <a:t>Healthy</a:t>
            </a:r>
            <a:r>
              <a:rPr lang="en-US" altLang="zh-CN" b="1" dirty="0">
                <a:latin typeface="Arial Narrow" panose="020B0606020202030204" pitchFamily="34" charset="0"/>
              </a:rPr>
              <a:t>  </a:t>
            </a:r>
            <a:r>
              <a:rPr lang="en-US" altLang="zh-CN" b="1" dirty="0">
                <a:solidFill>
                  <a:srgbClr val="FF0000"/>
                </a:solidFill>
                <a:latin typeface="Arial Narrow" panose="020B0606020202030204" pitchFamily="34" charset="0"/>
              </a:rPr>
              <a:t>EP</a:t>
            </a:r>
            <a:endParaRPr lang="zh-CN" altLang="en-US" b="1" dirty="0">
              <a:solidFill>
                <a:srgbClr val="FF0000"/>
              </a:solidFill>
              <a:latin typeface="Arial Narrow" panose="020B060602020203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3AC531DE-6FF8-4BE1-B0FA-C2D40FBBA987}"/>
              </a:ext>
            </a:extLst>
          </p:cNvPr>
          <p:cNvSpPr txBox="1"/>
          <p:nvPr/>
        </p:nvSpPr>
        <p:spPr>
          <a:xfrm>
            <a:off x="4139228" y="3949172"/>
            <a:ext cx="1265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0000FF"/>
                </a:solidFill>
                <a:latin typeface="Arial Narrow" panose="020B0606020202030204" pitchFamily="34" charset="0"/>
              </a:rPr>
              <a:t>Healthy</a:t>
            </a:r>
            <a:r>
              <a:rPr lang="en-US" altLang="zh-CN" b="1" dirty="0">
                <a:latin typeface="Arial Narrow" panose="020B0606020202030204" pitchFamily="34" charset="0"/>
              </a:rPr>
              <a:t>  </a:t>
            </a:r>
            <a:r>
              <a:rPr lang="en-US" altLang="zh-CN" b="1" dirty="0">
                <a:solidFill>
                  <a:srgbClr val="FF0000"/>
                </a:solidFill>
                <a:latin typeface="Arial Narrow" panose="020B0606020202030204" pitchFamily="34" charset="0"/>
              </a:rPr>
              <a:t>EP</a:t>
            </a:r>
            <a:endParaRPr lang="zh-CN" altLang="en-US" b="1" dirty="0">
              <a:solidFill>
                <a:srgbClr val="FF0000"/>
              </a:solidFill>
              <a:latin typeface="Arial Narrow" panose="020B060602020203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35CB6838-6232-480A-BD2B-36943E3ED721}"/>
              </a:ext>
            </a:extLst>
          </p:cNvPr>
          <p:cNvSpPr txBox="1"/>
          <p:nvPr/>
        </p:nvSpPr>
        <p:spPr>
          <a:xfrm>
            <a:off x="5508509" y="2511608"/>
            <a:ext cx="1265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0000FF"/>
                </a:solidFill>
                <a:latin typeface="Arial Narrow" panose="020B0606020202030204" pitchFamily="34" charset="0"/>
              </a:rPr>
              <a:t>Healthy</a:t>
            </a:r>
            <a:r>
              <a:rPr lang="en-US" altLang="zh-CN" b="1" dirty="0">
                <a:latin typeface="Arial Narrow" panose="020B0606020202030204" pitchFamily="34" charset="0"/>
              </a:rPr>
              <a:t>  </a:t>
            </a:r>
            <a:r>
              <a:rPr lang="en-US" altLang="zh-CN" b="1" dirty="0">
                <a:solidFill>
                  <a:srgbClr val="FF0000"/>
                </a:solidFill>
                <a:latin typeface="Arial Narrow" panose="020B0606020202030204" pitchFamily="34" charset="0"/>
              </a:rPr>
              <a:t>EP</a:t>
            </a:r>
            <a:endParaRPr lang="zh-CN" altLang="en-US" b="1" dirty="0">
              <a:solidFill>
                <a:srgbClr val="FF0000"/>
              </a:solidFill>
              <a:latin typeface="Arial Narrow" panose="020B0606020202030204" pitchFamily="34" charset="0"/>
            </a:endParaRP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AA251F72-F676-444A-AF67-5E7439156850}"/>
              </a:ext>
            </a:extLst>
          </p:cNvPr>
          <p:cNvSpPr/>
          <p:nvPr/>
        </p:nvSpPr>
        <p:spPr>
          <a:xfrm>
            <a:off x="1143797" y="6187432"/>
            <a:ext cx="3009295" cy="34216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aphicFrame>
        <p:nvGraphicFramePr>
          <p:cNvPr id="39" name="对象 38">
            <a:extLst>
              <a:ext uri="{FF2B5EF4-FFF2-40B4-BE49-F238E27FC236}">
                <a16:creationId xmlns:a16="http://schemas.microsoft.com/office/drawing/2014/main" id="{7F3603EF-9984-40B7-A7E0-ECEB811003F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46387892"/>
              </p:ext>
            </p:extLst>
          </p:nvPr>
        </p:nvGraphicFramePr>
        <p:xfrm>
          <a:off x="2214563" y="5948363"/>
          <a:ext cx="2690812" cy="26336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7" imgW="3543030" imgH="3463551" progId="Prism8.Document">
                  <p:embed/>
                </p:oleObj>
              </mc:Choice>
              <mc:Fallback>
                <p:oleObj name="Prism 8" r:id="rId17" imgW="3543030" imgH="3463551" progId="Prism8.Document">
                  <p:embed/>
                  <p:pic>
                    <p:nvPicPr>
                      <p:cNvPr id="39" name="对象 38">
                        <a:extLst>
                          <a:ext uri="{FF2B5EF4-FFF2-40B4-BE49-F238E27FC236}">
                            <a16:creationId xmlns:a16="http://schemas.microsoft.com/office/drawing/2014/main" id="{7F3603EF-9984-40B7-A7E0-ECEB811003F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2214563" y="5948363"/>
                        <a:ext cx="2690812" cy="26336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0" name="对象 39">
            <a:extLst>
              <a:ext uri="{FF2B5EF4-FFF2-40B4-BE49-F238E27FC236}">
                <a16:creationId xmlns:a16="http://schemas.microsoft.com/office/drawing/2014/main" id="{0F4DCC9A-94B4-4115-A2D2-0E2AD608ABA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14593639"/>
              </p:ext>
            </p:extLst>
          </p:nvPr>
        </p:nvGraphicFramePr>
        <p:xfrm>
          <a:off x="481491" y="6214823"/>
          <a:ext cx="2690547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9" imgW="3727327" imgH="2992721" progId="Prism8.Document">
                  <p:embed/>
                </p:oleObj>
              </mc:Choice>
              <mc:Fallback>
                <p:oleObj name="Prism 8" r:id="rId19" imgW="3727327" imgH="2992721" progId="Prism8.Document">
                  <p:embed/>
                  <p:pic>
                    <p:nvPicPr>
                      <p:cNvPr id="40" name="对象 39">
                        <a:extLst>
                          <a:ext uri="{FF2B5EF4-FFF2-40B4-BE49-F238E27FC236}">
                            <a16:creationId xmlns:a16="http://schemas.microsoft.com/office/drawing/2014/main" id="{0F4DCC9A-94B4-4115-A2D2-0E2AD608ABA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481491" y="6214823"/>
                        <a:ext cx="2690547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矩形 19">
            <a:extLst>
              <a:ext uri="{FF2B5EF4-FFF2-40B4-BE49-F238E27FC236}">
                <a16:creationId xmlns:a16="http://schemas.microsoft.com/office/drawing/2014/main" id="{5F8EA272-B972-4AE1-8DA6-C00DD670BBCC}"/>
              </a:ext>
            </a:extLst>
          </p:cNvPr>
          <p:cNvSpPr/>
          <p:nvPr/>
        </p:nvSpPr>
        <p:spPr>
          <a:xfrm>
            <a:off x="1241767" y="7995047"/>
            <a:ext cx="3009295" cy="34216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E5D62FA9-3CFD-4242-BBF1-941B97277934}"/>
              </a:ext>
            </a:extLst>
          </p:cNvPr>
          <p:cNvSpPr txBox="1"/>
          <p:nvPr/>
        </p:nvSpPr>
        <p:spPr>
          <a:xfrm>
            <a:off x="1154369" y="7954379"/>
            <a:ext cx="1265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0000FF"/>
                </a:solidFill>
                <a:latin typeface="Arial Narrow" panose="020B0606020202030204" pitchFamily="34" charset="0"/>
              </a:rPr>
              <a:t>Healthy</a:t>
            </a:r>
            <a:r>
              <a:rPr lang="en-US" altLang="zh-CN" b="1" dirty="0">
                <a:latin typeface="Arial Narrow" panose="020B0606020202030204" pitchFamily="34" charset="0"/>
              </a:rPr>
              <a:t>  </a:t>
            </a:r>
            <a:r>
              <a:rPr lang="en-US" altLang="zh-CN" b="1" dirty="0">
                <a:solidFill>
                  <a:srgbClr val="FF0000"/>
                </a:solidFill>
                <a:latin typeface="Arial Narrow" panose="020B0606020202030204" pitchFamily="34" charset="0"/>
              </a:rPr>
              <a:t>EP</a:t>
            </a:r>
            <a:endParaRPr lang="zh-CN" altLang="en-US" b="1" dirty="0">
              <a:solidFill>
                <a:srgbClr val="FF0000"/>
              </a:solidFill>
              <a:latin typeface="Arial Narrow" panose="020B060602020203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C8BE4011-DDD5-415A-944A-6C8F5D05423D}"/>
              </a:ext>
            </a:extLst>
          </p:cNvPr>
          <p:cNvSpPr txBox="1"/>
          <p:nvPr/>
        </p:nvSpPr>
        <p:spPr>
          <a:xfrm>
            <a:off x="2866092" y="7963196"/>
            <a:ext cx="1265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0000FF"/>
                </a:solidFill>
                <a:latin typeface="Arial Narrow" panose="020B0606020202030204" pitchFamily="34" charset="0"/>
              </a:rPr>
              <a:t>Healthy</a:t>
            </a:r>
            <a:r>
              <a:rPr lang="en-US" altLang="zh-CN" b="1" dirty="0">
                <a:latin typeface="Arial Narrow" panose="020B0606020202030204" pitchFamily="34" charset="0"/>
              </a:rPr>
              <a:t>  </a:t>
            </a:r>
            <a:r>
              <a:rPr lang="en-US" altLang="zh-CN" b="1" dirty="0">
                <a:solidFill>
                  <a:srgbClr val="FF0000"/>
                </a:solidFill>
                <a:latin typeface="Arial Narrow" panose="020B0606020202030204" pitchFamily="34" charset="0"/>
              </a:rPr>
              <a:t>EP</a:t>
            </a:r>
            <a:endParaRPr lang="zh-CN" altLang="en-US" b="1" dirty="0">
              <a:solidFill>
                <a:srgbClr val="FF0000"/>
              </a:solidFill>
              <a:latin typeface="Arial Narrow" panose="020B060602020203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94B70CBB-129F-4D14-AF36-1FE7864E4F78}"/>
              </a:ext>
            </a:extLst>
          </p:cNvPr>
          <p:cNvSpPr txBox="1"/>
          <p:nvPr/>
        </p:nvSpPr>
        <p:spPr>
          <a:xfrm>
            <a:off x="1318581" y="344152"/>
            <a:ext cx="453358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zh-CN" altLang="en-US" sz="2400" dirty="0"/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29E5701F-F528-455A-9510-5ADA8BC37EB6}"/>
              </a:ext>
            </a:extLst>
          </p:cNvPr>
          <p:cNvSpPr/>
          <p:nvPr/>
        </p:nvSpPr>
        <p:spPr>
          <a:xfrm>
            <a:off x="1165690" y="1397187"/>
            <a:ext cx="727143" cy="19119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solidFill>
                <a:schemeClr val="tx1"/>
              </a:solidFill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A34B90FE-1765-47F3-B0A0-F78C83A64B84}"/>
              </a:ext>
            </a:extLst>
          </p:cNvPr>
          <p:cNvSpPr txBox="1"/>
          <p:nvPr/>
        </p:nvSpPr>
        <p:spPr>
          <a:xfrm>
            <a:off x="1417331" y="1394012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id="{3D0A8270-6FF1-4980-B357-B768474D0AE8}"/>
              </a:ext>
            </a:extLst>
          </p:cNvPr>
          <p:cNvSpPr/>
          <p:nvPr/>
        </p:nvSpPr>
        <p:spPr>
          <a:xfrm>
            <a:off x="3073654" y="6578444"/>
            <a:ext cx="977390" cy="2160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solidFill>
                <a:schemeClr val="tx1"/>
              </a:solidFill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AF5301D9-CF99-4445-A870-0D49A5063C81}"/>
              </a:ext>
            </a:extLst>
          </p:cNvPr>
          <p:cNvSpPr txBox="1"/>
          <p:nvPr/>
        </p:nvSpPr>
        <p:spPr>
          <a:xfrm>
            <a:off x="3382449" y="6584795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132377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/>
          <p:cNvSpPr txBox="1"/>
          <p:nvPr/>
        </p:nvSpPr>
        <p:spPr>
          <a:xfrm>
            <a:off x="773205" y="1991319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92A75ACC-2317-4DAE-B8A1-9E6B794353BB}"/>
              </a:ext>
            </a:extLst>
          </p:cNvPr>
          <p:cNvSpPr txBox="1"/>
          <p:nvPr/>
        </p:nvSpPr>
        <p:spPr>
          <a:xfrm>
            <a:off x="3448809" y="1991319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8" name="对象 17">
            <a:extLst>
              <a:ext uri="{FF2B5EF4-FFF2-40B4-BE49-F238E27FC236}">
                <a16:creationId xmlns:a16="http://schemas.microsoft.com/office/drawing/2014/main" id="{536730EC-35FE-4652-AD57-B65FF601379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14666636"/>
              </p:ext>
            </p:extLst>
          </p:nvPr>
        </p:nvGraphicFramePr>
        <p:xfrm>
          <a:off x="733613" y="2073000"/>
          <a:ext cx="3090629" cy="28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3" imgW="3494397" imgH="3256513" progId="Prism7.Document">
                  <p:embed/>
                </p:oleObj>
              </mc:Choice>
              <mc:Fallback>
                <p:oleObj name="Prism 7" r:id="rId3" imgW="3494397" imgH="3256513" progId="Prism7.Document">
                  <p:embed/>
                  <p:pic>
                    <p:nvPicPr>
                      <p:cNvPr id="18" name="对象 17">
                        <a:extLst>
                          <a:ext uri="{FF2B5EF4-FFF2-40B4-BE49-F238E27FC236}">
                            <a16:creationId xmlns:a16="http://schemas.microsoft.com/office/drawing/2014/main" id="{536730EC-35FE-4652-AD57-B65FF601379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33613" y="2073000"/>
                        <a:ext cx="3090629" cy="28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对象 18">
            <a:extLst>
              <a:ext uri="{FF2B5EF4-FFF2-40B4-BE49-F238E27FC236}">
                <a16:creationId xmlns:a16="http://schemas.microsoft.com/office/drawing/2014/main" id="{7094C618-2B23-4602-BA91-DA2279FBF61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36829979"/>
              </p:ext>
            </p:extLst>
          </p:nvPr>
        </p:nvGraphicFramePr>
        <p:xfrm>
          <a:off x="3268125" y="2073000"/>
          <a:ext cx="3082205" cy="28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5" imgW="3485033" imgH="3256513" progId="Prism7.Document">
                  <p:embed/>
                </p:oleObj>
              </mc:Choice>
              <mc:Fallback>
                <p:oleObj name="Prism 7" r:id="rId5" imgW="3485033" imgH="3256513" progId="Prism7.Document">
                  <p:embed/>
                  <p:pic>
                    <p:nvPicPr>
                      <p:cNvPr id="19" name="对象 18">
                        <a:extLst>
                          <a:ext uri="{FF2B5EF4-FFF2-40B4-BE49-F238E27FC236}">
                            <a16:creationId xmlns:a16="http://schemas.microsoft.com/office/drawing/2014/main" id="{7094C618-2B23-4602-BA91-DA2279FBF61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268125" y="2073000"/>
                        <a:ext cx="3082205" cy="28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文本框 1">
            <a:extLst>
              <a:ext uri="{FF2B5EF4-FFF2-40B4-BE49-F238E27FC236}">
                <a16:creationId xmlns:a16="http://schemas.microsoft.com/office/drawing/2014/main" id="{6DA89DD4-2B01-4ACB-9D80-C5BB10CEBDF0}"/>
              </a:ext>
            </a:extLst>
          </p:cNvPr>
          <p:cNvSpPr txBox="1"/>
          <p:nvPr/>
        </p:nvSpPr>
        <p:spPr>
          <a:xfrm>
            <a:off x="1313738" y="464024"/>
            <a:ext cx="453358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endParaRPr lang="zh-CN" altLang="en-US" sz="2400" dirty="0"/>
          </a:p>
        </p:txBody>
      </p:sp>
    </p:spTree>
    <p:extLst>
      <p:ext uri="{BB962C8B-B14F-4D97-AF65-F5344CB8AC3E}">
        <p14:creationId xmlns:p14="http://schemas.microsoft.com/office/powerpoint/2010/main" val="5985887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对象 4">
            <a:extLst>
              <a:ext uri="{FF2B5EF4-FFF2-40B4-BE49-F238E27FC236}">
                <a16:creationId xmlns:a16="http://schemas.microsoft.com/office/drawing/2014/main" id="{CB3B30B6-D68B-48F9-99E2-984414150FF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10816934"/>
              </p:ext>
            </p:extLst>
          </p:nvPr>
        </p:nvGraphicFramePr>
        <p:xfrm>
          <a:off x="526681" y="7563481"/>
          <a:ext cx="1763646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4053840" imgH="3314700" progId="Prism8.Document">
                  <p:embed/>
                </p:oleObj>
              </mc:Choice>
              <mc:Fallback>
                <p:oleObj name="Prism 8" r:id="rId2" imgW="4053840" imgH="3314700" progId="Prism8.Document">
                  <p:embed/>
                  <p:pic>
                    <p:nvPicPr>
                      <p:cNvPr id="5" name="对象 4">
                        <a:extLst>
                          <a:ext uri="{FF2B5EF4-FFF2-40B4-BE49-F238E27FC236}">
                            <a16:creationId xmlns:a16="http://schemas.microsoft.com/office/drawing/2014/main" id="{CB3B30B6-D68B-48F9-99E2-984414150FF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26681" y="7563481"/>
                        <a:ext cx="1763646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对象 6">
            <a:extLst>
              <a:ext uri="{FF2B5EF4-FFF2-40B4-BE49-F238E27FC236}">
                <a16:creationId xmlns:a16="http://schemas.microsoft.com/office/drawing/2014/main" id="{CC342810-CA8A-4EF1-82E7-53F2FD98B32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64154592"/>
              </p:ext>
            </p:extLst>
          </p:nvPr>
        </p:nvGraphicFramePr>
        <p:xfrm>
          <a:off x="2410187" y="7563481"/>
          <a:ext cx="1754506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4053840" imgH="3314700" progId="Prism8.Document">
                  <p:embed/>
                </p:oleObj>
              </mc:Choice>
              <mc:Fallback>
                <p:oleObj name="Prism 8" r:id="rId4" imgW="4053840" imgH="3314700" progId="Prism8.Document">
                  <p:embed/>
                  <p:pic>
                    <p:nvPicPr>
                      <p:cNvPr id="7" name="对象 6">
                        <a:extLst>
                          <a:ext uri="{FF2B5EF4-FFF2-40B4-BE49-F238E27FC236}">
                            <a16:creationId xmlns:a16="http://schemas.microsoft.com/office/drawing/2014/main" id="{CC342810-CA8A-4EF1-82E7-53F2FD98B32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410187" y="7563481"/>
                        <a:ext cx="1754506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对象 8">
            <a:extLst>
              <a:ext uri="{FF2B5EF4-FFF2-40B4-BE49-F238E27FC236}">
                <a16:creationId xmlns:a16="http://schemas.microsoft.com/office/drawing/2014/main" id="{44D92931-0273-4394-90D5-49C0B81B1D3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4169366"/>
              </p:ext>
            </p:extLst>
          </p:nvPr>
        </p:nvGraphicFramePr>
        <p:xfrm>
          <a:off x="4325858" y="7563481"/>
          <a:ext cx="1842979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4053840" imgH="3314700" progId="Prism8.Document">
                  <p:embed/>
                </p:oleObj>
              </mc:Choice>
              <mc:Fallback>
                <p:oleObj name="Prism 8" r:id="rId6" imgW="4053840" imgH="3314700" progId="Prism8.Document">
                  <p:embed/>
                  <p:pic>
                    <p:nvPicPr>
                      <p:cNvPr id="9" name="对象 8">
                        <a:extLst>
                          <a:ext uri="{FF2B5EF4-FFF2-40B4-BE49-F238E27FC236}">
                            <a16:creationId xmlns:a16="http://schemas.microsoft.com/office/drawing/2014/main" id="{44D92931-0273-4394-90D5-49C0B81B1D3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325858" y="7563481"/>
                        <a:ext cx="1842979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对象 10">
            <a:extLst>
              <a:ext uri="{FF2B5EF4-FFF2-40B4-BE49-F238E27FC236}">
                <a16:creationId xmlns:a16="http://schemas.microsoft.com/office/drawing/2014/main" id="{CDF94E09-8651-42B5-9354-9ED714CA02D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83868841"/>
              </p:ext>
            </p:extLst>
          </p:nvPr>
        </p:nvGraphicFramePr>
        <p:xfrm>
          <a:off x="494516" y="1183004"/>
          <a:ext cx="1763844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4053840" imgH="3314700" progId="Prism8.Document">
                  <p:embed/>
                </p:oleObj>
              </mc:Choice>
              <mc:Fallback>
                <p:oleObj name="Prism 8" r:id="rId8" imgW="4053840" imgH="3314700" progId="Prism8.Document">
                  <p:embed/>
                  <p:pic>
                    <p:nvPicPr>
                      <p:cNvPr id="11" name="对象 10">
                        <a:extLst>
                          <a:ext uri="{FF2B5EF4-FFF2-40B4-BE49-F238E27FC236}">
                            <a16:creationId xmlns:a16="http://schemas.microsoft.com/office/drawing/2014/main" id="{CDF94E09-8651-42B5-9354-9ED714CA02D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94516" y="1183004"/>
                        <a:ext cx="1763844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对象 12">
            <a:extLst>
              <a:ext uri="{FF2B5EF4-FFF2-40B4-BE49-F238E27FC236}">
                <a16:creationId xmlns:a16="http://schemas.microsoft.com/office/drawing/2014/main" id="{1ED6EEC8-3D9D-4FCC-B0D4-16A7038B709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17257702"/>
              </p:ext>
            </p:extLst>
          </p:nvPr>
        </p:nvGraphicFramePr>
        <p:xfrm>
          <a:off x="429201" y="2732614"/>
          <a:ext cx="2143690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0" imgW="4053840" imgH="3314700" progId="Prism8.Document">
                  <p:embed/>
                </p:oleObj>
              </mc:Choice>
              <mc:Fallback>
                <p:oleObj name="Prism 8" r:id="rId10" imgW="4053840" imgH="3314700" progId="Prism8.Document">
                  <p:embed/>
                  <p:pic>
                    <p:nvPicPr>
                      <p:cNvPr id="13" name="对象 12">
                        <a:extLst>
                          <a:ext uri="{FF2B5EF4-FFF2-40B4-BE49-F238E27FC236}">
                            <a16:creationId xmlns:a16="http://schemas.microsoft.com/office/drawing/2014/main" id="{1ED6EEC8-3D9D-4FCC-B0D4-16A7038B709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29201" y="2732614"/>
                        <a:ext cx="2143690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对象 14">
            <a:extLst>
              <a:ext uri="{FF2B5EF4-FFF2-40B4-BE49-F238E27FC236}">
                <a16:creationId xmlns:a16="http://schemas.microsoft.com/office/drawing/2014/main" id="{FED00A6B-8BA8-4F0D-90E8-B6022081A56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31711877"/>
              </p:ext>
            </p:extLst>
          </p:nvPr>
        </p:nvGraphicFramePr>
        <p:xfrm>
          <a:off x="2370998" y="2731328"/>
          <a:ext cx="1864555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2" imgW="4053840" imgH="3314700" progId="Prism8.Document">
                  <p:embed/>
                </p:oleObj>
              </mc:Choice>
              <mc:Fallback>
                <p:oleObj name="Prism 8" r:id="rId12" imgW="4053840" imgH="3314700" progId="Prism8.Document">
                  <p:embed/>
                  <p:pic>
                    <p:nvPicPr>
                      <p:cNvPr id="15" name="对象 14">
                        <a:extLst>
                          <a:ext uri="{FF2B5EF4-FFF2-40B4-BE49-F238E27FC236}">
                            <a16:creationId xmlns:a16="http://schemas.microsoft.com/office/drawing/2014/main" id="{FED00A6B-8BA8-4F0D-90E8-B6022081A56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370998" y="2731328"/>
                        <a:ext cx="1864555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对象 16">
            <a:extLst>
              <a:ext uri="{FF2B5EF4-FFF2-40B4-BE49-F238E27FC236}">
                <a16:creationId xmlns:a16="http://schemas.microsoft.com/office/drawing/2014/main" id="{118C72B2-56E0-4BE2-A45B-9E161C1B9B8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37202343"/>
              </p:ext>
            </p:extLst>
          </p:nvPr>
        </p:nvGraphicFramePr>
        <p:xfrm>
          <a:off x="4325858" y="2731328"/>
          <a:ext cx="2035346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4" imgW="4053840" imgH="3314700" progId="Prism8.Document">
                  <p:embed/>
                </p:oleObj>
              </mc:Choice>
              <mc:Fallback>
                <p:oleObj name="Prism 8" r:id="rId14" imgW="4053840" imgH="3314700" progId="Prism8.Document">
                  <p:embed/>
                  <p:pic>
                    <p:nvPicPr>
                      <p:cNvPr id="17" name="对象 16">
                        <a:extLst>
                          <a:ext uri="{FF2B5EF4-FFF2-40B4-BE49-F238E27FC236}">
                            <a16:creationId xmlns:a16="http://schemas.microsoft.com/office/drawing/2014/main" id="{118C72B2-56E0-4BE2-A45B-9E161C1B9B8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4325858" y="2731328"/>
                        <a:ext cx="2035346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对象 18">
            <a:extLst>
              <a:ext uri="{FF2B5EF4-FFF2-40B4-BE49-F238E27FC236}">
                <a16:creationId xmlns:a16="http://schemas.microsoft.com/office/drawing/2014/main" id="{687C95A5-1DE5-48EE-BE47-3E4E8905B19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70569826"/>
              </p:ext>
            </p:extLst>
          </p:nvPr>
        </p:nvGraphicFramePr>
        <p:xfrm>
          <a:off x="526681" y="5896429"/>
          <a:ext cx="1855746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6" imgW="4053840" imgH="3314700" progId="Prism8.Document">
                  <p:embed/>
                </p:oleObj>
              </mc:Choice>
              <mc:Fallback>
                <p:oleObj name="Prism 8" r:id="rId16" imgW="4053840" imgH="3314700" progId="Prism8.Document">
                  <p:embed/>
                  <p:pic>
                    <p:nvPicPr>
                      <p:cNvPr id="19" name="对象 18">
                        <a:extLst>
                          <a:ext uri="{FF2B5EF4-FFF2-40B4-BE49-F238E27FC236}">
                            <a16:creationId xmlns:a16="http://schemas.microsoft.com/office/drawing/2014/main" id="{687C95A5-1DE5-48EE-BE47-3E4E8905B19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526681" y="5896429"/>
                        <a:ext cx="1855746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对象 20">
            <a:extLst>
              <a:ext uri="{FF2B5EF4-FFF2-40B4-BE49-F238E27FC236}">
                <a16:creationId xmlns:a16="http://schemas.microsoft.com/office/drawing/2014/main" id="{D824F436-B88E-4F64-A310-4DC12AF7F69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60368638"/>
              </p:ext>
            </p:extLst>
          </p:nvPr>
        </p:nvGraphicFramePr>
        <p:xfrm>
          <a:off x="2420047" y="5896429"/>
          <a:ext cx="1711689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8" imgW="4053840" imgH="3314700" progId="Prism8.Document">
                  <p:embed/>
                </p:oleObj>
              </mc:Choice>
              <mc:Fallback>
                <p:oleObj name="Prism 8" r:id="rId18" imgW="4053840" imgH="3314700" progId="Prism8.Document">
                  <p:embed/>
                  <p:pic>
                    <p:nvPicPr>
                      <p:cNvPr id="21" name="对象 20">
                        <a:extLst>
                          <a:ext uri="{FF2B5EF4-FFF2-40B4-BE49-F238E27FC236}">
                            <a16:creationId xmlns:a16="http://schemas.microsoft.com/office/drawing/2014/main" id="{D824F436-B88E-4F64-A310-4DC12AF7F69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2420047" y="5896429"/>
                        <a:ext cx="1711689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对象 22">
            <a:extLst>
              <a:ext uri="{FF2B5EF4-FFF2-40B4-BE49-F238E27FC236}">
                <a16:creationId xmlns:a16="http://schemas.microsoft.com/office/drawing/2014/main" id="{941FA046-828D-479A-AD08-765375BFB0B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27858834"/>
              </p:ext>
            </p:extLst>
          </p:nvPr>
        </p:nvGraphicFramePr>
        <p:xfrm>
          <a:off x="526681" y="4229377"/>
          <a:ext cx="1763633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0" imgW="4053840" imgH="3314700" progId="Prism8.Document">
                  <p:embed/>
                </p:oleObj>
              </mc:Choice>
              <mc:Fallback>
                <p:oleObj name="Prism 8" r:id="rId20" imgW="4053840" imgH="3314700" progId="Prism8.Document">
                  <p:embed/>
                  <p:pic>
                    <p:nvPicPr>
                      <p:cNvPr id="23" name="对象 22">
                        <a:extLst>
                          <a:ext uri="{FF2B5EF4-FFF2-40B4-BE49-F238E27FC236}">
                            <a16:creationId xmlns:a16="http://schemas.microsoft.com/office/drawing/2014/main" id="{941FA046-828D-479A-AD08-765375BFB0B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526681" y="4229377"/>
                        <a:ext cx="1763633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对象 24">
            <a:extLst>
              <a:ext uri="{FF2B5EF4-FFF2-40B4-BE49-F238E27FC236}">
                <a16:creationId xmlns:a16="http://schemas.microsoft.com/office/drawing/2014/main" id="{343486EE-6032-4581-9804-F64BF67EB06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5968545"/>
              </p:ext>
            </p:extLst>
          </p:nvPr>
        </p:nvGraphicFramePr>
        <p:xfrm>
          <a:off x="2410187" y="4229377"/>
          <a:ext cx="1721549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2" imgW="4122420" imgH="3314700" progId="Prism8.Document">
                  <p:embed/>
                </p:oleObj>
              </mc:Choice>
              <mc:Fallback>
                <p:oleObj name="Prism 8" r:id="rId22" imgW="4122420" imgH="3314700" progId="Prism8.Document">
                  <p:embed/>
                  <p:pic>
                    <p:nvPicPr>
                      <p:cNvPr id="25" name="对象 24">
                        <a:extLst>
                          <a:ext uri="{FF2B5EF4-FFF2-40B4-BE49-F238E27FC236}">
                            <a16:creationId xmlns:a16="http://schemas.microsoft.com/office/drawing/2014/main" id="{343486EE-6032-4581-9804-F64BF67EB06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2410187" y="4229377"/>
                        <a:ext cx="1721549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对象 26">
            <a:extLst>
              <a:ext uri="{FF2B5EF4-FFF2-40B4-BE49-F238E27FC236}">
                <a16:creationId xmlns:a16="http://schemas.microsoft.com/office/drawing/2014/main" id="{7640226B-F738-4010-8CF4-63B4D443723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43270782"/>
              </p:ext>
            </p:extLst>
          </p:nvPr>
        </p:nvGraphicFramePr>
        <p:xfrm>
          <a:off x="4434004" y="4206968"/>
          <a:ext cx="1763844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4" imgW="4053840" imgH="3314700" progId="Prism8.Document">
                  <p:embed/>
                </p:oleObj>
              </mc:Choice>
              <mc:Fallback>
                <p:oleObj name="Prism 8" r:id="rId24" imgW="4053840" imgH="3314700" progId="Prism8.Document">
                  <p:embed/>
                  <p:pic>
                    <p:nvPicPr>
                      <p:cNvPr id="27" name="对象 26">
                        <a:extLst>
                          <a:ext uri="{FF2B5EF4-FFF2-40B4-BE49-F238E27FC236}">
                            <a16:creationId xmlns:a16="http://schemas.microsoft.com/office/drawing/2014/main" id="{7640226B-F738-4010-8CF4-63B4D443723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4434004" y="4206968"/>
                        <a:ext cx="1763844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9" name="文本框 28">
            <a:extLst>
              <a:ext uri="{FF2B5EF4-FFF2-40B4-BE49-F238E27FC236}">
                <a16:creationId xmlns:a16="http://schemas.microsoft.com/office/drawing/2014/main" id="{39904E7C-D7DB-42E0-A888-4A9EE6962FAA}"/>
              </a:ext>
            </a:extLst>
          </p:cNvPr>
          <p:cNvSpPr txBox="1"/>
          <p:nvPr/>
        </p:nvSpPr>
        <p:spPr>
          <a:xfrm>
            <a:off x="1376438" y="232328"/>
            <a:ext cx="453358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  <a:endParaRPr lang="zh-CN" altLang="en-US" sz="2400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BA666635-513C-4099-B548-3669E908E055}"/>
              </a:ext>
            </a:extLst>
          </p:cNvPr>
          <p:cNvPicPr>
            <a:picLocks noChangeAspect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0998" y="1183004"/>
            <a:ext cx="1764133" cy="14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0966446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B59D524A-D825-4993-A747-FD96C3AFAA6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6322" y="5237150"/>
            <a:ext cx="2317027" cy="216000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248928A5-4373-43FF-93D5-1C68669D3B6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3555" y="5237150"/>
            <a:ext cx="2345445" cy="2160000"/>
          </a:xfrm>
          <a:prstGeom prst="rect">
            <a:avLst/>
          </a:prstGeom>
        </p:spPr>
      </p:pic>
      <p:graphicFrame>
        <p:nvGraphicFramePr>
          <p:cNvPr id="6" name="对象 5">
            <a:extLst>
              <a:ext uri="{FF2B5EF4-FFF2-40B4-BE49-F238E27FC236}">
                <a16:creationId xmlns:a16="http://schemas.microsoft.com/office/drawing/2014/main" id="{784FF160-BD47-4790-A8AB-7A5FD27DFF8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85491632"/>
              </p:ext>
            </p:extLst>
          </p:nvPr>
        </p:nvGraphicFramePr>
        <p:xfrm>
          <a:off x="2499139" y="1010736"/>
          <a:ext cx="2141288" cy="19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4045886" imgH="3742521" progId="Prism8.Document">
                  <p:embed/>
                </p:oleObj>
              </mc:Choice>
              <mc:Fallback>
                <p:oleObj name="Prism 8" r:id="rId4" imgW="4045886" imgH="3742521" progId="Prism8.Document">
                  <p:embed/>
                  <p:pic>
                    <p:nvPicPr>
                      <p:cNvPr id="6" name="对象 5">
                        <a:extLst>
                          <a:ext uri="{FF2B5EF4-FFF2-40B4-BE49-F238E27FC236}">
                            <a16:creationId xmlns:a16="http://schemas.microsoft.com/office/drawing/2014/main" id="{784FF160-BD47-4790-A8AB-7A5FD27DFF8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499139" y="1010736"/>
                        <a:ext cx="2141288" cy="19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对象 6">
            <a:extLst>
              <a:ext uri="{FF2B5EF4-FFF2-40B4-BE49-F238E27FC236}">
                <a16:creationId xmlns:a16="http://schemas.microsoft.com/office/drawing/2014/main" id="{797CD684-3DF8-4503-A341-C7260662DF1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21996354"/>
              </p:ext>
            </p:extLst>
          </p:nvPr>
        </p:nvGraphicFramePr>
        <p:xfrm>
          <a:off x="4440022" y="980769"/>
          <a:ext cx="2141288" cy="19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4045886" imgH="3742521" progId="Prism8.Document">
                  <p:embed/>
                </p:oleObj>
              </mc:Choice>
              <mc:Fallback>
                <p:oleObj name="Prism 8" r:id="rId6" imgW="4045886" imgH="3742521" progId="Prism8.Document">
                  <p:embed/>
                  <p:pic>
                    <p:nvPicPr>
                      <p:cNvPr id="7" name="对象 6">
                        <a:extLst>
                          <a:ext uri="{FF2B5EF4-FFF2-40B4-BE49-F238E27FC236}">
                            <a16:creationId xmlns:a16="http://schemas.microsoft.com/office/drawing/2014/main" id="{797CD684-3DF8-4503-A341-C7260662DF1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440022" y="980769"/>
                        <a:ext cx="2141288" cy="19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对象 7">
            <a:extLst>
              <a:ext uri="{FF2B5EF4-FFF2-40B4-BE49-F238E27FC236}">
                <a16:creationId xmlns:a16="http://schemas.microsoft.com/office/drawing/2014/main" id="{562C7574-41FF-43EE-A3FC-EA99A2CB650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84577611"/>
              </p:ext>
            </p:extLst>
          </p:nvPr>
        </p:nvGraphicFramePr>
        <p:xfrm>
          <a:off x="558256" y="874229"/>
          <a:ext cx="2334378" cy="19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4434277" imgH="3760879" progId="Prism8.Document">
                  <p:embed/>
                </p:oleObj>
              </mc:Choice>
              <mc:Fallback>
                <p:oleObj name="Prism 8" r:id="rId8" imgW="4434277" imgH="3760879" progId="Prism8.Document">
                  <p:embed/>
                  <p:pic>
                    <p:nvPicPr>
                      <p:cNvPr id="8" name="对象 7">
                        <a:extLst>
                          <a:ext uri="{FF2B5EF4-FFF2-40B4-BE49-F238E27FC236}">
                            <a16:creationId xmlns:a16="http://schemas.microsoft.com/office/drawing/2014/main" id="{562C7574-41FF-43EE-A3FC-EA99A2CB650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58256" y="874229"/>
                        <a:ext cx="2334378" cy="19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对象 8">
            <a:extLst>
              <a:ext uri="{FF2B5EF4-FFF2-40B4-BE49-F238E27FC236}">
                <a16:creationId xmlns:a16="http://schemas.microsoft.com/office/drawing/2014/main" id="{EC5F4A62-EE9B-45D7-BC63-1AD7FAD398F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31011021"/>
              </p:ext>
            </p:extLst>
          </p:nvPr>
        </p:nvGraphicFramePr>
        <p:xfrm>
          <a:off x="4492369" y="3179329"/>
          <a:ext cx="2132243" cy="19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0" imgW="4045886" imgH="3757639" progId="Prism8.Document">
                  <p:embed/>
                </p:oleObj>
              </mc:Choice>
              <mc:Fallback>
                <p:oleObj name="Prism 8" r:id="rId10" imgW="4045886" imgH="3757639" progId="Prism8.Document">
                  <p:embed/>
                  <p:pic>
                    <p:nvPicPr>
                      <p:cNvPr id="9" name="对象 8">
                        <a:extLst>
                          <a:ext uri="{FF2B5EF4-FFF2-40B4-BE49-F238E27FC236}">
                            <a16:creationId xmlns:a16="http://schemas.microsoft.com/office/drawing/2014/main" id="{EC5F4A62-EE9B-45D7-BC63-1AD7FAD398F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492369" y="3179329"/>
                        <a:ext cx="2132243" cy="19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对象 9">
            <a:extLst>
              <a:ext uri="{FF2B5EF4-FFF2-40B4-BE49-F238E27FC236}">
                <a16:creationId xmlns:a16="http://schemas.microsoft.com/office/drawing/2014/main" id="{044EECF5-D84D-416C-ABF4-DC9BD433D7F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07594222"/>
              </p:ext>
            </p:extLst>
          </p:nvPr>
        </p:nvGraphicFramePr>
        <p:xfrm>
          <a:off x="2499139" y="3179329"/>
          <a:ext cx="2149497" cy="19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2" imgW="4045886" imgH="3727403" progId="Prism8.Document">
                  <p:embed/>
                </p:oleObj>
              </mc:Choice>
              <mc:Fallback>
                <p:oleObj name="Prism 8" r:id="rId12" imgW="4045886" imgH="3727403" progId="Prism8.Document">
                  <p:embed/>
                  <p:pic>
                    <p:nvPicPr>
                      <p:cNvPr id="10" name="对象 9">
                        <a:extLst>
                          <a:ext uri="{FF2B5EF4-FFF2-40B4-BE49-F238E27FC236}">
                            <a16:creationId xmlns:a16="http://schemas.microsoft.com/office/drawing/2014/main" id="{044EECF5-D84D-416C-ABF4-DC9BD433D7F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499139" y="3179329"/>
                        <a:ext cx="2149497" cy="19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对象 10">
            <a:extLst>
              <a:ext uri="{FF2B5EF4-FFF2-40B4-BE49-F238E27FC236}">
                <a16:creationId xmlns:a16="http://schemas.microsoft.com/office/drawing/2014/main" id="{AAC4ECFB-DBED-450C-852B-4E24592DBCB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78794114"/>
              </p:ext>
            </p:extLst>
          </p:nvPr>
        </p:nvGraphicFramePr>
        <p:xfrm>
          <a:off x="558256" y="3038590"/>
          <a:ext cx="2334378" cy="19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4" imgW="4434277" imgH="3760879" progId="Prism8.Document">
                  <p:embed/>
                </p:oleObj>
              </mc:Choice>
              <mc:Fallback>
                <p:oleObj name="Prism 8" r:id="rId14" imgW="4434277" imgH="3760879" progId="Prism8.Document">
                  <p:embed/>
                  <p:pic>
                    <p:nvPicPr>
                      <p:cNvPr id="11" name="对象 10">
                        <a:extLst>
                          <a:ext uri="{FF2B5EF4-FFF2-40B4-BE49-F238E27FC236}">
                            <a16:creationId xmlns:a16="http://schemas.microsoft.com/office/drawing/2014/main" id="{AAC4ECFB-DBED-450C-852B-4E24592DBCB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558256" y="3038590"/>
                        <a:ext cx="2334378" cy="19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179568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12</TotalTime>
  <Words>302</Words>
  <Application>Microsoft Office PowerPoint</Application>
  <PresentationFormat>A4 纸张(210x297 毫米)</PresentationFormat>
  <Paragraphs>121</Paragraphs>
  <Slides>6</Slides>
  <Notes>3</Notes>
  <HiddenSlides>0</HiddenSlides>
  <MMClips>0</MMClips>
  <ScaleCrop>false</ScaleCrop>
  <HeadingPairs>
    <vt:vector size="8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2</vt:i4>
      </vt:variant>
      <vt:variant>
        <vt:lpstr>幻灯片标题</vt:lpstr>
      </vt:variant>
      <vt:variant>
        <vt:i4>6</vt:i4>
      </vt:variant>
    </vt:vector>
  </HeadingPairs>
  <TitlesOfParts>
    <vt:vector size="15" baseType="lpstr">
      <vt:lpstr>Arial Unicode MS</vt:lpstr>
      <vt:lpstr>Calibri (正文)</vt:lpstr>
      <vt:lpstr>Arial</vt:lpstr>
      <vt:lpstr>Arial Narrow</vt:lpstr>
      <vt:lpstr>Calibri</vt:lpstr>
      <vt:lpstr>Calibri Light</vt:lpstr>
      <vt:lpstr>Office 主题</vt:lpstr>
      <vt:lpstr>Prism 8</vt:lpstr>
      <vt:lpstr>Prism 7</vt:lpstr>
      <vt:lpstr>Supplementary Materials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f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User</dc:creator>
  <cp:lastModifiedBy>Derei Wu</cp:lastModifiedBy>
  <cp:revision>98</cp:revision>
  <dcterms:created xsi:type="dcterms:W3CDTF">2020-08-28T01:56:52Z</dcterms:created>
  <dcterms:modified xsi:type="dcterms:W3CDTF">2021-04-07T02:02:06Z</dcterms:modified>
</cp:coreProperties>
</file>